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rels" ContentType="application/vnd.openxmlformats-package.relationships+xml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264" r:id="rId2"/>
    <p:sldId id="256" r:id="rId3"/>
    <p:sldId id="293" r:id="rId4"/>
    <p:sldId id="294" r:id="rId5"/>
    <p:sldId id="295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29"/>
    <p:restoredTop sz="50000" autoAdjust="0"/>
  </p:normalViewPr>
  <p:slideViewPr>
    <p:cSldViewPr snapToGrid="0" snapToObjects="1">
      <p:cViewPr>
        <p:scale>
          <a:sx n="108" d="100"/>
          <a:sy n="108" d="100"/>
        </p:scale>
        <p:origin x="-736" y="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9" d="100"/>
        <a:sy n="8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handoutMaster" Target="handoutMasters/handout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ouzakimasaoki:Desktop:&#30740;&#31350;&#12486;&#12540;&#12510;&#19968;&#35239;:&#26368;&#20778;&#20808;&#20107;&#38917;:&#37325;&#35201;&#12288;&#26481;&#38651;&#31038;&#21729;&#12288;&#20581;&#24247;&#35386;&#26029;&#32080;&#26524;:Environmental%20Health%20Perspectives:13March2019%20&#30002;&#26000;&#20808;&#29983;&#12408;&#12398;&#12513;&#12540;&#12523;:&#9314;&#20581;&#35386;Hb&#12487;&#12540;&#12479;&#12414;&#12392;&#12417;_&#39321;&#23822;%20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ouzakimasaoki:Desktop:&#30740;&#31350;&#12486;&#12540;&#12510;&#19968;&#35239;:&#26368;&#20778;&#20808;&#20107;&#38917;:&#37325;&#35201;&#12288;&#26481;&#38651;&#31038;&#21729;&#12288;&#20581;&#24247;&#35386;&#26029;&#32080;&#26524;:Environmental%20Health%20Perspectives:13March2019%20&#30002;&#26000;&#20808;&#29983;&#12408;&#12398;&#12513;&#12540;&#12523;:&#9314;&#20581;&#35386;Hb&#12487;&#12540;&#12479;&#12414;&#12392;&#12417;_&#39321;&#23822;%20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ouzakimasaoki:Desktop:&#30740;&#31350;&#12486;&#12540;&#12510;&#19968;&#35239;:&#26368;&#20778;&#20808;&#20107;&#38917;:&#37325;&#35201;&#12288;&#26481;&#38651;&#31038;&#21729;&#12288;&#20581;&#24247;&#35386;&#26029;&#32080;&#26524;:Environmental%20Health%20Perspectives:13March2019%20&#30002;&#26000;&#20808;&#29983;&#12408;&#12398;&#12513;&#12540;&#12523;:&#9314;&#20581;&#35386;Hb&#12487;&#12540;&#12479;&#12414;&#12392;&#12417;_&#39321;&#23822;%20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ouzakimasaoki:Desktop:&#30740;&#31350;&#12486;&#12540;&#12510;&#19968;&#35239;:&#26368;&#20778;&#20808;&#20107;&#38917;:&#37325;&#35201;&#12288;&#26481;&#38651;&#31038;&#21729;&#12288;&#20581;&#24247;&#35386;&#26029;&#32080;&#26524;:Environmental%20Health%20Perspectives:13March2019%20&#30002;&#26000;&#20808;&#29983;&#12408;&#12398;&#12513;&#12540;&#12523;:&#9314;&#20581;&#35386;Hb&#12487;&#12540;&#12479;&#12414;&#12392;&#12417;_&#39321;&#23822;%20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47625">
              <a:noFill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0.0340833165889892"/>
                  <c:y val="0.340023161885088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solidFill>
                    <a:schemeClr val="tx1"/>
                  </a:solidFill>
                </a:ln>
              </c:spPr>
              <c:txPr>
                <a:bodyPr/>
                <a:lstStyle/>
                <a:p>
                  <a:pPr>
                    <a:defRPr b="1" i="0">
                      <a:latin typeface="Arial"/>
                    </a:defRPr>
                  </a:pPr>
                  <a:endParaRPr lang="en-US"/>
                </a:p>
              </c:txPr>
            </c:trendlineLbl>
          </c:trendline>
          <c:yVal>
            <c:numRef>
              <c:f>'[③健診Hbデータまとめ_香崎 2.xlsx]事故後線量多い順'!$H$5:$H$371</c:f>
              <c:numCache>
                <c:formatCode>General</c:formatCode>
                <c:ptCount val="367"/>
                <c:pt idx="0">
                  <c:v>5.567226890756285</c:v>
                </c:pt>
                <c:pt idx="1">
                  <c:v>-2.737973387922217</c:v>
                </c:pt>
                <c:pt idx="2">
                  <c:v>1.393728222996511</c:v>
                </c:pt>
                <c:pt idx="3">
                  <c:v>2.850061957868654</c:v>
                </c:pt>
                <c:pt idx="4">
                  <c:v>7.142857142857135</c:v>
                </c:pt>
                <c:pt idx="5">
                  <c:v>4.013377926421398</c:v>
                </c:pt>
                <c:pt idx="6">
                  <c:v>0.684931506849313</c:v>
                </c:pt>
                <c:pt idx="7">
                  <c:v>2.330779054916987</c:v>
                </c:pt>
                <c:pt idx="8">
                  <c:v>-2.207130730050955</c:v>
                </c:pt>
                <c:pt idx="9">
                  <c:v>0.61590145576709</c:v>
                </c:pt>
                <c:pt idx="10">
                  <c:v>4.244694132334602</c:v>
                </c:pt>
                <c:pt idx="11">
                  <c:v>7.029876977152874</c:v>
                </c:pt>
                <c:pt idx="12">
                  <c:v>4.301423027166888</c:v>
                </c:pt>
                <c:pt idx="13">
                  <c:v>3.26797385620915</c:v>
                </c:pt>
                <c:pt idx="14">
                  <c:v>1.900393184796861</c:v>
                </c:pt>
                <c:pt idx="15">
                  <c:v>0.548947849954264</c:v>
                </c:pt>
                <c:pt idx="16">
                  <c:v>5.045871559633035</c:v>
                </c:pt>
                <c:pt idx="17">
                  <c:v>-1.636713735558413</c:v>
                </c:pt>
                <c:pt idx="18">
                  <c:v>5.305989583333318</c:v>
                </c:pt>
                <c:pt idx="19">
                  <c:v>0.825688073394504</c:v>
                </c:pt>
                <c:pt idx="20">
                  <c:v>-0.645161290322578</c:v>
                </c:pt>
                <c:pt idx="21">
                  <c:v>0.901525658807193</c:v>
                </c:pt>
                <c:pt idx="22">
                  <c:v>6.100795755968182</c:v>
                </c:pt>
                <c:pt idx="23">
                  <c:v>9.713024282560728</c:v>
                </c:pt>
                <c:pt idx="24">
                  <c:v>3.953488372093008</c:v>
                </c:pt>
                <c:pt idx="25">
                  <c:v>3.151862464183382</c:v>
                </c:pt>
                <c:pt idx="26">
                  <c:v>0.628930817610049</c:v>
                </c:pt>
                <c:pt idx="27">
                  <c:v>4.805914972273549</c:v>
                </c:pt>
                <c:pt idx="28">
                  <c:v>4.346043460434588</c:v>
                </c:pt>
                <c:pt idx="29">
                  <c:v>-0.315955766192726</c:v>
                </c:pt>
                <c:pt idx="30">
                  <c:v>0.690087829360097</c:v>
                </c:pt>
                <c:pt idx="31">
                  <c:v>-3.685897435897431</c:v>
                </c:pt>
                <c:pt idx="32">
                  <c:v>0.653594771241816</c:v>
                </c:pt>
                <c:pt idx="33">
                  <c:v>5.953827460510312</c:v>
                </c:pt>
                <c:pt idx="34">
                  <c:v>4.17362270450753</c:v>
                </c:pt>
                <c:pt idx="35">
                  <c:v>-1.919475655430712</c:v>
                </c:pt>
                <c:pt idx="36">
                  <c:v>2.644230769230753</c:v>
                </c:pt>
                <c:pt idx="37">
                  <c:v>-1.764057331863291</c:v>
                </c:pt>
                <c:pt idx="38">
                  <c:v>6.435079726651466</c:v>
                </c:pt>
                <c:pt idx="39">
                  <c:v>5.993150684931506</c:v>
                </c:pt>
                <c:pt idx="40">
                  <c:v>1.758045292014292</c:v>
                </c:pt>
                <c:pt idx="41">
                  <c:v>4.032604032604035</c:v>
                </c:pt>
                <c:pt idx="42">
                  <c:v>-1.785714285714297</c:v>
                </c:pt>
                <c:pt idx="43">
                  <c:v>2.403846153846163</c:v>
                </c:pt>
                <c:pt idx="44">
                  <c:v>3.164556962025282</c:v>
                </c:pt>
                <c:pt idx="45">
                  <c:v>5.485232067510552</c:v>
                </c:pt>
                <c:pt idx="46">
                  <c:v>1.81582360570687</c:v>
                </c:pt>
                <c:pt idx="47">
                  <c:v>6.020942408376944</c:v>
                </c:pt>
                <c:pt idx="48">
                  <c:v>0.924744897959192</c:v>
                </c:pt>
                <c:pt idx="49">
                  <c:v>3.875476493011436</c:v>
                </c:pt>
                <c:pt idx="50">
                  <c:v>0.232828870779951</c:v>
                </c:pt>
                <c:pt idx="51">
                  <c:v>8.333333333333332</c:v>
                </c:pt>
                <c:pt idx="52">
                  <c:v>3.618421052631584</c:v>
                </c:pt>
                <c:pt idx="53">
                  <c:v>7.055214723926372</c:v>
                </c:pt>
                <c:pt idx="54">
                  <c:v>-1.764705882352924</c:v>
                </c:pt>
                <c:pt idx="55">
                  <c:v>-0.833333333333345</c:v>
                </c:pt>
                <c:pt idx="56">
                  <c:v>0.923482849604225</c:v>
                </c:pt>
                <c:pt idx="57">
                  <c:v>4.6718972895863</c:v>
                </c:pt>
                <c:pt idx="58">
                  <c:v>3.595890410958876</c:v>
                </c:pt>
                <c:pt idx="59">
                  <c:v>-2.002913328477796</c:v>
                </c:pt>
                <c:pt idx="60">
                  <c:v>-1.430842607313193</c:v>
                </c:pt>
                <c:pt idx="61">
                  <c:v>6.920199501246879</c:v>
                </c:pt>
                <c:pt idx="62">
                  <c:v>3.980891719745212</c:v>
                </c:pt>
                <c:pt idx="63">
                  <c:v>0.748013090229071</c:v>
                </c:pt>
                <c:pt idx="64">
                  <c:v>5.427631578947331</c:v>
                </c:pt>
                <c:pt idx="65">
                  <c:v>4.545454545454541</c:v>
                </c:pt>
                <c:pt idx="66">
                  <c:v>4.561403508771932</c:v>
                </c:pt>
                <c:pt idx="67">
                  <c:v>2.34375</c:v>
                </c:pt>
                <c:pt idx="68">
                  <c:v>-0.107066381156345</c:v>
                </c:pt>
                <c:pt idx="69">
                  <c:v>-0.549954170485791</c:v>
                </c:pt>
                <c:pt idx="70">
                  <c:v>2.627840909090916</c:v>
                </c:pt>
                <c:pt idx="71">
                  <c:v>9.04255319148937</c:v>
                </c:pt>
                <c:pt idx="72">
                  <c:v>-1.611226611226608</c:v>
                </c:pt>
                <c:pt idx="73">
                  <c:v>-1.946107784431134</c:v>
                </c:pt>
                <c:pt idx="74">
                  <c:v>3.55392156862744</c:v>
                </c:pt>
                <c:pt idx="75">
                  <c:v>4.761904761904769</c:v>
                </c:pt>
                <c:pt idx="76">
                  <c:v>7.288828337874648</c:v>
                </c:pt>
                <c:pt idx="77">
                  <c:v>5.580939947780694</c:v>
                </c:pt>
                <c:pt idx="78">
                  <c:v>3.723404255319152</c:v>
                </c:pt>
                <c:pt idx="79">
                  <c:v>4.850213980028527</c:v>
                </c:pt>
                <c:pt idx="80">
                  <c:v>-2.046783625730991</c:v>
                </c:pt>
                <c:pt idx="81">
                  <c:v>3.311258278145694</c:v>
                </c:pt>
                <c:pt idx="82">
                  <c:v>1.528384279475989</c:v>
                </c:pt>
                <c:pt idx="83">
                  <c:v>3.409090909090914</c:v>
                </c:pt>
                <c:pt idx="84">
                  <c:v>2.564102564102564</c:v>
                </c:pt>
                <c:pt idx="85">
                  <c:v>-1.127819548872183</c:v>
                </c:pt>
                <c:pt idx="86">
                  <c:v>-1.511879049676021</c:v>
                </c:pt>
                <c:pt idx="87">
                  <c:v>2.166666666666662</c:v>
                </c:pt>
                <c:pt idx="88">
                  <c:v>-3.691275167785227</c:v>
                </c:pt>
                <c:pt idx="89">
                  <c:v>4.107292539815586</c:v>
                </c:pt>
                <c:pt idx="90">
                  <c:v>2.614379084967323</c:v>
                </c:pt>
                <c:pt idx="91">
                  <c:v>5.134474327628349</c:v>
                </c:pt>
                <c:pt idx="92">
                  <c:v>2.901484480431822</c:v>
                </c:pt>
                <c:pt idx="93">
                  <c:v>2.520435967302447</c:v>
                </c:pt>
                <c:pt idx="94">
                  <c:v>2.991452991452992</c:v>
                </c:pt>
                <c:pt idx="95">
                  <c:v>-2.186421173762961</c:v>
                </c:pt>
                <c:pt idx="96">
                  <c:v>2.110157367668084</c:v>
                </c:pt>
                <c:pt idx="97">
                  <c:v>4.861111111111106</c:v>
                </c:pt>
                <c:pt idx="98">
                  <c:v>3.893979057591615</c:v>
                </c:pt>
                <c:pt idx="99">
                  <c:v>-0.932400932400933</c:v>
                </c:pt>
                <c:pt idx="100">
                  <c:v>1.301735647530054</c:v>
                </c:pt>
                <c:pt idx="101">
                  <c:v>1.935483870967746</c:v>
                </c:pt>
                <c:pt idx="102">
                  <c:v>2.574590952839286</c:v>
                </c:pt>
                <c:pt idx="103">
                  <c:v>3.174603174603198</c:v>
                </c:pt>
                <c:pt idx="104">
                  <c:v>4.345531315974681</c:v>
                </c:pt>
                <c:pt idx="105">
                  <c:v>4.166666666666674</c:v>
                </c:pt>
                <c:pt idx="106">
                  <c:v>1.718213058419256</c:v>
                </c:pt>
                <c:pt idx="107">
                  <c:v>8.695652173913051</c:v>
                </c:pt>
                <c:pt idx="108">
                  <c:v>9.019060901906088</c:v>
                </c:pt>
                <c:pt idx="109">
                  <c:v>12.9227053140097</c:v>
                </c:pt>
                <c:pt idx="110">
                  <c:v>0.312500000000004</c:v>
                </c:pt>
                <c:pt idx="111">
                  <c:v>2.507374631268422</c:v>
                </c:pt>
                <c:pt idx="112">
                  <c:v>4.643449419568805</c:v>
                </c:pt>
                <c:pt idx="113">
                  <c:v>-2.423469387755085</c:v>
                </c:pt>
                <c:pt idx="114">
                  <c:v>5.511811023622045</c:v>
                </c:pt>
                <c:pt idx="115">
                  <c:v>0.335570469798651</c:v>
                </c:pt>
                <c:pt idx="116">
                  <c:v>7.987505577866997</c:v>
                </c:pt>
                <c:pt idx="117">
                  <c:v>8.27338129496402</c:v>
                </c:pt>
                <c:pt idx="118">
                  <c:v>7.554417413572318</c:v>
                </c:pt>
                <c:pt idx="119">
                  <c:v>4.13929040735873</c:v>
                </c:pt>
                <c:pt idx="120">
                  <c:v>2.135980746089073</c:v>
                </c:pt>
                <c:pt idx="121">
                  <c:v>0.967540574282132</c:v>
                </c:pt>
                <c:pt idx="122">
                  <c:v>3.556485355648535</c:v>
                </c:pt>
                <c:pt idx="123">
                  <c:v>-0.410353535353543</c:v>
                </c:pt>
                <c:pt idx="124">
                  <c:v>1.724137931034496</c:v>
                </c:pt>
                <c:pt idx="125">
                  <c:v>6.434058898847635</c:v>
                </c:pt>
                <c:pt idx="126">
                  <c:v>-2.850589777195273</c:v>
                </c:pt>
                <c:pt idx="127">
                  <c:v>7.428571428571436</c:v>
                </c:pt>
                <c:pt idx="128">
                  <c:v>1.901743264659276</c:v>
                </c:pt>
                <c:pt idx="129">
                  <c:v>0.78125</c:v>
                </c:pt>
                <c:pt idx="130">
                  <c:v>2.211796246648806</c:v>
                </c:pt>
                <c:pt idx="131">
                  <c:v>3.680981595092011</c:v>
                </c:pt>
                <c:pt idx="132">
                  <c:v>-2.761627906976732</c:v>
                </c:pt>
                <c:pt idx="133">
                  <c:v>-0.114416475972546</c:v>
                </c:pt>
                <c:pt idx="134">
                  <c:v>-0.297619047619052</c:v>
                </c:pt>
                <c:pt idx="135">
                  <c:v>4.755784061696667</c:v>
                </c:pt>
                <c:pt idx="136">
                  <c:v>0.135317997293637</c:v>
                </c:pt>
                <c:pt idx="137">
                  <c:v>-1.944894651539713</c:v>
                </c:pt>
                <c:pt idx="138">
                  <c:v>2.718078381795206</c:v>
                </c:pt>
                <c:pt idx="139">
                  <c:v>2.741745283018858</c:v>
                </c:pt>
                <c:pt idx="140">
                  <c:v>0.477430555555549</c:v>
                </c:pt>
                <c:pt idx="141">
                  <c:v>5.308219178082182</c:v>
                </c:pt>
                <c:pt idx="142">
                  <c:v>1.700680272108844</c:v>
                </c:pt>
                <c:pt idx="143">
                  <c:v>-0.054347826086965</c:v>
                </c:pt>
                <c:pt idx="144">
                  <c:v>9.168865435356151</c:v>
                </c:pt>
                <c:pt idx="145">
                  <c:v>1.748251748251736</c:v>
                </c:pt>
                <c:pt idx="146">
                  <c:v>1.412259615384612</c:v>
                </c:pt>
                <c:pt idx="147">
                  <c:v>-2.941176470588223</c:v>
                </c:pt>
                <c:pt idx="148">
                  <c:v>-2.237354085603106</c:v>
                </c:pt>
                <c:pt idx="149">
                  <c:v>6.693620844564246</c:v>
                </c:pt>
                <c:pt idx="150">
                  <c:v>5.067567567567539</c:v>
                </c:pt>
                <c:pt idx="151">
                  <c:v>-2.83018867924528</c:v>
                </c:pt>
                <c:pt idx="152">
                  <c:v>3.144654088050303</c:v>
                </c:pt>
                <c:pt idx="153">
                  <c:v>4.611041405269723</c:v>
                </c:pt>
                <c:pt idx="154">
                  <c:v>-4.310003954132066</c:v>
                </c:pt>
                <c:pt idx="155">
                  <c:v>-3.064516129032267</c:v>
                </c:pt>
                <c:pt idx="156">
                  <c:v>3.758169934640518</c:v>
                </c:pt>
                <c:pt idx="157">
                  <c:v>5.020491803278684</c:v>
                </c:pt>
                <c:pt idx="158">
                  <c:v>-1.435574229691877</c:v>
                </c:pt>
                <c:pt idx="159">
                  <c:v>4.338842975206617</c:v>
                </c:pt>
                <c:pt idx="160">
                  <c:v>1.31578947368423</c:v>
                </c:pt>
                <c:pt idx="161">
                  <c:v>-2.058319039451108</c:v>
                </c:pt>
                <c:pt idx="162">
                  <c:v>3.082851637764926</c:v>
                </c:pt>
                <c:pt idx="163">
                  <c:v>2.756892230576438</c:v>
                </c:pt>
                <c:pt idx="164">
                  <c:v>-1.82926829268291</c:v>
                </c:pt>
                <c:pt idx="165">
                  <c:v>11.30798969072164</c:v>
                </c:pt>
                <c:pt idx="166">
                  <c:v>1.160602258469251</c:v>
                </c:pt>
                <c:pt idx="167">
                  <c:v>5.944055944055925</c:v>
                </c:pt>
                <c:pt idx="168">
                  <c:v>6.266149870801038</c:v>
                </c:pt>
                <c:pt idx="169">
                  <c:v>2.00777202072538</c:v>
                </c:pt>
                <c:pt idx="170">
                  <c:v>-1.600000000000011</c:v>
                </c:pt>
                <c:pt idx="171">
                  <c:v>5.375989445910287</c:v>
                </c:pt>
                <c:pt idx="172">
                  <c:v>4.404309252217994</c:v>
                </c:pt>
                <c:pt idx="173">
                  <c:v>4.581673306772917</c:v>
                </c:pt>
                <c:pt idx="174">
                  <c:v>1.40350877192982</c:v>
                </c:pt>
                <c:pt idx="175">
                  <c:v>1.763907734056986</c:v>
                </c:pt>
                <c:pt idx="176">
                  <c:v>-0.916380297823598</c:v>
                </c:pt>
                <c:pt idx="177">
                  <c:v>3.625170998632006</c:v>
                </c:pt>
                <c:pt idx="178">
                  <c:v>3.9002557544757</c:v>
                </c:pt>
                <c:pt idx="179">
                  <c:v>6.52624309392267</c:v>
                </c:pt>
                <c:pt idx="180">
                  <c:v>-5.555555555555562</c:v>
                </c:pt>
                <c:pt idx="181">
                  <c:v>0.456621004566227</c:v>
                </c:pt>
                <c:pt idx="182">
                  <c:v>-1.725304465493892</c:v>
                </c:pt>
                <c:pt idx="183">
                  <c:v>2.584814216478193</c:v>
                </c:pt>
                <c:pt idx="184">
                  <c:v>4.794933655006009</c:v>
                </c:pt>
                <c:pt idx="185">
                  <c:v>-1.533742331288344</c:v>
                </c:pt>
                <c:pt idx="186">
                  <c:v>5.628654970760203</c:v>
                </c:pt>
                <c:pt idx="187">
                  <c:v>3.401969561324988</c:v>
                </c:pt>
                <c:pt idx="188">
                  <c:v>2.476133651551307</c:v>
                </c:pt>
                <c:pt idx="189">
                  <c:v>-1.56250000000002</c:v>
                </c:pt>
                <c:pt idx="190">
                  <c:v>2.521008403361336</c:v>
                </c:pt>
                <c:pt idx="191">
                  <c:v>-1.256443298969063</c:v>
                </c:pt>
                <c:pt idx="192">
                  <c:v>4.65879265091863</c:v>
                </c:pt>
                <c:pt idx="193">
                  <c:v>5.373230373230366</c:v>
                </c:pt>
                <c:pt idx="194">
                  <c:v>1.155462184873962</c:v>
                </c:pt>
                <c:pt idx="195">
                  <c:v>9.949409780775713</c:v>
                </c:pt>
                <c:pt idx="196">
                  <c:v>2.92164674634795</c:v>
                </c:pt>
                <c:pt idx="197">
                  <c:v>3.872053872053858</c:v>
                </c:pt>
                <c:pt idx="198">
                  <c:v>8.179886685552416</c:v>
                </c:pt>
                <c:pt idx="199">
                  <c:v>-1.973401973401973</c:v>
                </c:pt>
                <c:pt idx="200">
                  <c:v>3.384615384615367</c:v>
                </c:pt>
                <c:pt idx="201">
                  <c:v>2.090592334494779</c:v>
                </c:pt>
                <c:pt idx="202">
                  <c:v>6.0897435897436</c:v>
                </c:pt>
                <c:pt idx="203">
                  <c:v>3.500000000000002</c:v>
                </c:pt>
                <c:pt idx="204">
                  <c:v>-2.888446215139434</c:v>
                </c:pt>
                <c:pt idx="205">
                  <c:v>2.25806451612903</c:v>
                </c:pt>
                <c:pt idx="206">
                  <c:v>2.083333333333326</c:v>
                </c:pt>
                <c:pt idx="207">
                  <c:v>2.471482889733822</c:v>
                </c:pt>
                <c:pt idx="208">
                  <c:v>-1.883561643835607</c:v>
                </c:pt>
                <c:pt idx="209">
                  <c:v>0.279850746268645</c:v>
                </c:pt>
                <c:pt idx="210">
                  <c:v>4.47928331466966</c:v>
                </c:pt>
                <c:pt idx="211">
                  <c:v>-4.69314079422383</c:v>
                </c:pt>
                <c:pt idx="212">
                  <c:v>3.43137254901961</c:v>
                </c:pt>
                <c:pt idx="213">
                  <c:v>-2.52976190476191</c:v>
                </c:pt>
                <c:pt idx="214">
                  <c:v>-0.283018867924527</c:v>
                </c:pt>
                <c:pt idx="215">
                  <c:v>1.167315175097298</c:v>
                </c:pt>
                <c:pt idx="216">
                  <c:v>-1.607142857142854</c:v>
                </c:pt>
                <c:pt idx="217">
                  <c:v>3.270609318996402</c:v>
                </c:pt>
                <c:pt idx="218">
                  <c:v>3.270609318996413</c:v>
                </c:pt>
                <c:pt idx="219">
                  <c:v>-1.371951219512182</c:v>
                </c:pt>
                <c:pt idx="220">
                  <c:v>-0.215982721382277</c:v>
                </c:pt>
                <c:pt idx="221">
                  <c:v>5.523495465787306</c:v>
                </c:pt>
                <c:pt idx="222">
                  <c:v>1.455301455301439</c:v>
                </c:pt>
                <c:pt idx="223">
                  <c:v>3.38709677419354</c:v>
                </c:pt>
                <c:pt idx="224">
                  <c:v>7.172995780590714</c:v>
                </c:pt>
                <c:pt idx="225">
                  <c:v>-2.850877192982458</c:v>
                </c:pt>
                <c:pt idx="226">
                  <c:v>5.408031088082883</c:v>
                </c:pt>
                <c:pt idx="227">
                  <c:v>2.489019033674962</c:v>
                </c:pt>
                <c:pt idx="228">
                  <c:v>-0.159744408945689</c:v>
                </c:pt>
                <c:pt idx="229">
                  <c:v>2.27272727272726</c:v>
                </c:pt>
                <c:pt idx="230">
                  <c:v>3.922651933701677</c:v>
                </c:pt>
                <c:pt idx="231">
                  <c:v>3.74639769452448</c:v>
                </c:pt>
                <c:pt idx="232">
                  <c:v>-1.487778958554735</c:v>
                </c:pt>
                <c:pt idx="233">
                  <c:v>-0.322580645161295</c:v>
                </c:pt>
                <c:pt idx="234">
                  <c:v>-1.263902932254774</c:v>
                </c:pt>
                <c:pt idx="235">
                  <c:v>-0.445292620865142</c:v>
                </c:pt>
                <c:pt idx="236">
                  <c:v>-4.127829560585877</c:v>
                </c:pt>
                <c:pt idx="237">
                  <c:v>-1.710893854748598</c:v>
                </c:pt>
                <c:pt idx="238">
                  <c:v>6.542397660818724</c:v>
                </c:pt>
                <c:pt idx="239">
                  <c:v>1.167929292929285</c:v>
                </c:pt>
                <c:pt idx="240">
                  <c:v>4.747675962815406</c:v>
                </c:pt>
                <c:pt idx="241">
                  <c:v>4.44151275285839</c:v>
                </c:pt>
                <c:pt idx="242">
                  <c:v>-1.029411764705886</c:v>
                </c:pt>
                <c:pt idx="243">
                  <c:v>0.104602510460256</c:v>
                </c:pt>
                <c:pt idx="244">
                  <c:v>3.947368421052641</c:v>
                </c:pt>
                <c:pt idx="245">
                  <c:v>4.221204188481673</c:v>
                </c:pt>
                <c:pt idx="246">
                  <c:v>1.430842607313193</c:v>
                </c:pt>
                <c:pt idx="247">
                  <c:v>4.37777777777775</c:v>
                </c:pt>
                <c:pt idx="248">
                  <c:v>2.61538461538462</c:v>
                </c:pt>
                <c:pt idx="249">
                  <c:v>2.423638778220453</c:v>
                </c:pt>
                <c:pt idx="250">
                  <c:v>-1.13636363636363</c:v>
                </c:pt>
                <c:pt idx="251">
                  <c:v>7.11111111111111</c:v>
                </c:pt>
                <c:pt idx="252">
                  <c:v>8.86571056062581</c:v>
                </c:pt>
                <c:pt idx="253">
                  <c:v>1.403061224489788</c:v>
                </c:pt>
                <c:pt idx="254">
                  <c:v>0.363070539419089</c:v>
                </c:pt>
                <c:pt idx="255">
                  <c:v>3.535353535353538</c:v>
                </c:pt>
                <c:pt idx="256">
                  <c:v>0.938735177865601</c:v>
                </c:pt>
                <c:pt idx="257">
                  <c:v>4.770017035775122</c:v>
                </c:pt>
                <c:pt idx="258">
                  <c:v>-0.804289544235908</c:v>
                </c:pt>
                <c:pt idx="259">
                  <c:v>1.973684210526321</c:v>
                </c:pt>
                <c:pt idx="260">
                  <c:v>-1.737967914438501</c:v>
                </c:pt>
                <c:pt idx="261">
                  <c:v>1.15236875800257</c:v>
                </c:pt>
                <c:pt idx="262">
                  <c:v>-1.477832512315283</c:v>
                </c:pt>
                <c:pt idx="263">
                  <c:v>1.513240857503165</c:v>
                </c:pt>
                <c:pt idx="264">
                  <c:v>0.645539906103283</c:v>
                </c:pt>
                <c:pt idx="265">
                  <c:v>0.326797385620908</c:v>
                </c:pt>
                <c:pt idx="266">
                  <c:v>-0.032938076416319</c:v>
                </c:pt>
                <c:pt idx="267">
                  <c:v>2.781329923273672</c:v>
                </c:pt>
                <c:pt idx="268">
                  <c:v>9.628378378378345</c:v>
                </c:pt>
                <c:pt idx="269">
                  <c:v>6.87022900763359</c:v>
                </c:pt>
                <c:pt idx="270">
                  <c:v>#N/A</c:v>
                </c:pt>
                <c:pt idx="271">
                  <c:v>6.48148148148147</c:v>
                </c:pt>
                <c:pt idx="272">
                  <c:v>4.010876954452748</c:v>
                </c:pt>
                <c:pt idx="273">
                  <c:v>1.697736351531297</c:v>
                </c:pt>
                <c:pt idx="274">
                  <c:v>2.884615384615414</c:v>
                </c:pt>
                <c:pt idx="275">
                  <c:v>2.430555555555553</c:v>
                </c:pt>
                <c:pt idx="276">
                  <c:v>3.431890179514252</c:v>
                </c:pt>
                <c:pt idx="277">
                  <c:v>4.239917269906925</c:v>
                </c:pt>
                <c:pt idx="278">
                  <c:v>4.190919674039574</c:v>
                </c:pt>
                <c:pt idx="279">
                  <c:v>3.588235294117656</c:v>
                </c:pt>
                <c:pt idx="280">
                  <c:v>4.964539007092194</c:v>
                </c:pt>
                <c:pt idx="281">
                  <c:v>9.751552795031058</c:v>
                </c:pt>
                <c:pt idx="282">
                  <c:v>2.640845070422548</c:v>
                </c:pt>
                <c:pt idx="283">
                  <c:v>2.836879432624107</c:v>
                </c:pt>
                <c:pt idx="284">
                  <c:v>2.333333333333343</c:v>
                </c:pt>
                <c:pt idx="285">
                  <c:v>-0.142045454545446</c:v>
                </c:pt>
                <c:pt idx="286">
                  <c:v>0.46728971962617</c:v>
                </c:pt>
                <c:pt idx="287">
                  <c:v>5.124223602484445</c:v>
                </c:pt>
                <c:pt idx="288">
                  <c:v>5.204342273307796</c:v>
                </c:pt>
                <c:pt idx="289">
                  <c:v>4.687499999999987</c:v>
                </c:pt>
                <c:pt idx="290">
                  <c:v>2.329192546583851</c:v>
                </c:pt>
                <c:pt idx="291">
                  <c:v>0.576662143826317</c:v>
                </c:pt>
                <c:pt idx="292">
                  <c:v>3.624382207578246</c:v>
                </c:pt>
                <c:pt idx="293">
                  <c:v>1.79775280898877</c:v>
                </c:pt>
                <c:pt idx="294">
                  <c:v>0.743855109961191</c:v>
                </c:pt>
                <c:pt idx="295">
                  <c:v>-1.415094339622639</c:v>
                </c:pt>
                <c:pt idx="296">
                  <c:v>1.296505073280732</c:v>
                </c:pt>
                <c:pt idx="297">
                  <c:v>6.18279569892473</c:v>
                </c:pt>
                <c:pt idx="298">
                  <c:v>-3.280542986425346</c:v>
                </c:pt>
                <c:pt idx="299">
                  <c:v>2.43538767395623</c:v>
                </c:pt>
                <c:pt idx="300">
                  <c:v>-0.704225352112671</c:v>
                </c:pt>
                <c:pt idx="301">
                  <c:v>-4.880478087649399</c:v>
                </c:pt>
                <c:pt idx="302">
                  <c:v>-5.089820359281424</c:v>
                </c:pt>
                <c:pt idx="303">
                  <c:v>-0.80195258019526</c:v>
                </c:pt>
                <c:pt idx="304">
                  <c:v>5.031779661016945</c:v>
                </c:pt>
                <c:pt idx="305">
                  <c:v>3.486180904522634</c:v>
                </c:pt>
                <c:pt idx="306">
                  <c:v>2.968036529680355</c:v>
                </c:pt>
                <c:pt idx="307">
                  <c:v>6.343283582089568</c:v>
                </c:pt>
                <c:pt idx="308">
                  <c:v>5.91755319148937</c:v>
                </c:pt>
                <c:pt idx="309">
                  <c:v>-0.337457817772795</c:v>
                </c:pt>
                <c:pt idx="310">
                  <c:v>-4.172320217096336</c:v>
                </c:pt>
                <c:pt idx="311">
                  <c:v>1.390374331550803</c:v>
                </c:pt>
                <c:pt idx="312">
                  <c:v>4.809725158562387</c:v>
                </c:pt>
                <c:pt idx="313">
                  <c:v>6.071428571428582</c:v>
                </c:pt>
                <c:pt idx="314">
                  <c:v>5.280528052805285</c:v>
                </c:pt>
                <c:pt idx="315">
                  <c:v>-2.65297389816005</c:v>
                </c:pt>
                <c:pt idx="316">
                  <c:v>-3.95833333333333</c:v>
                </c:pt>
                <c:pt idx="317">
                  <c:v>-4.01633764465624</c:v>
                </c:pt>
                <c:pt idx="318">
                  <c:v>8.48400556328234</c:v>
                </c:pt>
                <c:pt idx="319">
                  <c:v>0.714924039320831</c:v>
                </c:pt>
                <c:pt idx="320">
                  <c:v>2.728285077951001</c:v>
                </c:pt>
                <c:pt idx="321">
                  <c:v>6.874145006839925</c:v>
                </c:pt>
                <c:pt idx="322">
                  <c:v>1.825842696629209</c:v>
                </c:pt>
                <c:pt idx="323">
                  <c:v>2.509778357235983</c:v>
                </c:pt>
                <c:pt idx="324">
                  <c:v>-1.134800550206346</c:v>
                </c:pt>
                <c:pt idx="325">
                  <c:v>-9.503631961259081</c:v>
                </c:pt>
                <c:pt idx="326">
                  <c:v>-1.71503957783641</c:v>
                </c:pt>
                <c:pt idx="327">
                  <c:v>-0.730622617534933</c:v>
                </c:pt>
                <c:pt idx="328">
                  <c:v>3.679504814305353</c:v>
                </c:pt>
                <c:pt idx="329">
                  <c:v>4.916897506925189</c:v>
                </c:pt>
                <c:pt idx="330">
                  <c:v>1.090512540894228</c:v>
                </c:pt>
                <c:pt idx="331">
                  <c:v>-0.426309378806335</c:v>
                </c:pt>
                <c:pt idx="332">
                  <c:v>3.462157809983923</c:v>
                </c:pt>
                <c:pt idx="333">
                  <c:v>#N/A</c:v>
                </c:pt>
                <c:pt idx="334">
                  <c:v>-0.691699604743074</c:v>
                </c:pt>
                <c:pt idx="335">
                  <c:v>-2.221526908635797</c:v>
                </c:pt>
                <c:pt idx="336">
                  <c:v>-0.943396226415088</c:v>
                </c:pt>
                <c:pt idx="337">
                  <c:v>1.073619631901845</c:v>
                </c:pt>
                <c:pt idx="338">
                  <c:v>4.838709677419362</c:v>
                </c:pt>
                <c:pt idx="339">
                  <c:v>5.056980056980039</c:v>
                </c:pt>
                <c:pt idx="340">
                  <c:v>-3.416149068322964</c:v>
                </c:pt>
                <c:pt idx="341">
                  <c:v>2.358490566037724</c:v>
                </c:pt>
                <c:pt idx="342">
                  <c:v>-8.487654320987656</c:v>
                </c:pt>
                <c:pt idx="343">
                  <c:v>2.871621621621614</c:v>
                </c:pt>
                <c:pt idx="344">
                  <c:v>1.689189189189189</c:v>
                </c:pt>
                <c:pt idx="345">
                  <c:v>-1.150627615062755</c:v>
                </c:pt>
                <c:pt idx="346">
                  <c:v>4.417670682730936</c:v>
                </c:pt>
                <c:pt idx="347">
                  <c:v>-1.405622489959845</c:v>
                </c:pt>
                <c:pt idx="348">
                  <c:v>2.047502047502035</c:v>
                </c:pt>
                <c:pt idx="349">
                  <c:v>4.432397959183663</c:v>
                </c:pt>
                <c:pt idx="350">
                  <c:v>-0.22935779816515</c:v>
                </c:pt>
                <c:pt idx="351">
                  <c:v>1.070336391437291</c:v>
                </c:pt>
                <c:pt idx="352">
                  <c:v>-0.753186558516784</c:v>
                </c:pt>
                <c:pt idx="353">
                  <c:v>-2.329490874159451</c:v>
                </c:pt>
                <c:pt idx="354">
                  <c:v>-4.060913705583763</c:v>
                </c:pt>
                <c:pt idx="355">
                  <c:v>-2.881040892193307</c:v>
                </c:pt>
                <c:pt idx="356">
                  <c:v>1.138613861386137</c:v>
                </c:pt>
                <c:pt idx="357">
                  <c:v>4.955320877335507</c:v>
                </c:pt>
                <c:pt idx="358">
                  <c:v>-0.730411686586993</c:v>
                </c:pt>
                <c:pt idx="359">
                  <c:v>5.263157894736842</c:v>
                </c:pt>
                <c:pt idx="360">
                  <c:v>5.526770293609651</c:v>
                </c:pt>
                <c:pt idx="361">
                  <c:v>2.692307692307692</c:v>
                </c:pt>
                <c:pt idx="362">
                  <c:v>3.767123287671225</c:v>
                </c:pt>
                <c:pt idx="363">
                  <c:v>2.73722627737225</c:v>
                </c:pt>
                <c:pt idx="364">
                  <c:v>-2.474690663667057</c:v>
                </c:pt>
                <c:pt idx="365">
                  <c:v>2.317880794701996</c:v>
                </c:pt>
                <c:pt idx="366">
                  <c:v>-3.41614906832298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267520344"/>
        <c:axId val="2066030696"/>
      </c:scatterChart>
      <c:valAx>
        <c:axId val="-1267520344"/>
        <c:scaling>
          <c:orientation val="minMax"/>
          <c:max val="370.0"/>
          <c:min val="0.0"/>
        </c:scaling>
        <c:delete val="0"/>
        <c:axPos val="b"/>
        <c:majorTickMark val="out"/>
        <c:minorTickMark val="none"/>
        <c:tickLblPos val="nextTo"/>
        <c:spPr>
          <a:solidFill>
            <a:srgbClr val="FFFF00"/>
          </a:solidFill>
        </c:spPr>
        <c:txPr>
          <a:bodyPr/>
          <a:lstStyle/>
          <a:p>
            <a:pPr>
              <a:defRPr b="1" i="0">
                <a:solidFill>
                  <a:srgbClr val="0000FF"/>
                </a:solidFill>
                <a:latin typeface="Arial"/>
              </a:defRPr>
            </a:pPr>
            <a:endParaRPr lang="en-US"/>
          </a:p>
        </c:txPr>
        <c:crossAx val="2066030696"/>
        <c:crosses val="autoZero"/>
        <c:crossBetween val="midCat"/>
      </c:valAx>
      <c:valAx>
        <c:axId val="2066030696"/>
        <c:scaling>
          <c:orientation val="minMax"/>
          <c:max val="10.0"/>
          <c:min val="-1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0" i="0">
                <a:latin typeface="Arial"/>
              </a:defRPr>
            </a:pPr>
            <a:endParaRPr lang="en-US"/>
          </a:p>
        </c:txPr>
        <c:crossAx val="-126752034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47625">
              <a:noFill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013251312335958"/>
                  <c:y val="-0.392980825313502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solidFill>
                    <a:srgbClr val="000000"/>
                  </a:solidFill>
                </a:ln>
              </c:spPr>
              <c:txPr>
                <a:bodyPr/>
                <a:lstStyle/>
                <a:p>
                  <a:pPr>
                    <a:defRPr b="1" i="0" baseline="0">
                      <a:latin typeface="Arial"/>
                    </a:defRPr>
                  </a:pPr>
                  <a:endParaRPr lang="en-US"/>
                </a:p>
              </c:txPr>
            </c:trendlineLbl>
          </c:trendline>
          <c:yVal>
            <c:numRef>
              <c:f>'[③健診Hbデータまとめ_香崎 2.xlsx]事故後線量多い順'!$H$373:$H$693</c:f>
              <c:numCache>
                <c:formatCode>General</c:formatCode>
                <c:ptCount val="321"/>
                <c:pt idx="0">
                  <c:v>3.289473684210526</c:v>
                </c:pt>
                <c:pt idx="1">
                  <c:v>4.381443298969058</c:v>
                </c:pt>
                <c:pt idx="2">
                  <c:v>3.448275862068995</c:v>
                </c:pt>
                <c:pt idx="3">
                  <c:v>0.891677675033036</c:v>
                </c:pt>
                <c:pt idx="4">
                  <c:v>1.309328968903432</c:v>
                </c:pt>
                <c:pt idx="5">
                  <c:v>4.477611940298495</c:v>
                </c:pt>
                <c:pt idx="6">
                  <c:v>1.41820580474934</c:v>
                </c:pt>
                <c:pt idx="7">
                  <c:v>3.988222698072801</c:v>
                </c:pt>
                <c:pt idx="8">
                  <c:v>3.973509933774836</c:v>
                </c:pt>
                <c:pt idx="9">
                  <c:v>-2.30991337824832</c:v>
                </c:pt>
                <c:pt idx="10">
                  <c:v>8.01354401805869</c:v>
                </c:pt>
                <c:pt idx="11">
                  <c:v>2.272727272727265</c:v>
                </c:pt>
                <c:pt idx="12">
                  <c:v>-4.51174289245983</c:v>
                </c:pt>
                <c:pt idx="13">
                  <c:v>1.338729763387296</c:v>
                </c:pt>
                <c:pt idx="14">
                  <c:v>3.192584963954702</c:v>
                </c:pt>
                <c:pt idx="15">
                  <c:v>19.71635150166852</c:v>
                </c:pt>
                <c:pt idx="16">
                  <c:v>1.039651837524177</c:v>
                </c:pt>
                <c:pt idx="17">
                  <c:v>3.781882145998235</c:v>
                </c:pt>
                <c:pt idx="18">
                  <c:v>-1.699029126213575</c:v>
                </c:pt>
                <c:pt idx="19">
                  <c:v>5.53564317005177</c:v>
                </c:pt>
                <c:pt idx="20">
                  <c:v>8.236151603498541</c:v>
                </c:pt>
                <c:pt idx="21">
                  <c:v>8.05860805860804</c:v>
                </c:pt>
                <c:pt idx="22">
                  <c:v>-0.426985482493607</c:v>
                </c:pt>
                <c:pt idx="23">
                  <c:v>2.335456475583835</c:v>
                </c:pt>
                <c:pt idx="24">
                  <c:v>3.351648351648357</c:v>
                </c:pt>
                <c:pt idx="25">
                  <c:v>0.315457413249205</c:v>
                </c:pt>
                <c:pt idx="26">
                  <c:v>-0.324675324675329</c:v>
                </c:pt>
                <c:pt idx="27">
                  <c:v>6.607142857142854</c:v>
                </c:pt>
                <c:pt idx="28">
                  <c:v>9.469240048250906</c:v>
                </c:pt>
                <c:pt idx="29">
                  <c:v>1.511169513797638</c:v>
                </c:pt>
                <c:pt idx="30">
                  <c:v>1.883561643835619</c:v>
                </c:pt>
                <c:pt idx="31">
                  <c:v>-1.609195402298857</c:v>
                </c:pt>
                <c:pt idx="32">
                  <c:v>3.107344632768358</c:v>
                </c:pt>
                <c:pt idx="33">
                  <c:v>2.481751824817521</c:v>
                </c:pt>
                <c:pt idx="34">
                  <c:v>0.263991552270324</c:v>
                </c:pt>
                <c:pt idx="35">
                  <c:v>3.67924528301887</c:v>
                </c:pt>
                <c:pt idx="36">
                  <c:v>2.94985250737461</c:v>
                </c:pt>
                <c:pt idx="37">
                  <c:v>-6.371911573472055</c:v>
                </c:pt>
                <c:pt idx="38">
                  <c:v>-1.464713715046597</c:v>
                </c:pt>
                <c:pt idx="39">
                  <c:v>-1.749663526244952</c:v>
                </c:pt>
                <c:pt idx="40">
                  <c:v>3.166666666666676</c:v>
                </c:pt>
                <c:pt idx="41">
                  <c:v>-2.354111405835558</c:v>
                </c:pt>
                <c:pt idx="42">
                  <c:v>2.049180327868867</c:v>
                </c:pt>
                <c:pt idx="43">
                  <c:v>6.365503080082138</c:v>
                </c:pt>
                <c:pt idx="44">
                  <c:v>14.31256713211603</c:v>
                </c:pt>
                <c:pt idx="45">
                  <c:v>-1.190476190476195</c:v>
                </c:pt>
                <c:pt idx="46">
                  <c:v>1.748251748251736</c:v>
                </c:pt>
                <c:pt idx="47">
                  <c:v>5.143229166666661</c:v>
                </c:pt>
                <c:pt idx="48">
                  <c:v>-0.471698113207554</c:v>
                </c:pt>
                <c:pt idx="49">
                  <c:v>1.388888888888876</c:v>
                </c:pt>
                <c:pt idx="50">
                  <c:v>2.009536784741143</c:v>
                </c:pt>
                <c:pt idx="51">
                  <c:v>-1.836969001148087</c:v>
                </c:pt>
                <c:pt idx="52">
                  <c:v>9.526627218934926</c:v>
                </c:pt>
                <c:pt idx="53">
                  <c:v>3.333333333333318</c:v>
                </c:pt>
                <c:pt idx="54">
                  <c:v>2.331002331002336</c:v>
                </c:pt>
                <c:pt idx="55">
                  <c:v>1.329442282749688</c:v>
                </c:pt>
                <c:pt idx="56">
                  <c:v>-1.833872707659115</c:v>
                </c:pt>
                <c:pt idx="57">
                  <c:v>1.023706896551723</c:v>
                </c:pt>
                <c:pt idx="58">
                  <c:v>2.382908792111743</c:v>
                </c:pt>
                <c:pt idx="59">
                  <c:v>2.524630541871923</c:v>
                </c:pt>
                <c:pt idx="60">
                  <c:v>7.665394402035636</c:v>
                </c:pt>
                <c:pt idx="61">
                  <c:v>2.901484480431859</c:v>
                </c:pt>
                <c:pt idx="62">
                  <c:v>3.464717101080725</c:v>
                </c:pt>
                <c:pt idx="63">
                  <c:v>4.697986577181189</c:v>
                </c:pt>
                <c:pt idx="64">
                  <c:v>5.995203836930472</c:v>
                </c:pt>
                <c:pt idx="65">
                  <c:v>-2.858176555716337</c:v>
                </c:pt>
                <c:pt idx="66">
                  <c:v>-0.107066381156311</c:v>
                </c:pt>
                <c:pt idx="67">
                  <c:v>0.199733688415454</c:v>
                </c:pt>
                <c:pt idx="68">
                  <c:v>5.627306273062715</c:v>
                </c:pt>
                <c:pt idx="69">
                  <c:v>4.332010582010565</c:v>
                </c:pt>
                <c:pt idx="70">
                  <c:v>5.745341614906814</c:v>
                </c:pt>
                <c:pt idx="71">
                  <c:v>-2.296937416777634</c:v>
                </c:pt>
                <c:pt idx="72">
                  <c:v>0.257069408740354</c:v>
                </c:pt>
                <c:pt idx="73">
                  <c:v>0.763612217795498</c:v>
                </c:pt>
                <c:pt idx="74">
                  <c:v>-0.353016688061627</c:v>
                </c:pt>
                <c:pt idx="75">
                  <c:v>1.307189542483656</c:v>
                </c:pt>
                <c:pt idx="76">
                  <c:v>2.352941176470598</c:v>
                </c:pt>
                <c:pt idx="77">
                  <c:v>4.11184210526316</c:v>
                </c:pt>
                <c:pt idx="78">
                  <c:v>5.202879581151845</c:v>
                </c:pt>
                <c:pt idx="79">
                  <c:v>3.171641791044768</c:v>
                </c:pt>
                <c:pt idx="80">
                  <c:v>-10.08563273073266</c:v>
                </c:pt>
                <c:pt idx="81">
                  <c:v>6.29675810473817</c:v>
                </c:pt>
                <c:pt idx="82">
                  <c:v>1.846590909090884</c:v>
                </c:pt>
                <c:pt idx="83">
                  <c:v>0.0</c:v>
                </c:pt>
                <c:pt idx="84">
                  <c:v>1.725260416666647</c:v>
                </c:pt>
                <c:pt idx="85">
                  <c:v>-11.37254901960785</c:v>
                </c:pt>
                <c:pt idx="86">
                  <c:v>-3.314285714285706</c:v>
                </c:pt>
                <c:pt idx="87">
                  <c:v>3.854024556616652</c:v>
                </c:pt>
                <c:pt idx="88">
                  <c:v>2.333333333333343</c:v>
                </c:pt>
                <c:pt idx="89">
                  <c:v>-2.376485303314566</c:v>
                </c:pt>
                <c:pt idx="90">
                  <c:v>4.045307443365694</c:v>
                </c:pt>
                <c:pt idx="91">
                  <c:v>5.280312907431544</c:v>
                </c:pt>
                <c:pt idx="92">
                  <c:v>6.462585034013609</c:v>
                </c:pt>
                <c:pt idx="93">
                  <c:v>3.727144866385355</c:v>
                </c:pt>
                <c:pt idx="94">
                  <c:v>4.79632063074899</c:v>
                </c:pt>
                <c:pt idx="95">
                  <c:v>1.207906295754019</c:v>
                </c:pt>
                <c:pt idx="96">
                  <c:v>0.353356890459356</c:v>
                </c:pt>
                <c:pt idx="97">
                  <c:v>3.348467650397292</c:v>
                </c:pt>
                <c:pt idx="98">
                  <c:v>#N/A</c:v>
                </c:pt>
                <c:pt idx="99">
                  <c:v>5.350066050198142</c:v>
                </c:pt>
                <c:pt idx="100">
                  <c:v>-4.919908466819234</c:v>
                </c:pt>
                <c:pt idx="101">
                  <c:v>-4.24618320610687</c:v>
                </c:pt>
                <c:pt idx="102">
                  <c:v>1.33744855967076</c:v>
                </c:pt>
                <c:pt idx="103">
                  <c:v>4.032258064516128</c:v>
                </c:pt>
                <c:pt idx="104">
                  <c:v>-3.017241379310344</c:v>
                </c:pt>
                <c:pt idx="105">
                  <c:v>-2.995720399429386</c:v>
                </c:pt>
                <c:pt idx="106">
                  <c:v>1.041666666666669</c:v>
                </c:pt>
                <c:pt idx="107">
                  <c:v>1.840101522842645</c:v>
                </c:pt>
                <c:pt idx="108">
                  <c:v>1.484623541887576</c:v>
                </c:pt>
                <c:pt idx="109">
                  <c:v>3.316326530612276</c:v>
                </c:pt>
                <c:pt idx="110">
                  <c:v>-0.335570469798651</c:v>
                </c:pt>
                <c:pt idx="111">
                  <c:v>-0.375536480686685</c:v>
                </c:pt>
                <c:pt idx="112">
                  <c:v>-3.326745718050048</c:v>
                </c:pt>
                <c:pt idx="113">
                  <c:v>2.132262051915939</c:v>
                </c:pt>
                <c:pt idx="114">
                  <c:v>-0.652985074626879</c:v>
                </c:pt>
                <c:pt idx="115">
                  <c:v>-4.823989569752269</c:v>
                </c:pt>
                <c:pt idx="116">
                  <c:v>5.254120879120846</c:v>
                </c:pt>
                <c:pt idx="117">
                  <c:v>-0.588768115942036</c:v>
                </c:pt>
                <c:pt idx="118">
                  <c:v>3.730366492146622</c:v>
                </c:pt>
                <c:pt idx="119">
                  <c:v>-7.965056526207589</c:v>
                </c:pt>
                <c:pt idx="120">
                  <c:v>2.30179028132992</c:v>
                </c:pt>
                <c:pt idx="121">
                  <c:v>-1.872074882995302</c:v>
                </c:pt>
                <c:pt idx="122">
                  <c:v>3.85906040268457</c:v>
                </c:pt>
                <c:pt idx="123">
                  <c:v>0.713627992633529</c:v>
                </c:pt>
                <c:pt idx="124">
                  <c:v>1.78571428571429</c:v>
                </c:pt>
                <c:pt idx="125">
                  <c:v>0.210084033613445</c:v>
                </c:pt>
                <c:pt idx="126">
                  <c:v>#N/A</c:v>
                </c:pt>
                <c:pt idx="127">
                  <c:v>0.265700483091777</c:v>
                </c:pt>
                <c:pt idx="128">
                  <c:v>4.325699745547072</c:v>
                </c:pt>
                <c:pt idx="129">
                  <c:v>-1.499999999999998</c:v>
                </c:pt>
                <c:pt idx="130">
                  <c:v>3.287092882991544</c:v>
                </c:pt>
                <c:pt idx="131">
                  <c:v>-1.675041876046901</c:v>
                </c:pt>
                <c:pt idx="132">
                  <c:v>-5.459057071960304</c:v>
                </c:pt>
                <c:pt idx="133">
                  <c:v>2.914663461538479</c:v>
                </c:pt>
                <c:pt idx="134">
                  <c:v>2.17842323651452</c:v>
                </c:pt>
                <c:pt idx="135">
                  <c:v>1.052631578947371</c:v>
                </c:pt>
                <c:pt idx="136">
                  <c:v>0.870827285921617</c:v>
                </c:pt>
                <c:pt idx="137">
                  <c:v>1.468624833110831</c:v>
                </c:pt>
                <c:pt idx="138">
                  <c:v>-2.794117647058832</c:v>
                </c:pt>
                <c:pt idx="139">
                  <c:v>-3.437500000000004</c:v>
                </c:pt>
                <c:pt idx="140">
                  <c:v>0.21097046413502</c:v>
                </c:pt>
                <c:pt idx="141">
                  <c:v>2.803738317757032</c:v>
                </c:pt>
                <c:pt idx="142">
                  <c:v>3.361945636623744</c:v>
                </c:pt>
                <c:pt idx="143">
                  <c:v>-1.437371663244337</c:v>
                </c:pt>
                <c:pt idx="144">
                  <c:v>-4.573170731707306</c:v>
                </c:pt>
                <c:pt idx="145">
                  <c:v>1.231190150478806</c:v>
                </c:pt>
                <c:pt idx="146">
                  <c:v>3.83858267716536</c:v>
                </c:pt>
                <c:pt idx="147">
                  <c:v>-0.686740623349176</c:v>
                </c:pt>
                <c:pt idx="148">
                  <c:v>0.265604249668001</c:v>
                </c:pt>
                <c:pt idx="149">
                  <c:v>-3.999999999999997</c:v>
                </c:pt>
                <c:pt idx="150">
                  <c:v>2.363515312916103</c:v>
                </c:pt>
                <c:pt idx="151">
                  <c:v>0.423728813559324</c:v>
                </c:pt>
                <c:pt idx="152">
                  <c:v>2.610114192495936</c:v>
                </c:pt>
                <c:pt idx="153">
                  <c:v>-0.934278350515461</c:v>
                </c:pt>
                <c:pt idx="154">
                  <c:v>0.781250000000007</c:v>
                </c:pt>
                <c:pt idx="155">
                  <c:v>-0.377969762418996</c:v>
                </c:pt>
                <c:pt idx="156">
                  <c:v>3.77258235919235</c:v>
                </c:pt>
                <c:pt idx="157">
                  <c:v>0.42317708333333</c:v>
                </c:pt>
                <c:pt idx="158">
                  <c:v>2.708058124174373</c:v>
                </c:pt>
                <c:pt idx="159">
                  <c:v>-6.371595330739306</c:v>
                </c:pt>
                <c:pt idx="160">
                  <c:v>0.766871165644194</c:v>
                </c:pt>
                <c:pt idx="161">
                  <c:v>2.395411605937937</c:v>
                </c:pt>
                <c:pt idx="162">
                  <c:v>1.141078838174255</c:v>
                </c:pt>
                <c:pt idx="163">
                  <c:v>1.587301587301576</c:v>
                </c:pt>
                <c:pt idx="164">
                  <c:v>0.649350649350635</c:v>
                </c:pt>
                <c:pt idx="165">
                  <c:v>2.007299270072995</c:v>
                </c:pt>
                <c:pt idx="166">
                  <c:v>2.844311377245517</c:v>
                </c:pt>
                <c:pt idx="167">
                  <c:v>2.428256070640168</c:v>
                </c:pt>
                <c:pt idx="168">
                  <c:v>-0.803722504230109</c:v>
                </c:pt>
                <c:pt idx="169">
                  <c:v>7.068245125348193</c:v>
                </c:pt>
                <c:pt idx="170">
                  <c:v>7.48626373626374</c:v>
                </c:pt>
                <c:pt idx="171">
                  <c:v>2.718078381795206</c:v>
                </c:pt>
                <c:pt idx="172">
                  <c:v>1.814300960512261</c:v>
                </c:pt>
                <c:pt idx="173">
                  <c:v>2.046783625730982</c:v>
                </c:pt>
                <c:pt idx="174">
                  <c:v>-3.430749682337998</c:v>
                </c:pt>
                <c:pt idx="175">
                  <c:v>4.05844155844157</c:v>
                </c:pt>
                <c:pt idx="176">
                  <c:v>-1.729399796541194</c:v>
                </c:pt>
                <c:pt idx="177">
                  <c:v>5.74018126888217</c:v>
                </c:pt>
                <c:pt idx="178">
                  <c:v>1.031957390146467</c:v>
                </c:pt>
                <c:pt idx="179">
                  <c:v>27.08333333333326</c:v>
                </c:pt>
                <c:pt idx="180">
                  <c:v>0.0615763546797907</c:v>
                </c:pt>
                <c:pt idx="181">
                  <c:v>-1.0818120351589</c:v>
                </c:pt>
                <c:pt idx="182">
                  <c:v>-1.818181818181823</c:v>
                </c:pt>
                <c:pt idx="183">
                  <c:v>#N/A</c:v>
                </c:pt>
                <c:pt idx="184">
                  <c:v>-2.23350253807107</c:v>
                </c:pt>
                <c:pt idx="185">
                  <c:v>-0.354609929078007</c:v>
                </c:pt>
                <c:pt idx="186">
                  <c:v>-0.209205020920524</c:v>
                </c:pt>
                <c:pt idx="187">
                  <c:v>#N/A</c:v>
                </c:pt>
                <c:pt idx="188">
                  <c:v>0.176056338028172</c:v>
                </c:pt>
                <c:pt idx="189">
                  <c:v>2.22457627118645</c:v>
                </c:pt>
                <c:pt idx="190">
                  <c:v>2.344546381243626</c:v>
                </c:pt>
                <c:pt idx="191">
                  <c:v>-0.848972296693468</c:v>
                </c:pt>
                <c:pt idx="192">
                  <c:v>-5.272564789991043</c:v>
                </c:pt>
                <c:pt idx="193">
                  <c:v>-2.852049910873426</c:v>
                </c:pt>
                <c:pt idx="194">
                  <c:v>-5.701754385964903</c:v>
                </c:pt>
                <c:pt idx="195">
                  <c:v>0.49668874172185</c:v>
                </c:pt>
                <c:pt idx="196">
                  <c:v>-2.952261306532645</c:v>
                </c:pt>
                <c:pt idx="197">
                  <c:v>-1.628222523744913</c:v>
                </c:pt>
                <c:pt idx="198">
                  <c:v>#N/A</c:v>
                </c:pt>
                <c:pt idx="199">
                  <c:v>-3.184713375796167</c:v>
                </c:pt>
                <c:pt idx="200">
                  <c:v>#N/A</c:v>
                </c:pt>
                <c:pt idx="201">
                  <c:v>-0.647249190938497</c:v>
                </c:pt>
                <c:pt idx="202">
                  <c:v>-0.390624999999999</c:v>
                </c:pt>
                <c:pt idx="203">
                  <c:v>-1.57342657342656</c:v>
                </c:pt>
                <c:pt idx="204">
                  <c:v>0.327868852459021</c:v>
                </c:pt>
                <c:pt idx="205">
                  <c:v>-1.742788461538456</c:v>
                </c:pt>
                <c:pt idx="206">
                  <c:v>0.773480662983417</c:v>
                </c:pt>
                <c:pt idx="207">
                  <c:v>0.164473684210529</c:v>
                </c:pt>
                <c:pt idx="208">
                  <c:v>-2.2633744855967</c:v>
                </c:pt>
                <c:pt idx="209">
                  <c:v>0.162866449511403</c:v>
                </c:pt>
                <c:pt idx="210">
                  <c:v>2.456258411843854</c:v>
                </c:pt>
                <c:pt idx="211">
                  <c:v>0.773889636608358</c:v>
                </c:pt>
                <c:pt idx="212">
                  <c:v>2.954144620811303</c:v>
                </c:pt>
                <c:pt idx="213">
                  <c:v>4.054959785522767</c:v>
                </c:pt>
                <c:pt idx="214">
                  <c:v>4.768786127167644</c:v>
                </c:pt>
                <c:pt idx="215">
                  <c:v>3.192488262910799</c:v>
                </c:pt>
                <c:pt idx="216">
                  <c:v>0.877192982456142</c:v>
                </c:pt>
                <c:pt idx="217">
                  <c:v>-0.0513347022587021</c:v>
                </c:pt>
                <c:pt idx="218">
                  <c:v>-3.708668453976772</c:v>
                </c:pt>
                <c:pt idx="219">
                  <c:v>5.082417582417595</c:v>
                </c:pt>
                <c:pt idx="220">
                  <c:v>-0.60408921933086</c:v>
                </c:pt>
                <c:pt idx="221">
                  <c:v>-3.211009174311939</c:v>
                </c:pt>
                <c:pt idx="222">
                  <c:v>-0.432180851063838</c:v>
                </c:pt>
                <c:pt idx="223">
                  <c:v>0.332225913621255</c:v>
                </c:pt>
                <c:pt idx="224">
                  <c:v>#N/A</c:v>
                </c:pt>
                <c:pt idx="225">
                  <c:v>1.190476190476183</c:v>
                </c:pt>
                <c:pt idx="226">
                  <c:v>0.513698630136994</c:v>
                </c:pt>
                <c:pt idx="227">
                  <c:v>-0.862068965517241</c:v>
                </c:pt>
                <c:pt idx="228">
                  <c:v>-0.778210116731512</c:v>
                </c:pt>
                <c:pt idx="229">
                  <c:v>-0.596733668341712</c:v>
                </c:pt>
                <c:pt idx="230">
                  <c:v>-1.28624883068288</c:v>
                </c:pt>
                <c:pt idx="231">
                  <c:v>2.493074792243763</c:v>
                </c:pt>
                <c:pt idx="232">
                  <c:v>-0.603968938740296</c:v>
                </c:pt>
                <c:pt idx="233">
                  <c:v>2.212389380530954</c:v>
                </c:pt>
                <c:pt idx="234">
                  <c:v>0.942962281508733</c:v>
                </c:pt>
                <c:pt idx="235">
                  <c:v>-3.371062992125994</c:v>
                </c:pt>
                <c:pt idx="236">
                  <c:v>2.596053997923156</c:v>
                </c:pt>
                <c:pt idx="237">
                  <c:v>-3.403141361256541</c:v>
                </c:pt>
                <c:pt idx="238">
                  <c:v>-0.179856115107916</c:v>
                </c:pt>
                <c:pt idx="239">
                  <c:v>1.722532588454372</c:v>
                </c:pt>
                <c:pt idx="240">
                  <c:v>-3.236040609137066</c:v>
                </c:pt>
                <c:pt idx="241">
                  <c:v>-0.809248554913286</c:v>
                </c:pt>
                <c:pt idx="242">
                  <c:v>-2.232142857142837</c:v>
                </c:pt>
                <c:pt idx="243">
                  <c:v>-3.626149131767099</c:v>
                </c:pt>
                <c:pt idx="244">
                  <c:v>-0.111731843575401</c:v>
                </c:pt>
                <c:pt idx="245">
                  <c:v>-0.866738894907906</c:v>
                </c:pt>
                <c:pt idx="246">
                  <c:v>3.196233894945502</c:v>
                </c:pt>
                <c:pt idx="247">
                  <c:v>6.20567375886526</c:v>
                </c:pt>
                <c:pt idx="248">
                  <c:v>-9.34426229508196</c:v>
                </c:pt>
                <c:pt idx="249">
                  <c:v>13.0952380952381</c:v>
                </c:pt>
                <c:pt idx="250">
                  <c:v>-1.428571428571437</c:v>
                </c:pt>
                <c:pt idx="251">
                  <c:v>-2.56588072122051</c:v>
                </c:pt>
                <c:pt idx="252">
                  <c:v>4.583835946924028</c:v>
                </c:pt>
                <c:pt idx="253">
                  <c:v>-3.180212014134283</c:v>
                </c:pt>
                <c:pt idx="254">
                  <c:v>0.0531914893616991</c:v>
                </c:pt>
                <c:pt idx="255">
                  <c:v>-7.946635730858474</c:v>
                </c:pt>
                <c:pt idx="256">
                  <c:v>1.999999999999993</c:v>
                </c:pt>
                <c:pt idx="257">
                  <c:v>1.661129568106324</c:v>
                </c:pt>
                <c:pt idx="258">
                  <c:v>6.276005547850229</c:v>
                </c:pt>
                <c:pt idx="259">
                  <c:v>-1.461574728901476</c:v>
                </c:pt>
                <c:pt idx="260">
                  <c:v>-2.352418996893024</c:v>
                </c:pt>
                <c:pt idx="261">
                  <c:v>-1.121794871794865</c:v>
                </c:pt>
                <c:pt idx="262">
                  <c:v>-0.105042016806717</c:v>
                </c:pt>
                <c:pt idx="263">
                  <c:v>-4.255319148936164</c:v>
                </c:pt>
                <c:pt idx="264">
                  <c:v>-1.846590909090925</c:v>
                </c:pt>
                <c:pt idx="265">
                  <c:v>2.528089887640456</c:v>
                </c:pt>
                <c:pt idx="266">
                  <c:v>0.0</c:v>
                </c:pt>
                <c:pt idx="267">
                  <c:v>1.181948424068775</c:v>
                </c:pt>
                <c:pt idx="268">
                  <c:v>#N/A</c:v>
                </c:pt>
                <c:pt idx="269">
                  <c:v>-6.23036649214659</c:v>
                </c:pt>
                <c:pt idx="270">
                  <c:v>-1.725304465493904</c:v>
                </c:pt>
                <c:pt idx="271">
                  <c:v>1.620947630922703</c:v>
                </c:pt>
                <c:pt idx="272">
                  <c:v>-1.970954356846462</c:v>
                </c:pt>
                <c:pt idx="273">
                  <c:v>6.175693527080598</c:v>
                </c:pt>
                <c:pt idx="274">
                  <c:v>2.357320099255599</c:v>
                </c:pt>
                <c:pt idx="275">
                  <c:v>-4.130434782608702</c:v>
                </c:pt>
                <c:pt idx="276">
                  <c:v>-1.534828807556094</c:v>
                </c:pt>
                <c:pt idx="277">
                  <c:v>-3.196803196803177</c:v>
                </c:pt>
                <c:pt idx="278">
                  <c:v>-4.723127035830616</c:v>
                </c:pt>
                <c:pt idx="279">
                  <c:v>3.793103448275867</c:v>
                </c:pt>
                <c:pt idx="280">
                  <c:v>-2.904699738903407</c:v>
                </c:pt>
                <c:pt idx="281">
                  <c:v>-0.811688311688312</c:v>
                </c:pt>
                <c:pt idx="282">
                  <c:v>3.174603174603173</c:v>
                </c:pt>
                <c:pt idx="283">
                  <c:v>2.222222222222226</c:v>
                </c:pt>
                <c:pt idx="284">
                  <c:v>-1.046831955922852</c:v>
                </c:pt>
                <c:pt idx="285">
                  <c:v>3.985056039850539</c:v>
                </c:pt>
                <c:pt idx="286">
                  <c:v>-5.043859649122813</c:v>
                </c:pt>
                <c:pt idx="287">
                  <c:v>1.040118870728088</c:v>
                </c:pt>
                <c:pt idx="288">
                  <c:v>0.131752305665335</c:v>
                </c:pt>
                <c:pt idx="289">
                  <c:v>2.516778523489933</c:v>
                </c:pt>
                <c:pt idx="290">
                  <c:v>0.929614873837997</c:v>
                </c:pt>
                <c:pt idx="291">
                  <c:v>-2.50000000000001</c:v>
                </c:pt>
                <c:pt idx="292">
                  <c:v>-1.664611590628872</c:v>
                </c:pt>
                <c:pt idx="293">
                  <c:v>2.411684782608711</c:v>
                </c:pt>
                <c:pt idx="294">
                  <c:v>-5.487804878048769</c:v>
                </c:pt>
                <c:pt idx="295">
                  <c:v>2.771362586605096</c:v>
                </c:pt>
                <c:pt idx="296">
                  <c:v>-0.44101433296582</c:v>
                </c:pt>
                <c:pt idx="297">
                  <c:v>1.190476190476184</c:v>
                </c:pt>
                <c:pt idx="298">
                  <c:v>-1.034928848641645</c:v>
                </c:pt>
                <c:pt idx="299">
                  <c:v>0.0970245795601589</c:v>
                </c:pt>
                <c:pt idx="300">
                  <c:v>-1.65016501650164</c:v>
                </c:pt>
                <c:pt idx="301">
                  <c:v>-0.0536480686695248</c:v>
                </c:pt>
                <c:pt idx="302">
                  <c:v>0.738585496866602</c:v>
                </c:pt>
                <c:pt idx="303">
                  <c:v>1.108647450110873</c:v>
                </c:pt>
                <c:pt idx="304">
                  <c:v>-0.541711809317435</c:v>
                </c:pt>
                <c:pt idx="305">
                  <c:v>2.04402515723269</c:v>
                </c:pt>
                <c:pt idx="306">
                  <c:v>-1.785714285714267</c:v>
                </c:pt>
                <c:pt idx="307">
                  <c:v>-3.342070773263432</c:v>
                </c:pt>
                <c:pt idx="308">
                  <c:v>-1.541095890410957</c:v>
                </c:pt>
                <c:pt idx="309">
                  <c:v>0.165562913907287</c:v>
                </c:pt>
                <c:pt idx="310">
                  <c:v>-4.537286612758312</c:v>
                </c:pt>
                <c:pt idx="311">
                  <c:v>-0.505050505050503</c:v>
                </c:pt>
                <c:pt idx="312">
                  <c:v>-1.77224736048267</c:v>
                </c:pt>
                <c:pt idx="313">
                  <c:v>-0.824652777777791</c:v>
                </c:pt>
                <c:pt idx="314">
                  <c:v>-0.305410122164027</c:v>
                </c:pt>
                <c:pt idx="315">
                  <c:v>-5.475880052151238</c:v>
                </c:pt>
                <c:pt idx="316">
                  <c:v>1.76701570680628</c:v>
                </c:pt>
                <c:pt idx="317">
                  <c:v>0.122699386503087</c:v>
                </c:pt>
                <c:pt idx="318">
                  <c:v>-1.531573986804904</c:v>
                </c:pt>
                <c:pt idx="319">
                  <c:v>-3.017241379310346</c:v>
                </c:pt>
                <c:pt idx="320">
                  <c:v>1.07095046854085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265363912"/>
        <c:axId val="-1264926760"/>
      </c:scatterChart>
      <c:valAx>
        <c:axId val="-1265363912"/>
        <c:scaling>
          <c:orientation val="minMax"/>
          <c:max val="320.0"/>
          <c:min val="0.0"/>
        </c:scaling>
        <c:delete val="0"/>
        <c:axPos val="b"/>
        <c:majorTickMark val="out"/>
        <c:minorTickMark val="none"/>
        <c:tickLblPos val="nextTo"/>
        <c:spPr>
          <a:solidFill>
            <a:srgbClr val="FFFF00"/>
          </a:solidFill>
        </c:spPr>
        <c:txPr>
          <a:bodyPr/>
          <a:lstStyle/>
          <a:p>
            <a:pPr>
              <a:defRPr b="1" i="0">
                <a:solidFill>
                  <a:srgbClr val="0000FF"/>
                </a:solidFill>
                <a:latin typeface="Arial"/>
              </a:defRPr>
            </a:pPr>
            <a:endParaRPr lang="en-US"/>
          </a:p>
        </c:txPr>
        <c:crossAx val="-1264926760"/>
        <c:crosses val="autoZero"/>
        <c:crossBetween val="midCat"/>
      </c:valAx>
      <c:valAx>
        <c:axId val="-1264926760"/>
        <c:scaling>
          <c:orientation val="minMax"/>
          <c:max val="10.0"/>
          <c:min val="-1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0" i="0">
                <a:latin typeface="Arial"/>
              </a:defRPr>
            </a:pPr>
            <a:endParaRPr lang="en-US"/>
          </a:p>
        </c:txPr>
        <c:crossAx val="-126536391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47625">
              <a:noFill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0139845027886626"/>
                  <c:y val="0.310316031852634"/>
                </c:manualLayout>
              </c:layout>
              <c:numFmt formatCode="General" sourceLinked="0"/>
              <c:spPr>
                <a:solidFill>
                  <a:srgbClr val="FFFFFF"/>
                </a:solidFill>
                <a:ln>
                  <a:solidFill>
                    <a:srgbClr val="000000"/>
                  </a:solidFill>
                </a:ln>
              </c:spPr>
              <c:txPr>
                <a:bodyPr/>
                <a:lstStyle/>
                <a:p>
                  <a:pPr>
                    <a:defRPr b="1" i="0">
                      <a:latin typeface="Arial"/>
                    </a:defRPr>
                  </a:pPr>
                  <a:endParaRPr lang="en-US"/>
                </a:p>
              </c:txPr>
            </c:trendlineLbl>
          </c:trendline>
          <c:yVal>
            <c:numRef>
              <c:f>'[③健診Hbデータまとめ_香崎 2.xlsx]事故後線量多い順'!$H$695:$H$1252</c:f>
              <c:numCache>
                <c:formatCode>General</c:formatCode>
                <c:ptCount val="558"/>
                <c:pt idx="0">
                  <c:v>3.036649214659676</c:v>
                </c:pt>
                <c:pt idx="1">
                  <c:v>0.233644859813096</c:v>
                </c:pt>
                <c:pt idx="2">
                  <c:v>-1.041666666666686</c:v>
                </c:pt>
                <c:pt idx="3">
                  <c:v>-4.821280133000831</c:v>
                </c:pt>
                <c:pt idx="4">
                  <c:v>-0.715859030836999</c:v>
                </c:pt>
                <c:pt idx="5">
                  <c:v>-15.45893719806763</c:v>
                </c:pt>
                <c:pt idx="6">
                  <c:v>0.436681222707434</c:v>
                </c:pt>
                <c:pt idx="7">
                  <c:v>-10.1196410767697</c:v>
                </c:pt>
                <c:pt idx="8">
                  <c:v>-1.14795918367348</c:v>
                </c:pt>
                <c:pt idx="9">
                  <c:v>1.950354609929068</c:v>
                </c:pt>
                <c:pt idx="10">
                  <c:v>-2.174849267872556</c:v>
                </c:pt>
                <c:pt idx="11">
                  <c:v>2.152317880794697</c:v>
                </c:pt>
                <c:pt idx="12">
                  <c:v>3.838383838383836</c:v>
                </c:pt>
                <c:pt idx="13">
                  <c:v>-1.089449541284403</c:v>
                </c:pt>
                <c:pt idx="14">
                  <c:v>2.803203661327218</c:v>
                </c:pt>
                <c:pt idx="15">
                  <c:v>-1.842629482071693</c:v>
                </c:pt>
                <c:pt idx="16">
                  <c:v>1.888020833333328</c:v>
                </c:pt>
                <c:pt idx="17">
                  <c:v>#N/A</c:v>
                </c:pt>
                <c:pt idx="18">
                  <c:v>-2.97314578005115</c:v>
                </c:pt>
                <c:pt idx="19">
                  <c:v>1.155462184873962</c:v>
                </c:pt>
                <c:pt idx="20">
                  <c:v>-0.788643533123028</c:v>
                </c:pt>
                <c:pt idx="21">
                  <c:v>-2.607361963190188</c:v>
                </c:pt>
                <c:pt idx="22">
                  <c:v>4.328165374676978</c:v>
                </c:pt>
                <c:pt idx="23">
                  <c:v>-4.614325068870509</c:v>
                </c:pt>
                <c:pt idx="24">
                  <c:v>-0.665004156275981</c:v>
                </c:pt>
                <c:pt idx="25">
                  <c:v>-1.630434782608693</c:v>
                </c:pt>
                <c:pt idx="26">
                  <c:v>-0.868306801736608</c:v>
                </c:pt>
                <c:pt idx="27">
                  <c:v>0.772471910112368</c:v>
                </c:pt>
                <c:pt idx="28">
                  <c:v>-5.063291139240499</c:v>
                </c:pt>
                <c:pt idx="29">
                  <c:v>-7.635467980295572</c:v>
                </c:pt>
                <c:pt idx="30">
                  <c:v>-1.751592356687889</c:v>
                </c:pt>
                <c:pt idx="31">
                  <c:v>2.910602910602923</c:v>
                </c:pt>
                <c:pt idx="32">
                  <c:v>-1.697530864197533</c:v>
                </c:pt>
                <c:pt idx="33">
                  <c:v>-0.198938992042448</c:v>
                </c:pt>
                <c:pt idx="34">
                  <c:v>-3.199208443271774</c:v>
                </c:pt>
                <c:pt idx="35">
                  <c:v>5.540897097625328</c:v>
                </c:pt>
                <c:pt idx="36">
                  <c:v>-0.398406374502007</c:v>
                </c:pt>
                <c:pt idx="37">
                  <c:v>0.063131313131323</c:v>
                </c:pt>
                <c:pt idx="38">
                  <c:v>-0.823045267489709</c:v>
                </c:pt>
                <c:pt idx="39">
                  <c:v>4.27989130434781</c:v>
                </c:pt>
                <c:pt idx="40">
                  <c:v>3.84366925064601</c:v>
                </c:pt>
                <c:pt idx="41">
                  <c:v>-0.129701686121928</c:v>
                </c:pt>
                <c:pt idx="42">
                  <c:v>-4.666666666666674</c:v>
                </c:pt>
                <c:pt idx="43">
                  <c:v>-2.742230347349177</c:v>
                </c:pt>
                <c:pt idx="44">
                  <c:v>-3.21492805755396</c:v>
                </c:pt>
                <c:pt idx="45">
                  <c:v>0.0673854447439458</c:v>
                </c:pt>
                <c:pt idx="46">
                  <c:v>-8.06794055201699</c:v>
                </c:pt>
                <c:pt idx="47">
                  <c:v>-1.546157344247397</c:v>
                </c:pt>
                <c:pt idx="48">
                  <c:v>-0.383141762452097</c:v>
                </c:pt>
                <c:pt idx="49">
                  <c:v>1.791907514450876</c:v>
                </c:pt>
                <c:pt idx="50">
                  <c:v>-1.423487544483981</c:v>
                </c:pt>
                <c:pt idx="51">
                  <c:v>4.659090909090906</c:v>
                </c:pt>
                <c:pt idx="52">
                  <c:v>2.091633466135466</c:v>
                </c:pt>
                <c:pt idx="53">
                  <c:v>-6.250000000000014</c:v>
                </c:pt>
                <c:pt idx="54">
                  <c:v>-3.280542986425346</c:v>
                </c:pt>
                <c:pt idx="55">
                  <c:v>6.824324324324325</c:v>
                </c:pt>
                <c:pt idx="56">
                  <c:v>1.421188630490949</c:v>
                </c:pt>
                <c:pt idx="57">
                  <c:v>-1.215644820295982</c:v>
                </c:pt>
                <c:pt idx="58">
                  <c:v>4.509415262636264</c:v>
                </c:pt>
                <c:pt idx="59">
                  <c:v>1.076555023923443</c:v>
                </c:pt>
                <c:pt idx="60">
                  <c:v>-0.0508905852417274</c:v>
                </c:pt>
                <c:pt idx="61">
                  <c:v>1.615646258503382</c:v>
                </c:pt>
                <c:pt idx="62">
                  <c:v>-3.705636743215032</c:v>
                </c:pt>
                <c:pt idx="63">
                  <c:v>1.888020833333328</c:v>
                </c:pt>
                <c:pt idx="64">
                  <c:v>-1.182432432432437</c:v>
                </c:pt>
                <c:pt idx="65">
                  <c:v>1.388888888888895</c:v>
                </c:pt>
                <c:pt idx="66">
                  <c:v>#N/A</c:v>
                </c:pt>
                <c:pt idx="67">
                  <c:v>5.71923743500866</c:v>
                </c:pt>
                <c:pt idx="68">
                  <c:v>2.004716981132075</c:v>
                </c:pt>
                <c:pt idx="69">
                  <c:v>1.246105919003111</c:v>
                </c:pt>
                <c:pt idx="70">
                  <c:v>-0.334448160535134</c:v>
                </c:pt>
                <c:pt idx="71">
                  <c:v>2.719406674907296</c:v>
                </c:pt>
                <c:pt idx="72">
                  <c:v>-4.57516339869283</c:v>
                </c:pt>
                <c:pt idx="73">
                  <c:v>0.758575197889172</c:v>
                </c:pt>
                <c:pt idx="74">
                  <c:v>0.776053215077609</c:v>
                </c:pt>
                <c:pt idx="75">
                  <c:v>-4.45304937076477</c:v>
                </c:pt>
                <c:pt idx="76">
                  <c:v>3.548387096774198</c:v>
                </c:pt>
                <c:pt idx="77">
                  <c:v>-4.638009049773745</c:v>
                </c:pt>
                <c:pt idx="78">
                  <c:v>-1.621787025703798</c:v>
                </c:pt>
                <c:pt idx="79">
                  <c:v>0.237812128418548</c:v>
                </c:pt>
                <c:pt idx="80">
                  <c:v>-3.27253218884121</c:v>
                </c:pt>
                <c:pt idx="81">
                  <c:v>2.332457293035477</c:v>
                </c:pt>
                <c:pt idx="82">
                  <c:v>-1.065801668211309</c:v>
                </c:pt>
                <c:pt idx="83">
                  <c:v>-3.924221921515562</c:v>
                </c:pt>
                <c:pt idx="84">
                  <c:v>-0.816802800466748</c:v>
                </c:pt>
                <c:pt idx="85">
                  <c:v>-2.313769751693003</c:v>
                </c:pt>
                <c:pt idx="86">
                  <c:v>0.93023255813952</c:v>
                </c:pt>
                <c:pt idx="87">
                  <c:v>-1.462317210348695</c:v>
                </c:pt>
                <c:pt idx="88">
                  <c:v>-2.833572453371588</c:v>
                </c:pt>
                <c:pt idx="89">
                  <c:v>-0.502512562814089</c:v>
                </c:pt>
                <c:pt idx="90">
                  <c:v>-1.473684210526311</c:v>
                </c:pt>
                <c:pt idx="91">
                  <c:v>-4.357298474945542</c:v>
                </c:pt>
                <c:pt idx="92">
                  <c:v>1.178451178451183</c:v>
                </c:pt>
                <c:pt idx="93">
                  <c:v>0.812146892655369</c:v>
                </c:pt>
                <c:pt idx="94">
                  <c:v>-4.474272930648766</c:v>
                </c:pt>
                <c:pt idx="95">
                  <c:v>-0.375939849624052</c:v>
                </c:pt>
                <c:pt idx="96">
                  <c:v>2.577683615819198</c:v>
                </c:pt>
                <c:pt idx="97">
                  <c:v>0.605726872246697</c:v>
                </c:pt>
                <c:pt idx="98">
                  <c:v>-1.377688172043023</c:v>
                </c:pt>
                <c:pt idx="99">
                  <c:v>2.117486338797805</c:v>
                </c:pt>
                <c:pt idx="100">
                  <c:v>-1.00129198966409</c:v>
                </c:pt>
                <c:pt idx="101">
                  <c:v>-3.067484662576666</c:v>
                </c:pt>
                <c:pt idx="102">
                  <c:v>-4.242424242424238</c:v>
                </c:pt>
                <c:pt idx="103">
                  <c:v>-2.218700475435803</c:v>
                </c:pt>
                <c:pt idx="104">
                  <c:v>-0.341296928327638</c:v>
                </c:pt>
                <c:pt idx="105">
                  <c:v>1.398601398601381</c:v>
                </c:pt>
                <c:pt idx="106">
                  <c:v>-0.20703933747413</c:v>
                </c:pt>
                <c:pt idx="107">
                  <c:v>0.0604412209126848</c:v>
                </c:pt>
                <c:pt idx="108">
                  <c:v>0.0318979266347448</c:v>
                </c:pt>
                <c:pt idx="109">
                  <c:v>0.0589970501474893</c:v>
                </c:pt>
                <c:pt idx="110">
                  <c:v>1.374570446735388</c:v>
                </c:pt>
                <c:pt idx="111">
                  <c:v>-1.525658807212222</c:v>
                </c:pt>
                <c:pt idx="112">
                  <c:v>-2.10355987055017</c:v>
                </c:pt>
                <c:pt idx="113">
                  <c:v>0.55350553505535</c:v>
                </c:pt>
                <c:pt idx="114">
                  <c:v>-1.797603195739023</c:v>
                </c:pt>
                <c:pt idx="115">
                  <c:v>1.307189542483655</c:v>
                </c:pt>
                <c:pt idx="116">
                  <c:v>1.76678445229682</c:v>
                </c:pt>
                <c:pt idx="117">
                  <c:v>-0.323624595469272</c:v>
                </c:pt>
                <c:pt idx="118">
                  <c:v>-1.499999999999998</c:v>
                </c:pt>
                <c:pt idx="119">
                  <c:v>-2.796052631578937</c:v>
                </c:pt>
                <c:pt idx="120">
                  <c:v>1.601830663615543</c:v>
                </c:pt>
                <c:pt idx="121">
                  <c:v>0.977198697068406</c:v>
                </c:pt>
                <c:pt idx="122">
                  <c:v>-5.217045001991238</c:v>
                </c:pt>
                <c:pt idx="123">
                  <c:v>-2.725250278086762</c:v>
                </c:pt>
                <c:pt idx="124">
                  <c:v>-1.048951048951064</c:v>
                </c:pt>
                <c:pt idx="125">
                  <c:v>-2.343749999999996</c:v>
                </c:pt>
                <c:pt idx="126">
                  <c:v>1.306873184898343</c:v>
                </c:pt>
                <c:pt idx="127">
                  <c:v>-1.96850393700787</c:v>
                </c:pt>
                <c:pt idx="128">
                  <c:v>1.03806228373704</c:v>
                </c:pt>
                <c:pt idx="129">
                  <c:v>4.219653179190758</c:v>
                </c:pt>
                <c:pt idx="130">
                  <c:v>-1.238591916558003</c:v>
                </c:pt>
                <c:pt idx="131">
                  <c:v>1.048218029350101</c:v>
                </c:pt>
                <c:pt idx="132">
                  <c:v>0.698725852856555</c:v>
                </c:pt>
                <c:pt idx="133">
                  <c:v>-1.970284237726085</c:v>
                </c:pt>
                <c:pt idx="134">
                  <c:v>-8.197406942701808</c:v>
                </c:pt>
                <c:pt idx="135">
                  <c:v>0.202429149797567</c:v>
                </c:pt>
                <c:pt idx="136">
                  <c:v>-2.166666666666662</c:v>
                </c:pt>
                <c:pt idx="137">
                  <c:v>1.773049645390071</c:v>
                </c:pt>
                <c:pt idx="138">
                  <c:v>1.541554959785538</c:v>
                </c:pt>
                <c:pt idx="139">
                  <c:v>1.977750309023488</c:v>
                </c:pt>
                <c:pt idx="140">
                  <c:v>-3.67553865652725</c:v>
                </c:pt>
                <c:pt idx="141">
                  <c:v>1.585503963759904</c:v>
                </c:pt>
                <c:pt idx="142">
                  <c:v>0.554785020804451</c:v>
                </c:pt>
                <c:pt idx="143">
                  <c:v>-2.061855670103093</c:v>
                </c:pt>
                <c:pt idx="144">
                  <c:v>2.722513089005248</c:v>
                </c:pt>
                <c:pt idx="145">
                  <c:v>-2.486910994764403</c:v>
                </c:pt>
                <c:pt idx="146">
                  <c:v>-4.870129870129856</c:v>
                </c:pt>
                <c:pt idx="147">
                  <c:v>0.433369447453953</c:v>
                </c:pt>
                <c:pt idx="148">
                  <c:v>-2.467105263157906</c:v>
                </c:pt>
                <c:pt idx="149">
                  <c:v>4.217603911980448</c:v>
                </c:pt>
                <c:pt idx="150">
                  <c:v>-2.310231023102308</c:v>
                </c:pt>
                <c:pt idx="151">
                  <c:v>1.20408163265308</c:v>
                </c:pt>
                <c:pt idx="152">
                  <c:v>-5.10825439783493</c:v>
                </c:pt>
                <c:pt idx="153">
                  <c:v>-0.19762845849802</c:v>
                </c:pt>
                <c:pt idx="154">
                  <c:v>-2.371916508538926</c:v>
                </c:pt>
                <c:pt idx="155">
                  <c:v>-3.271983640081809</c:v>
                </c:pt>
                <c:pt idx="156">
                  <c:v>3.057553956834524</c:v>
                </c:pt>
                <c:pt idx="157">
                  <c:v>2.62295081967211</c:v>
                </c:pt>
                <c:pt idx="158">
                  <c:v>1.231386025200443</c:v>
                </c:pt>
                <c:pt idx="159">
                  <c:v>-1.664476565922047</c:v>
                </c:pt>
                <c:pt idx="160">
                  <c:v>2.258663366336624</c:v>
                </c:pt>
                <c:pt idx="161">
                  <c:v>-3.169014084507037</c:v>
                </c:pt>
                <c:pt idx="162">
                  <c:v>0.410677618069814</c:v>
                </c:pt>
                <c:pt idx="163">
                  <c:v>1.393188854489173</c:v>
                </c:pt>
                <c:pt idx="164">
                  <c:v>-0.577858880778575</c:v>
                </c:pt>
                <c:pt idx="165">
                  <c:v>-2.880184331797231</c:v>
                </c:pt>
                <c:pt idx="166">
                  <c:v>3.16742081447964</c:v>
                </c:pt>
                <c:pt idx="167">
                  <c:v>-1.315789473684206</c:v>
                </c:pt>
                <c:pt idx="168">
                  <c:v>-1.817640047675803</c:v>
                </c:pt>
                <c:pt idx="169">
                  <c:v>3.103448275862064</c:v>
                </c:pt>
                <c:pt idx="170">
                  <c:v>1.857585139318868</c:v>
                </c:pt>
                <c:pt idx="171">
                  <c:v>-0.37076271186442</c:v>
                </c:pt>
                <c:pt idx="172">
                  <c:v>2.588105726872276</c:v>
                </c:pt>
                <c:pt idx="173">
                  <c:v>-2.845036319612584</c:v>
                </c:pt>
                <c:pt idx="174">
                  <c:v>-0.219298245614025</c:v>
                </c:pt>
                <c:pt idx="175">
                  <c:v>0.844748858447494</c:v>
                </c:pt>
                <c:pt idx="176">
                  <c:v>-1.608910891089108</c:v>
                </c:pt>
                <c:pt idx="177">
                  <c:v>1.36248415716097</c:v>
                </c:pt>
                <c:pt idx="178">
                  <c:v>1.927710843373474</c:v>
                </c:pt>
                <c:pt idx="179">
                  <c:v>-1.145912910618793</c:v>
                </c:pt>
                <c:pt idx="180">
                  <c:v>-5.552359033371683</c:v>
                </c:pt>
                <c:pt idx="181">
                  <c:v>0.0442673749446845</c:v>
                </c:pt>
                <c:pt idx="182">
                  <c:v>-0.0331564986737217</c:v>
                </c:pt>
                <c:pt idx="183">
                  <c:v>7.692307692307694</c:v>
                </c:pt>
                <c:pt idx="184">
                  <c:v>0.217864923747276</c:v>
                </c:pt>
                <c:pt idx="185">
                  <c:v>-0.337837837837843</c:v>
                </c:pt>
                <c:pt idx="186">
                  <c:v>-1.35046113306983</c:v>
                </c:pt>
                <c:pt idx="187">
                  <c:v>-1.785714285714272</c:v>
                </c:pt>
                <c:pt idx="188">
                  <c:v>-0.627943485086329</c:v>
                </c:pt>
                <c:pt idx="189">
                  <c:v>1.016586409844848</c:v>
                </c:pt>
                <c:pt idx="190">
                  <c:v>1.697699890470983</c:v>
                </c:pt>
                <c:pt idx="191">
                  <c:v>3.68589743589742</c:v>
                </c:pt>
                <c:pt idx="192">
                  <c:v>-2.560763888888885</c:v>
                </c:pt>
                <c:pt idx="193">
                  <c:v>0.911458333333337</c:v>
                </c:pt>
                <c:pt idx="194">
                  <c:v>-0.264200792602384</c:v>
                </c:pt>
                <c:pt idx="195">
                  <c:v>-1.439645625692115</c:v>
                </c:pt>
                <c:pt idx="196">
                  <c:v>1.827485380116968</c:v>
                </c:pt>
                <c:pt idx="197">
                  <c:v>5.680317040951118</c:v>
                </c:pt>
                <c:pt idx="198">
                  <c:v>-5.56826849733028</c:v>
                </c:pt>
                <c:pt idx="199">
                  <c:v>0.857687420584497</c:v>
                </c:pt>
                <c:pt idx="200">
                  <c:v>-1.923076923076928</c:v>
                </c:pt>
                <c:pt idx="201">
                  <c:v>-2.585315408479852</c:v>
                </c:pt>
                <c:pt idx="202">
                  <c:v>0.4872107186358</c:v>
                </c:pt>
                <c:pt idx="203">
                  <c:v>0.0</c:v>
                </c:pt>
                <c:pt idx="204">
                  <c:v>3.95189003436424</c:v>
                </c:pt>
                <c:pt idx="205">
                  <c:v>2.92887029288703</c:v>
                </c:pt>
                <c:pt idx="206">
                  <c:v>1.495016611295691</c:v>
                </c:pt>
                <c:pt idx="207">
                  <c:v>-3.040540540540547</c:v>
                </c:pt>
                <c:pt idx="208">
                  <c:v>-0.318696883852691</c:v>
                </c:pt>
                <c:pt idx="209">
                  <c:v>-1.789473684210536</c:v>
                </c:pt>
                <c:pt idx="210">
                  <c:v>-1.59629248197734</c:v>
                </c:pt>
                <c:pt idx="211">
                  <c:v>-0.385154061624648</c:v>
                </c:pt>
                <c:pt idx="212">
                  <c:v>0.659547738693492</c:v>
                </c:pt>
                <c:pt idx="213">
                  <c:v>-4.308323563892142</c:v>
                </c:pt>
                <c:pt idx="214">
                  <c:v>-1.387755102040818</c:v>
                </c:pt>
                <c:pt idx="215">
                  <c:v>1.251042535446205</c:v>
                </c:pt>
                <c:pt idx="216">
                  <c:v>1.56720916214588</c:v>
                </c:pt>
                <c:pt idx="217">
                  <c:v>0.755667506297224</c:v>
                </c:pt>
                <c:pt idx="218">
                  <c:v>-0.238663484486871</c:v>
                </c:pt>
                <c:pt idx="219">
                  <c:v>3.713188220230497</c:v>
                </c:pt>
                <c:pt idx="220">
                  <c:v>-7.15065502183405</c:v>
                </c:pt>
                <c:pt idx="221">
                  <c:v>1.680672268907575</c:v>
                </c:pt>
                <c:pt idx="222">
                  <c:v>1.608187134502937</c:v>
                </c:pt>
                <c:pt idx="223">
                  <c:v>1.639344262295082</c:v>
                </c:pt>
                <c:pt idx="224">
                  <c:v>-2.551020408163277</c:v>
                </c:pt>
                <c:pt idx="225">
                  <c:v>-1.823949246629679</c:v>
                </c:pt>
                <c:pt idx="226">
                  <c:v>-1.804670912951173</c:v>
                </c:pt>
                <c:pt idx="227">
                  <c:v>2.302631578947366</c:v>
                </c:pt>
                <c:pt idx="228">
                  <c:v>0.237449118046134</c:v>
                </c:pt>
                <c:pt idx="229">
                  <c:v>-0.806451612903226</c:v>
                </c:pt>
                <c:pt idx="230">
                  <c:v>-0.267737617135226</c:v>
                </c:pt>
                <c:pt idx="231">
                  <c:v>3.092182030338376</c:v>
                </c:pt>
                <c:pt idx="232">
                  <c:v>-7.78341793570221</c:v>
                </c:pt>
                <c:pt idx="233">
                  <c:v>-1.691542288557202</c:v>
                </c:pt>
                <c:pt idx="234">
                  <c:v>6.344586728754336</c:v>
                </c:pt>
                <c:pt idx="235">
                  <c:v>0.947459086993954</c:v>
                </c:pt>
                <c:pt idx="236">
                  <c:v>2.629781420765026</c:v>
                </c:pt>
                <c:pt idx="237">
                  <c:v>4.783092324805352</c:v>
                </c:pt>
                <c:pt idx="238">
                  <c:v>-2.368185880250248</c:v>
                </c:pt>
                <c:pt idx="239">
                  <c:v>-0.856531049250555</c:v>
                </c:pt>
                <c:pt idx="240">
                  <c:v>2.323008849557532</c:v>
                </c:pt>
                <c:pt idx="241">
                  <c:v>-0.970873786407758</c:v>
                </c:pt>
                <c:pt idx="242">
                  <c:v>-0.418275418275404</c:v>
                </c:pt>
                <c:pt idx="243">
                  <c:v>2.192982456140355</c:v>
                </c:pt>
                <c:pt idx="244">
                  <c:v>-5.428329092451241</c:v>
                </c:pt>
                <c:pt idx="245">
                  <c:v>-0.60370849504098</c:v>
                </c:pt>
                <c:pt idx="246">
                  <c:v>-0.0307125307125464</c:v>
                </c:pt>
                <c:pt idx="247">
                  <c:v>1.125854443104124</c:v>
                </c:pt>
                <c:pt idx="248">
                  <c:v>3.620689655172403</c:v>
                </c:pt>
                <c:pt idx="249">
                  <c:v>-3.164116828929068</c:v>
                </c:pt>
                <c:pt idx="250">
                  <c:v>-0.230870712401056</c:v>
                </c:pt>
                <c:pt idx="251">
                  <c:v>3.157894736842112</c:v>
                </c:pt>
                <c:pt idx="252">
                  <c:v>3.282275711159737</c:v>
                </c:pt>
                <c:pt idx="253">
                  <c:v>1.126126126126134</c:v>
                </c:pt>
                <c:pt idx="254">
                  <c:v>-4.301675977653637</c:v>
                </c:pt>
                <c:pt idx="255">
                  <c:v>-0.0534759358288854</c:v>
                </c:pt>
                <c:pt idx="256">
                  <c:v>-0.337837837837836</c:v>
                </c:pt>
                <c:pt idx="257">
                  <c:v>-2.49360613810742</c:v>
                </c:pt>
                <c:pt idx="258">
                  <c:v>-1.487736228387634</c:v>
                </c:pt>
                <c:pt idx="259">
                  <c:v>0.470588235294128</c:v>
                </c:pt>
                <c:pt idx="260">
                  <c:v>0.734976221357556</c:v>
                </c:pt>
                <c:pt idx="261">
                  <c:v>0.539811066126856</c:v>
                </c:pt>
                <c:pt idx="262">
                  <c:v>3.773584905660375</c:v>
                </c:pt>
                <c:pt idx="263">
                  <c:v>-3.18471337579619</c:v>
                </c:pt>
                <c:pt idx="264">
                  <c:v>-3.289473684210526</c:v>
                </c:pt>
                <c:pt idx="265">
                  <c:v>-3.983228511530407</c:v>
                </c:pt>
                <c:pt idx="266">
                  <c:v>0.448247758761211</c:v>
                </c:pt>
                <c:pt idx="267">
                  <c:v>2.383531960996741</c:v>
                </c:pt>
                <c:pt idx="268">
                  <c:v>-0.222222222222221</c:v>
                </c:pt>
                <c:pt idx="269">
                  <c:v>0.30487804878047</c:v>
                </c:pt>
                <c:pt idx="270">
                  <c:v>0.310773480662983</c:v>
                </c:pt>
                <c:pt idx="271">
                  <c:v>1.310483870967744</c:v>
                </c:pt>
                <c:pt idx="272">
                  <c:v>-2.646014843497881</c:v>
                </c:pt>
                <c:pt idx="273">
                  <c:v>-0.928074245939672</c:v>
                </c:pt>
                <c:pt idx="274">
                  <c:v>2.773988176443835</c:v>
                </c:pt>
                <c:pt idx="275">
                  <c:v>3.554868624420418</c:v>
                </c:pt>
                <c:pt idx="276">
                  <c:v>-4.723127035830616</c:v>
                </c:pt>
                <c:pt idx="277">
                  <c:v>-2.057613168724273</c:v>
                </c:pt>
                <c:pt idx="278">
                  <c:v>-1.53010858835143</c:v>
                </c:pt>
                <c:pt idx="279">
                  <c:v>-4.019873532068656</c:v>
                </c:pt>
                <c:pt idx="280">
                  <c:v>-0.556173526140148</c:v>
                </c:pt>
                <c:pt idx="281">
                  <c:v>-3.728070175438583</c:v>
                </c:pt>
                <c:pt idx="282">
                  <c:v>-0.992331980153347</c:v>
                </c:pt>
                <c:pt idx="283">
                  <c:v>1.37931034482757</c:v>
                </c:pt>
                <c:pt idx="284">
                  <c:v>-3.101604278074872</c:v>
                </c:pt>
                <c:pt idx="285">
                  <c:v>-1.028277634961441</c:v>
                </c:pt>
                <c:pt idx="286">
                  <c:v>1.71460176991149</c:v>
                </c:pt>
                <c:pt idx="287">
                  <c:v>0.838926174496644</c:v>
                </c:pt>
                <c:pt idx="288">
                  <c:v>-1.727509778357228</c:v>
                </c:pt>
                <c:pt idx="289">
                  <c:v>-2.593360995850618</c:v>
                </c:pt>
                <c:pt idx="290">
                  <c:v>2.223816355810608</c:v>
                </c:pt>
                <c:pt idx="291">
                  <c:v>2.743902439024408</c:v>
                </c:pt>
                <c:pt idx="292">
                  <c:v>-22.01986754966886</c:v>
                </c:pt>
                <c:pt idx="293">
                  <c:v>5.47024952015353</c:v>
                </c:pt>
                <c:pt idx="294">
                  <c:v>-9.11141181777176</c:v>
                </c:pt>
                <c:pt idx="295">
                  <c:v>5.664488017429183</c:v>
                </c:pt>
                <c:pt idx="296">
                  <c:v>4.2240587695133</c:v>
                </c:pt>
                <c:pt idx="297">
                  <c:v>-2.16010165184244</c:v>
                </c:pt>
                <c:pt idx="298">
                  <c:v>8.86917960088692</c:v>
                </c:pt>
                <c:pt idx="299">
                  <c:v>2.596849723286502</c:v>
                </c:pt>
                <c:pt idx="300">
                  <c:v>-2.350427350427342</c:v>
                </c:pt>
                <c:pt idx="301">
                  <c:v>3.878583473861727</c:v>
                </c:pt>
                <c:pt idx="302">
                  <c:v>1.140065146579798</c:v>
                </c:pt>
                <c:pt idx="303">
                  <c:v>2.728127939793029</c:v>
                </c:pt>
                <c:pt idx="304">
                  <c:v>0.971694127587647</c:v>
                </c:pt>
                <c:pt idx="305">
                  <c:v>1.415094339622632</c:v>
                </c:pt>
                <c:pt idx="306">
                  <c:v>-0.554844216816066</c:v>
                </c:pt>
                <c:pt idx="307">
                  <c:v>1.19811724433032</c:v>
                </c:pt>
                <c:pt idx="308">
                  <c:v>3.227232537577362</c:v>
                </c:pt>
                <c:pt idx="309">
                  <c:v>3.253182461103259</c:v>
                </c:pt>
                <c:pt idx="310">
                  <c:v>-3.411426222770239</c:v>
                </c:pt>
                <c:pt idx="311">
                  <c:v>-0.635593220338984</c:v>
                </c:pt>
                <c:pt idx="312">
                  <c:v>-1.399491094147575</c:v>
                </c:pt>
                <c:pt idx="313">
                  <c:v>-0.0589970501474924</c:v>
                </c:pt>
                <c:pt idx="314">
                  <c:v>-2.013422818791951</c:v>
                </c:pt>
                <c:pt idx="315">
                  <c:v>-0.709219858156031</c:v>
                </c:pt>
                <c:pt idx="316">
                  <c:v>3.164556962025316</c:v>
                </c:pt>
                <c:pt idx="317">
                  <c:v>-0.259067357512959</c:v>
                </c:pt>
                <c:pt idx="318">
                  <c:v>-3.012048192771096</c:v>
                </c:pt>
                <c:pt idx="319">
                  <c:v>-2.759526938239182</c:v>
                </c:pt>
                <c:pt idx="320">
                  <c:v>1.508916323731118</c:v>
                </c:pt>
                <c:pt idx="321">
                  <c:v>-2.34877734877735</c:v>
                </c:pt>
                <c:pt idx="322">
                  <c:v>0.164473684210552</c:v>
                </c:pt>
                <c:pt idx="323">
                  <c:v>-5.424528301886784</c:v>
                </c:pt>
                <c:pt idx="324">
                  <c:v>4.535017221584384</c:v>
                </c:pt>
                <c:pt idx="325">
                  <c:v>-1.048218029350112</c:v>
                </c:pt>
                <c:pt idx="326">
                  <c:v>1.877934272300475</c:v>
                </c:pt>
                <c:pt idx="327">
                  <c:v>-3.06834030683404</c:v>
                </c:pt>
                <c:pt idx="328">
                  <c:v>-1.572926596758806</c:v>
                </c:pt>
                <c:pt idx="329">
                  <c:v>0.632911392405052</c:v>
                </c:pt>
                <c:pt idx="330">
                  <c:v>-0.641025641025639</c:v>
                </c:pt>
                <c:pt idx="331">
                  <c:v>-1.85950413223142</c:v>
                </c:pt>
                <c:pt idx="332">
                  <c:v>3.125</c:v>
                </c:pt>
                <c:pt idx="333">
                  <c:v>2.92792792792793</c:v>
                </c:pt>
                <c:pt idx="334">
                  <c:v>2.67670430782099</c:v>
                </c:pt>
                <c:pt idx="335">
                  <c:v>5.01981505944519</c:v>
                </c:pt>
                <c:pt idx="336">
                  <c:v>3.737259343148363</c:v>
                </c:pt>
                <c:pt idx="337">
                  <c:v>1.580660158066028</c:v>
                </c:pt>
                <c:pt idx="338">
                  <c:v>-1.947764497565291</c:v>
                </c:pt>
                <c:pt idx="339">
                  <c:v>-1.763224181360208</c:v>
                </c:pt>
                <c:pt idx="340">
                  <c:v>-1.484480431848845</c:v>
                </c:pt>
                <c:pt idx="341">
                  <c:v>2.572898799313872</c:v>
                </c:pt>
                <c:pt idx="342">
                  <c:v>-0.608194622279122</c:v>
                </c:pt>
                <c:pt idx="343">
                  <c:v>2.74869109947644</c:v>
                </c:pt>
                <c:pt idx="344">
                  <c:v>-4.458598726114656</c:v>
                </c:pt>
                <c:pt idx="345">
                  <c:v>-2.533783783783796</c:v>
                </c:pt>
                <c:pt idx="346">
                  <c:v>1.83923705722073</c:v>
                </c:pt>
                <c:pt idx="347">
                  <c:v>-1.774193548387111</c:v>
                </c:pt>
                <c:pt idx="348">
                  <c:v>0.694444444444442</c:v>
                </c:pt>
                <c:pt idx="349">
                  <c:v>-4.393939393939392</c:v>
                </c:pt>
                <c:pt idx="350">
                  <c:v>-1.108269394714405</c:v>
                </c:pt>
                <c:pt idx="351">
                  <c:v>-4.008438818565397</c:v>
                </c:pt>
                <c:pt idx="352">
                  <c:v>3.027139874739023</c:v>
                </c:pt>
                <c:pt idx="353">
                  <c:v>-1.937046004842617</c:v>
                </c:pt>
                <c:pt idx="354">
                  <c:v>1.839965768078724</c:v>
                </c:pt>
                <c:pt idx="355">
                  <c:v>1.638477801268496</c:v>
                </c:pt>
                <c:pt idx="356">
                  <c:v>-11.1111111111111</c:v>
                </c:pt>
                <c:pt idx="357">
                  <c:v>2.396514161220035</c:v>
                </c:pt>
                <c:pt idx="358">
                  <c:v>-0.52173913043479</c:v>
                </c:pt>
                <c:pt idx="359">
                  <c:v>-0.916561314791401</c:v>
                </c:pt>
                <c:pt idx="360">
                  <c:v>-9.0686274509804</c:v>
                </c:pt>
                <c:pt idx="361">
                  <c:v>-3.947368421052629</c:v>
                </c:pt>
                <c:pt idx="362">
                  <c:v>-3.592814371257494</c:v>
                </c:pt>
                <c:pt idx="363">
                  <c:v>3.133159268929518</c:v>
                </c:pt>
                <c:pt idx="364">
                  <c:v>-0.663716814159266</c:v>
                </c:pt>
                <c:pt idx="365">
                  <c:v>-1.81058495821727</c:v>
                </c:pt>
                <c:pt idx="366">
                  <c:v>-0.357142857142862</c:v>
                </c:pt>
                <c:pt idx="367">
                  <c:v>#N/A</c:v>
                </c:pt>
                <c:pt idx="368">
                  <c:v>0.942782834850464</c:v>
                </c:pt>
                <c:pt idx="369">
                  <c:v>0.0647668393782484</c:v>
                </c:pt>
                <c:pt idx="370">
                  <c:v>-1.53061224489797</c:v>
                </c:pt>
                <c:pt idx="371">
                  <c:v>-0.0526315789473654</c:v>
                </c:pt>
                <c:pt idx="372">
                  <c:v>-3.029247910863513</c:v>
                </c:pt>
                <c:pt idx="373">
                  <c:v>4.19580419580418</c:v>
                </c:pt>
                <c:pt idx="374">
                  <c:v>3.52348993288591</c:v>
                </c:pt>
                <c:pt idx="375">
                  <c:v>2.915578764142713</c:v>
                </c:pt>
                <c:pt idx="376">
                  <c:v>5.121776504298007</c:v>
                </c:pt>
                <c:pt idx="377">
                  <c:v>-1.271753681392244</c:v>
                </c:pt>
                <c:pt idx="378">
                  <c:v>-0.172711571675292</c:v>
                </c:pt>
                <c:pt idx="379">
                  <c:v>0.760043431053206</c:v>
                </c:pt>
                <c:pt idx="380">
                  <c:v>-0.0350140056022588</c:v>
                </c:pt>
                <c:pt idx="381">
                  <c:v>-2.364066193853432</c:v>
                </c:pt>
                <c:pt idx="382">
                  <c:v>0.117813383600385</c:v>
                </c:pt>
                <c:pt idx="383">
                  <c:v>1.971748087110049</c:v>
                </c:pt>
                <c:pt idx="384">
                  <c:v>-2.821670428893913</c:v>
                </c:pt>
                <c:pt idx="385">
                  <c:v>-0.579374275782147</c:v>
                </c:pt>
                <c:pt idx="386">
                  <c:v>-7.739938080495345</c:v>
                </c:pt>
                <c:pt idx="387">
                  <c:v>2.430555555555553</c:v>
                </c:pt>
                <c:pt idx="388">
                  <c:v>1.576943991299622</c:v>
                </c:pt>
                <c:pt idx="389">
                  <c:v>7.142857142857117</c:v>
                </c:pt>
                <c:pt idx="390">
                  <c:v>-3.144654088050325</c:v>
                </c:pt>
                <c:pt idx="391">
                  <c:v>0.0</c:v>
                </c:pt>
                <c:pt idx="392">
                  <c:v>-5.37974683544303</c:v>
                </c:pt>
                <c:pt idx="393">
                  <c:v>-0.635593220338972</c:v>
                </c:pt>
                <c:pt idx="394">
                  <c:v>2.499999999999991</c:v>
                </c:pt>
                <c:pt idx="395">
                  <c:v>-0.588865096359744</c:v>
                </c:pt>
                <c:pt idx="396">
                  <c:v>1.748021108179411</c:v>
                </c:pt>
                <c:pt idx="397">
                  <c:v>-2.359108781127114</c:v>
                </c:pt>
                <c:pt idx="398">
                  <c:v>1.766004415011043</c:v>
                </c:pt>
                <c:pt idx="399">
                  <c:v>0.0344352617080066</c:v>
                </c:pt>
                <c:pt idx="400">
                  <c:v>0.0</c:v>
                </c:pt>
                <c:pt idx="401">
                  <c:v>-0.320073159579346</c:v>
                </c:pt>
                <c:pt idx="402">
                  <c:v>-0.338218714768877</c:v>
                </c:pt>
                <c:pt idx="403">
                  <c:v>-0.418848167539277</c:v>
                </c:pt>
                <c:pt idx="404">
                  <c:v>1.17145899893505</c:v>
                </c:pt>
                <c:pt idx="405">
                  <c:v>1.98366394399069</c:v>
                </c:pt>
                <c:pt idx="406">
                  <c:v>4.9019607843137</c:v>
                </c:pt>
                <c:pt idx="407">
                  <c:v>4.166666666666663</c:v>
                </c:pt>
                <c:pt idx="408">
                  <c:v>-1.014109347442675</c:v>
                </c:pt>
                <c:pt idx="409">
                  <c:v>0.398936170212757</c:v>
                </c:pt>
                <c:pt idx="410">
                  <c:v>1.48042024832856</c:v>
                </c:pt>
                <c:pt idx="411">
                  <c:v>-0.930851063829791</c:v>
                </c:pt>
                <c:pt idx="412">
                  <c:v>0.4287598944591</c:v>
                </c:pt>
                <c:pt idx="413">
                  <c:v>-0.704225352112676</c:v>
                </c:pt>
                <c:pt idx="414">
                  <c:v>-1.152073732718902</c:v>
                </c:pt>
                <c:pt idx="415">
                  <c:v>1.388888888888884</c:v>
                </c:pt>
                <c:pt idx="416">
                  <c:v>0.392512077294715</c:v>
                </c:pt>
                <c:pt idx="417">
                  <c:v>-1.666666666666658</c:v>
                </c:pt>
                <c:pt idx="418">
                  <c:v>-1.620111731843602</c:v>
                </c:pt>
                <c:pt idx="419">
                  <c:v>-2.819956616052063</c:v>
                </c:pt>
                <c:pt idx="420">
                  <c:v>-1.434426229508202</c:v>
                </c:pt>
                <c:pt idx="421">
                  <c:v>-0.838926174496644</c:v>
                </c:pt>
                <c:pt idx="422">
                  <c:v>-1.102362204724425</c:v>
                </c:pt>
                <c:pt idx="423">
                  <c:v>5.833333333333332</c:v>
                </c:pt>
                <c:pt idx="424">
                  <c:v>0.580046403712301</c:v>
                </c:pt>
                <c:pt idx="425">
                  <c:v>3.080568720379136</c:v>
                </c:pt>
                <c:pt idx="426">
                  <c:v>5.93220338983051</c:v>
                </c:pt>
                <c:pt idx="427">
                  <c:v>-1.31578947368422</c:v>
                </c:pt>
                <c:pt idx="428">
                  <c:v>-3.636363636363633</c:v>
                </c:pt>
                <c:pt idx="429">
                  <c:v>0.535640708693857</c:v>
                </c:pt>
                <c:pt idx="430">
                  <c:v>1.542416452442184</c:v>
                </c:pt>
                <c:pt idx="431">
                  <c:v>0.804828973843077</c:v>
                </c:pt>
                <c:pt idx="432">
                  <c:v>-0.137741046831953</c:v>
                </c:pt>
                <c:pt idx="433">
                  <c:v>-2.09087253719339</c:v>
                </c:pt>
                <c:pt idx="434">
                  <c:v>0.170068027210887</c:v>
                </c:pt>
                <c:pt idx="435">
                  <c:v>2.514285714285704</c:v>
                </c:pt>
                <c:pt idx="436">
                  <c:v>1.19453924914675</c:v>
                </c:pt>
                <c:pt idx="437">
                  <c:v>-0.221729490022172</c:v>
                </c:pt>
                <c:pt idx="438">
                  <c:v>0.357142857142862</c:v>
                </c:pt>
                <c:pt idx="439">
                  <c:v>-4.50047125353441</c:v>
                </c:pt>
                <c:pt idx="440">
                  <c:v>1.0498687664042</c:v>
                </c:pt>
                <c:pt idx="441">
                  <c:v>-0.241545893719788</c:v>
                </c:pt>
                <c:pt idx="442">
                  <c:v>-1.208740120874015</c:v>
                </c:pt>
                <c:pt idx="443">
                  <c:v>2.49554367201427</c:v>
                </c:pt>
                <c:pt idx="444">
                  <c:v>-1.89003436426116</c:v>
                </c:pt>
                <c:pt idx="445">
                  <c:v>2.689873417721523</c:v>
                </c:pt>
                <c:pt idx="446">
                  <c:v>-1.044727391446303</c:v>
                </c:pt>
                <c:pt idx="447">
                  <c:v>0.217864923747288</c:v>
                </c:pt>
                <c:pt idx="448">
                  <c:v>-0.0314861460957228</c:v>
                </c:pt>
                <c:pt idx="449">
                  <c:v>1.49006622516556</c:v>
                </c:pt>
                <c:pt idx="450">
                  <c:v>2.819807427785407</c:v>
                </c:pt>
                <c:pt idx="451">
                  <c:v>-2.979414951245941</c:v>
                </c:pt>
                <c:pt idx="452">
                  <c:v>1.893095768374164</c:v>
                </c:pt>
                <c:pt idx="453">
                  <c:v>1.346801346801354</c:v>
                </c:pt>
                <c:pt idx="454">
                  <c:v>-1.08142493638679</c:v>
                </c:pt>
                <c:pt idx="455">
                  <c:v>8.75912408759125</c:v>
                </c:pt>
                <c:pt idx="456">
                  <c:v>-1.844532279314907</c:v>
                </c:pt>
                <c:pt idx="457">
                  <c:v>0.970245795601557</c:v>
                </c:pt>
                <c:pt idx="458">
                  <c:v>#N/A</c:v>
                </c:pt>
                <c:pt idx="459">
                  <c:v>1.57618213660245</c:v>
                </c:pt>
                <c:pt idx="460">
                  <c:v>2.52263906856404</c:v>
                </c:pt>
                <c:pt idx="461">
                  <c:v>-1.837524177949715</c:v>
                </c:pt>
                <c:pt idx="462">
                  <c:v>2.571251548946707</c:v>
                </c:pt>
                <c:pt idx="463">
                  <c:v>-1.354279523293612</c:v>
                </c:pt>
                <c:pt idx="464">
                  <c:v>2.140077821011686</c:v>
                </c:pt>
                <c:pt idx="465">
                  <c:v>-1.454363089267785</c:v>
                </c:pt>
                <c:pt idx="466">
                  <c:v>0.467289719626142</c:v>
                </c:pt>
                <c:pt idx="467">
                  <c:v>3.889990089197232</c:v>
                </c:pt>
                <c:pt idx="468">
                  <c:v>-2.628571428571437</c:v>
                </c:pt>
                <c:pt idx="469">
                  <c:v>0.770478507704798</c:v>
                </c:pt>
                <c:pt idx="470">
                  <c:v>1.826792963464138</c:v>
                </c:pt>
                <c:pt idx="471">
                  <c:v>-2.614379084967322</c:v>
                </c:pt>
                <c:pt idx="472">
                  <c:v>-4.093264248704662</c:v>
                </c:pt>
                <c:pt idx="473">
                  <c:v>-0.122549019607841</c:v>
                </c:pt>
                <c:pt idx="474">
                  <c:v>1.429848078641654</c:v>
                </c:pt>
                <c:pt idx="475">
                  <c:v>1.204819277108429</c:v>
                </c:pt>
                <c:pt idx="476">
                  <c:v>2.902621722846455</c:v>
                </c:pt>
                <c:pt idx="477">
                  <c:v>0.229885057471264</c:v>
                </c:pt>
                <c:pt idx="478">
                  <c:v>1.47427854454203</c:v>
                </c:pt>
                <c:pt idx="479">
                  <c:v>5.56300268096516</c:v>
                </c:pt>
                <c:pt idx="480">
                  <c:v>0.64516129032259</c:v>
                </c:pt>
                <c:pt idx="481">
                  <c:v>7.746478873239432</c:v>
                </c:pt>
                <c:pt idx="482">
                  <c:v>-1.006711409395964</c:v>
                </c:pt>
                <c:pt idx="483">
                  <c:v>-0.128040973111393</c:v>
                </c:pt>
                <c:pt idx="484">
                  <c:v>1.325556733828211</c:v>
                </c:pt>
                <c:pt idx="485">
                  <c:v>-1.185770750988129</c:v>
                </c:pt>
                <c:pt idx="486">
                  <c:v>-0.537634408602171</c:v>
                </c:pt>
                <c:pt idx="487">
                  <c:v>3.703703703703668</c:v>
                </c:pt>
                <c:pt idx="488">
                  <c:v>4.219543147208105</c:v>
                </c:pt>
                <c:pt idx="489">
                  <c:v>-3.823529411764702</c:v>
                </c:pt>
                <c:pt idx="490">
                  <c:v>-1.021711366538954</c:v>
                </c:pt>
                <c:pt idx="491">
                  <c:v>-3.868360277136272</c:v>
                </c:pt>
                <c:pt idx="492">
                  <c:v>-1.121076233183852</c:v>
                </c:pt>
                <c:pt idx="493">
                  <c:v>2.461858529819696</c:v>
                </c:pt>
                <c:pt idx="494">
                  <c:v>1.436464088397779</c:v>
                </c:pt>
                <c:pt idx="495">
                  <c:v>-4.328523862375126</c:v>
                </c:pt>
                <c:pt idx="496">
                  <c:v>-1.583710407239813</c:v>
                </c:pt>
                <c:pt idx="497">
                  <c:v>0.718194254445955</c:v>
                </c:pt>
                <c:pt idx="498">
                  <c:v>0.882470918572033</c:v>
                </c:pt>
                <c:pt idx="499">
                  <c:v>-2.2633744855967</c:v>
                </c:pt>
                <c:pt idx="500">
                  <c:v>-0.333333333333338</c:v>
                </c:pt>
                <c:pt idx="501">
                  <c:v>1.198186528497401</c:v>
                </c:pt>
                <c:pt idx="502">
                  <c:v>-1.432469304229189</c:v>
                </c:pt>
                <c:pt idx="503">
                  <c:v>0.308641975308629</c:v>
                </c:pt>
                <c:pt idx="504">
                  <c:v>-0.216450216450239</c:v>
                </c:pt>
                <c:pt idx="505">
                  <c:v>-1.740020470829057</c:v>
                </c:pt>
                <c:pt idx="506">
                  <c:v>2.047146401985124</c:v>
                </c:pt>
                <c:pt idx="507">
                  <c:v>0.874769797421711</c:v>
                </c:pt>
                <c:pt idx="508">
                  <c:v>-0.590551181102361</c:v>
                </c:pt>
                <c:pt idx="509">
                  <c:v>-3.432588916459856</c:v>
                </c:pt>
                <c:pt idx="510">
                  <c:v>-0.991295938104466</c:v>
                </c:pt>
                <c:pt idx="511">
                  <c:v>1.234567901234563</c:v>
                </c:pt>
                <c:pt idx="512">
                  <c:v>-0.316455696202536</c:v>
                </c:pt>
                <c:pt idx="513">
                  <c:v>-0.875224416517044</c:v>
                </c:pt>
                <c:pt idx="514">
                  <c:v>0.90090090090091</c:v>
                </c:pt>
                <c:pt idx="515">
                  <c:v>3.381014304291285</c:v>
                </c:pt>
                <c:pt idx="516">
                  <c:v>2.596580113996212</c:v>
                </c:pt>
                <c:pt idx="517">
                  <c:v>1.314771848414531</c:v>
                </c:pt>
                <c:pt idx="518">
                  <c:v>-0.666666666666664</c:v>
                </c:pt>
                <c:pt idx="519">
                  <c:v>-1.769087523277471</c:v>
                </c:pt>
                <c:pt idx="520">
                  <c:v>1.610904584882268</c:v>
                </c:pt>
                <c:pt idx="521">
                  <c:v>-0.438005390835588</c:v>
                </c:pt>
                <c:pt idx="522">
                  <c:v>#N/A</c:v>
                </c:pt>
                <c:pt idx="523">
                  <c:v>-0.788211103495546</c:v>
                </c:pt>
                <c:pt idx="524">
                  <c:v>-1.505646173149322</c:v>
                </c:pt>
                <c:pt idx="525">
                  <c:v>-3.113087674714095</c:v>
                </c:pt>
                <c:pt idx="526">
                  <c:v>-3.203661327231134</c:v>
                </c:pt>
                <c:pt idx="527">
                  <c:v>4.627071823204407</c:v>
                </c:pt>
                <c:pt idx="528">
                  <c:v>1.502403846153838</c:v>
                </c:pt>
                <c:pt idx="529">
                  <c:v>4.04397330192384</c:v>
                </c:pt>
                <c:pt idx="530">
                  <c:v>1.904761904761898</c:v>
                </c:pt>
                <c:pt idx="531">
                  <c:v>2.435064935064922</c:v>
                </c:pt>
                <c:pt idx="532">
                  <c:v>0.598526703499087</c:v>
                </c:pt>
                <c:pt idx="533">
                  <c:v>-3.690186536901848</c:v>
                </c:pt>
                <c:pt idx="534">
                  <c:v>-1.398601398601394</c:v>
                </c:pt>
                <c:pt idx="535">
                  <c:v>0.983606557377051</c:v>
                </c:pt>
                <c:pt idx="536">
                  <c:v>2.150537634408606</c:v>
                </c:pt>
                <c:pt idx="537">
                  <c:v>0.228050171037627</c:v>
                </c:pt>
                <c:pt idx="538">
                  <c:v>-2.844638949671762</c:v>
                </c:pt>
                <c:pt idx="539">
                  <c:v>1.28617363344051</c:v>
                </c:pt>
                <c:pt idx="540">
                  <c:v>0.5056890012642</c:v>
                </c:pt>
                <c:pt idx="541">
                  <c:v>-0.181900864029108</c:v>
                </c:pt>
                <c:pt idx="542">
                  <c:v>1.335559265442411</c:v>
                </c:pt>
                <c:pt idx="543">
                  <c:v>-6.52866242038217</c:v>
                </c:pt>
                <c:pt idx="544">
                  <c:v>-1.340206185567022</c:v>
                </c:pt>
                <c:pt idx="545">
                  <c:v>0.539811066126868</c:v>
                </c:pt>
                <c:pt idx="546">
                  <c:v>-0.4594180704441</c:v>
                </c:pt>
                <c:pt idx="547">
                  <c:v>4.03120936280884</c:v>
                </c:pt>
                <c:pt idx="548">
                  <c:v>2.331887201735352</c:v>
                </c:pt>
                <c:pt idx="549">
                  <c:v>-6.437125748502988</c:v>
                </c:pt>
                <c:pt idx="550">
                  <c:v>1.259689922480622</c:v>
                </c:pt>
                <c:pt idx="551">
                  <c:v>-2.964118564742588</c:v>
                </c:pt>
                <c:pt idx="552">
                  <c:v>-0.20703933747413</c:v>
                </c:pt>
                <c:pt idx="553">
                  <c:v>2.932098765432108</c:v>
                </c:pt>
                <c:pt idx="554">
                  <c:v>4.06852248394003</c:v>
                </c:pt>
                <c:pt idx="555">
                  <c:v>-6.097018246550933</c:v>
                </c:pt>
                <c:pt idx="556">
                  <c:v>-0.177069499778655</c:v>
                </c:pt>
                <c:pt idx="557">
                  <c:v>-1.93491644678979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941783176"/>
        <c:axId val="-1941780008"/>
      </c:scatterChart>
      <c:valAx>
        <c:axId val="-1941783176"/>
        <c:scaling>
          <c:orientation val="minMax"/>
          <c:max val="560.0"/>
          <c:min val="0.0"/>
        </c:scaling>
        <c:delete val="0"/>
        <c:axPos val="b"/>
        <c:majorTickMark val="out"/>
        <c:minorTickMark val="none"/>
        <c:tickLblPos val="nextTo"/>
        <c:spPr>
          <a:solidFill>
            <a:srgbClr val="FFFF00"/>
          </a:solidFill>
        </c:spPr>
        <c:txPr>
          <a:bodyPr/>
          <a:lstStyle/>
          <a:p>
            <a:pPr>
              <a:defRPr b="1" i="0" baseline="0">
                <a:solidFill>
                  <a:srgbClr val="0000FF"/>
                </a:solidFill>
                <a:latin typeface="Arial"/>
              </a:defRPr>
            </a:pPr>
            <a:endParaRPr lang="en-US"/>
          </a:p>
        </c:txPr>
        <c:crossAx val="-1941780008"/>
        <c:crosses val="autoZero"/>
        <c:crossBetween val="midCat"/>
      </c:valAx>
      <c:valAx>
        <c:axId val="-1941780008"/>
        <c:scaling>
          <c:orientation val="minMax"/>
          <c:min val="-1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0" i="0">
                <a:latin typeface="Arial"/>
              </a:defRPr>
            </a:pPr>
            <a:endParaRPr lang="en-US"/>
          </a:p>
        </c:txPr>
        <c:crossAx val="-194178317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47625">
              <a:noFill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000458250451443023"/>
                  <c:y val="-0.331459731222146"/>
                </c:manualLayout>
              </c:layout>
              <c:numFmt formatCode="General" sourceLinked="0"/>
              <c:spPr>
                <a:solidFill>
                  <a:srgbClr val="FFFFFF"/>
                </a:solidFill>
                <a:ln>
                  <a:solidFill>
                    <a:srgbClr val="000000"/>
                  </a:solidFill>
                </a:ln>
              </c:spPr>
              <c:txPr>
                <a:bodyPr/>
                <a:lstStyle/>
                <a:p>
                  <a:pPr>
                    <a:defRPr b="1" i="0">
                      <a:latin typeface="Arial"/>
                    </a:defRPr>
                  </a:pPr>
                  <a:endParaRPr lang="en-US"/>
                </a:p>
              </c:txPr>
            </c:trendlineLbl>
          </c:trendline>
          <c:yVal>
            <c:numRef>
              <c:f>'[③健診Hbデータまとめ_香崎 2.xlsx]事故後線量多い順'!$H$1254:$H$2112</c:f>
              <c:numCache>
                <c:formatCode>General</c:formatCode>
                <c:ptCount val="859"/>
                <c:pt idx="0">
                  <c:v>-1.217861975642758</c:v>
                </c:pt>
                <c:pt idx="1">
                  <c:v>1.936619718309874</c:v>
                </c:pt>
                <c:pt idx="2">
                  <c:v>-3.074866310160434</c:v>
                </c:pt>
                <c:pt idx="3">
                  <c:v>-1.309328968903444</c:v>
                </c:pt>
                <c:pt idx="4">
                  <c:v>-2.008456659619438</c:v>
                </c:pt>
                <c:pt idx="5">
                  <c:v>-4.046997389033937</c:v>
                </c:pt>
                <c:pt idx="6">
                  <c:v>-2.056962025316463</c:v>
                </c:pt>
                <c:pt idx="7">
                  <c:v>-1.607142857142854</c:v>
                </c:pt>
                <c:pt idx="8">
                  <c:v>0.914634146341477</c:v>
                </c:pt>
                <c:pt idx="9">
                  <c:v>3.142983621071254</c:v>
                </c:pt>
                <c:pt idx="10">
                  <c:v>0.531914893617016</c:v>
                </c:pt>
                <c:pt idx="11">
                  <c:v>-1.166666666666671</c:v>
                </c:pt>
                <c:pt idx="12">
                  <c:v>2.99468233977051</c:v>
                </c:pt>
                <c:pt idx="13">
                  <c:v>-3.100775193798448</c:v>
                </c:pt>
                <c:pt idx="14">
                  <c:v>-2.116402116402118</c:v>
                </c:pt>
                <c:pt idx="15">
                  <c:v>-1.148730350665053</c:v>
                </c:pt>
                <c:pt idx="16">
                  <c:v>4.50669914738126</c:v>
                </c:pt>
                <c:pt idx="17">
                  <c:v>-6.028368794326238</c:v>
                </c:pt>
                <c:pt idx="18">
                  <c:v>-2.611775121735277</c:v>
                </c:pt>
                <c:pt idx="19">
                  <c:v>-0.740479548660088</c:v>
                </c:pt>
                <c:pt idx="20">
                  <c:v>1.261829652996841</c:v>
                </c:pt>
                <c:pt idx="21">
                  <c:v>2.539682539682531</c:v>
                </c:pt>
                <c:pt idx="22">
                  <c:v>2.309468822170904</c:v>
                </c:pt>
                <c:pt idx="23">
                  <c:v>-0.0626566416040309</c:v>
                </c:pt>
                <c:pt idx="24">
                  <c:v>-3.02267002518892</c:v>
                </c:pt>
                <c:pt idx="25">
                  <c:v>-2.999999999999996</c:v>
                </c:pt>
                <c:pt idx="26">
                  <c:v>3.183118741058656</c:v>
                </c:pt>
                <c:pt idx="27">
                  <c:v>-2.560240963855447</c:v>
                </c:pt>
                <c:pt idx="28">
                  <c:v>3.743016759776537</c:v>
                </c:pt>
                <c:pt idx="29">
                  <c:v>-1.986754966887398</c:v>
                </c:pt>
                <c:pt idx="30">
                  <c:v>-1.391862955032109</c:v>
                </c:pt>
                <c:pt idx="31">
                  <c:v>-2.235516372795972</c:v>
                </c:pt>
                <c:pt idx="32">
                  <c:v>2.103960396039603</c:v>
                </c:pt>
                <c:pt idx="33">
                  <c:v>1.604278074866312</c:v>
                </c:pt>
                <c:pt idx="34">
                  <c:v>1.54941373534338</c:v>
                </c:pt>
                <c:pt idx="35">
                  <c:v>6.603153745072291</c:v>
                </c:pt>
                <c:pt idx="36">
                  <c:v>5.272108843537408</c:v>
                </c:pt>
                <c:pt idx="37">
                  <c:v>1.784266017842658</c:v>
                </c:pt>
                <c:pt idx="38">
                  <c:v>-3.205128205128206</c:v>
                </c:pt>
                <c:pt idx="39">
                  <c:v>-4.915912031047876</c:v>
                </c:pt>
                <c:pt idx="40">
                  <c:v>-1.520270270270292</c:v>
                </c:pt>
                <c:pt idx="41">
                  <c:v>2.721088435374152</c:v>
                </c:pt>
                <c:pt idx="42">
                  <c:v>2.015558698727004</c:v>
                </c:pt>
                <c:pt idx="43">
                  <c:v>2.297165200391017</c:v>
                </c:pt>
                <c:pt idx="44">
                  <c:v>2.59433962264152</c:v>
                </c:pt>
                <c:pt idx="45">
                  <c:v>5.478589420654918</c:v>
                </c:pt>
                <c:pt idx="46">
                  <c:v>3.603603603603606</c:v>
                </c:pt>
                <c:pt idx="47">
                  <c:v>3.051643192488256</c:v>
                </c:pt>
                <c:pt idx="48">
                  <c:v>2.736928104575178</c:v>
                </c:pt>
                <c:pt idx="49">
                  <c:v>-2.901785714285726</c:v>
                </c:pt>
                <c:pt idx="50">
                  <c:v>2.11978465679678</c:v>
                </c:pt>
                <c:pt idx="51">
                  <c:v>0.593667546174141</c:v>
                </c:pt>
                <c:pt idx="52">
                  <c:v>2.215980024968768</c:v>
                </c:pt>
                <c:pt idx="53">
                  <c:v>-1.464435146443543</c:v>
                </c:pt>
                <c:pt idx="54">
                  <c:v>-2.07373271889399</c:v>
                </c:pt>
                <c:pt idx="55">
                  <c:v>-3.205918618988911</c:v>
                </c:pt>
                <c:pt idx="56">
                  <c:v>3.456116416552973</c:v>
                </c:pt>
                <c:pt idx="57">
                  <c:v>2.013422818791927</c:v>
                </c:pt>
                <c:pt idx="58">
                  <c:v>3.211009174311909</c:v>
                </c:pt>
                <c:pt idx="59">
                  <c:v>-0.527009222661409</c:v>
                </c:pt>
                <c:pt idx="60">
                  <c:v>-0.943396226415088</c:v>
                </c:pt>
                <c:pt idx="61">
                  <c:v>-0.136798905608752</c:v>
                </c:pt>
                <c:pt idx="62">
                  <c:v>-1.5625</c:v>
                </c:pt>
                <c:pt idx="63">
                  <c:v>1.689739413680786</c:v>
                </c:pt>
                <c:pt idx="64">
                  <c:v>1.7786561264822</c:v>
                </c:pt>
                <c:pt idx="65">
                  <c:v>0.226757369614524</c:v>
                </c:pt>
                <c:pt idx="66">
                  <c:v>-1.717557251908394</c:v>
                </c:pt>
                <c:pt idx="67">
                  <c:v>0.319197446420418</c:v>
                </c:pt>
                <c:pt idx="68">
                  <c:v>-2.533783783783784</c:v>
                </c:pt>
                <c:pt idx="69">
                  <c:v>3.294367693942596</c:v>
                </c:pt>
                <c:pt idx="70">
                  <c:v>-2.960526315789469</c:v>
                </c:pt>
                <c:pt idx="71">
                  <c:v>3.121175030599743</c:v>
                </c:pt>
                <c:pt idx="72">
                  <c:v>1.651480637813215</c:v>
                </c:pt>
                <c:pt idx="73">
                  <c:v>3.469581749049435</c:v>
                </c:pt>
                <c:pt idx="74">
                  <c:v>#N/A</c:v>
                </c:pt>
                <c:pt idx="75">
                  <c:v>-1.585204755614268</c:v>
                </c:pt>
                <c:pt idx="76">
                  <c:v>0.182704019488414</c:v>
                </c:pt>
                <c:pt idx="77">
                  <c:v>0.384615384615386</c:v>
                </c:pt>
                <c:pt idx="78">
                  <c:v>-1.632934682612691</c:v>
                </c:pt>
                <c:pt idx="79">
                  <c:v>0.164473684210546</c:v>
                </c:pt>
                <c:pt idx="80">
                  <c:v>-1.938239159001302</c:v>
                </c:pt>
                <c:pt idx="81">
                  <c:v>-0.760043431053206</c:v>
                </c:pt>
                <c:pt idx="82">
                  <c:v>-0.0917992656058569</c:v>
                </c:pt>
                <c:pt idx="83">
                  <c:v>-2.902262057191645</c:v>
                </c:pt>
                <c:pt idx="84">
                  <c:v>-1.492537313432824</c:v>
                </c:pt>
                <c:pt idx="85">
                  <c:v>1.497504159733787</c:v>
                </c:pt>
                <c:pt idx="86">
                  <c:v>8.55263157894737</c:v>
                </c:pt>
                <c:pt idx="87">
                  <c:v>-0.240384615384589</c:v>
                </c:pt>
                <c:pt idx="88">
                  <c:v>-1.386404293381049</c:v>
                </c:pt>
                <c:pt idx="89">
                  <c:v>7.118834080717469</c:v>
                </c:pt>
                <c:pt idx="90">
                  <c:v>-1.223776223776241</c:v>
                </c:pt>
                <c:pt idx="91">
                  <c:v>0.571428571428563</c:v>
                </c:pt>
                <c:pt idx="92">
                  <c:v>-2.476290832455219</c:v>
                </c:pt>
                <c:pt idx="93">
                  <c:v>-4.125248508946321</c:v>
                </c:pt>
                <c:pt idx="94">
                  <c:v>-0.192554557124537</c:v>
                </c:pt>
                <c:pt idx="95">
                  <c:v>1.542416452442161</c:v>
                </c:pt>
                <c:pt idx="96">
                  <c:v>3.187919463087258</c:v>
                </c:pt>
                <c:pt idx="97">
                  <c:v>-0.70480928689885</c:v>
                </c:pt>
                <c:pt idx="98">
                  <c:v>3.053435114503817</c:v>
                </c:pt>
                <c:pt idx="99">
                  <c:v>2.632850241545893</c:v>
                </c:pt>
                <c:pt idx="100">
                  <c:v>1.925630810092968</c:v>
                </c:pt>
                <c:pt idx="101">
                  <c:v>-1.410658307210007</c:v>
                </c:pt>
                <c:pt idx="102">
                  <c:v>-8.067940552017</c:v>
                </c:pt>
                <c:pt idx="103">
                  <c:v>-1.675786593707257</c:v>
                </c:pt>
                <c:pt idx="104">
                  <c:v>-1.185567010309277</c:v>
                </c:pt>
                <c:pt idx="105">
                  <c:v>4.077253218884123</c:v>
                </c:pt>
                <c:pt idx="106">
                  <c:v>-4.125615763546775</c:v>
                </c:pt>
                <c:pt idx="107">
                  <c:v>-0.729927007299254</c:v>
                </c:pt>
                <c:pt idx="108">
                  <c:v>-2.257154373236586</c:v>
                </c:pt>
                <c:pt idx="109">
                  <c:v>-2.267303102625308</c:v>
                </c:pt>
                <c:pt idx="110">
                  <c:v>-2.314316469321846</c:v>
                </c:pt>
                <c:pt idx="111">
                  <c:v>-2.796882164144888</c:v>
                </c:pt>
                <c:pt idx="112">
                  <c:v>-6.448087431693995</c:v>
                </c:pt>
                <c:pt idx="113">
                  <c:v>0.727603456116397</c:v>
                </c:pt>
                <c:pt idx="114">
                  <c:v>-2.30664857530527</c:v>
                </c:pt>
                <c:pt idx="115">
                  <c:v>-0.641025641025639</c:v>
                </c:pt>
                <c:pt idx="116">
                  <c:v>4.461756373937683</c:v>
                </c:pt>
                <c:pt idx="117">
                  <c:v>1.912260967379065</c:v>
                </c:pt>
                <c:pt idx="118">
                  <c:v>0.470219435736684</c:v>
                </c:pt>
                <c:pt idx="119">
                  <c:v>2.690058479532157</c:v>
                </c:pt>
                <c:pt idx="120">
                  <c:v>0.326797385620931</c:v>
                </c:pt>
                <c:pt idx="121">
                  <c:v>0.660066006600658</c:v>
                </c:pt>
                <c:pt idx="122">
                  <c:v>-0.813008130081276</c:v>
                </c:pt>
                <c:pt idx="123">
                  <c:v>2.572145545796738</c:v>
                </c:pt>
                <c:pt idx="124">
                  <c:v>1.185770750988138</c:v>
                </c:pt>
                <c:pt idx="125">
                  <c:v>3.965517241379305</c:v>
                </c:pt>
                <c:pt idx="126">
                  <c:v>0.961538461538462</c:v>
                </c:pt>
                <c:pt idx="127">
                  <c:v>1.024208566107994</c:v>
                </c:pt>
                <c:pt idx="128">
                  <c:v>4.205607476635516</c:v>
                </c:pt>
                <c:pt idx="129">
                  <c:v>1.85185185185186</c:v>
                </c:pt>
                <c:pt idx="130">
                  <c:v>-1.292067307692307</c:v>
                </c:pt>
                <c:pt idx="131">
                  <c:v>2.624495289367433</c:v>
                </c:pt>
                <c:pt idx="132">
                  <c:v>0.379867046533724</c:v>
                </c:pt>
                <c:pt idx="133">
                  <c:v>-3.401585204755607</c:v>
                </c:pt>
                <c:pt idx="134">
                  <c:v>-3.061224489795914</c:v>
                </c:pt>
                <c:pt idx="135">
                  <c:v>3.80507343124167</c:v>
                </c:pt>
                <c:pt idx="136">
                  <c:v>-3.058929374718871</c:v>
                </c:pt>
                <c:pt idx="137">
                  <c:v>-4.723650385604098</c:v>
                </c:pt>
                <c:pt idx="138">
                  <c:v>-2.444444444444448</c:v>
                </c:pt>
                <c:pt idx="139">
                  <c:v>6.260869565217382</c:v>
                </c:pt>
                <c:pt idx="140">
                  <c:v>-1.741573033707874</c:v>
                </c:pt>
                <c:pt idx="141">
                  <c:v>0.149476831091178</c:v>
                </c:pt>
                <c:pt idx="142">
                  <c:v>1.016949152542363</c:v>
                </c:pt>
                <c:pt idx="143">
                  <c:v>11.87290969899667</c:v>
                </c:pt>
                <c:pt idx="144">
                  <c:v>-0.3504161191415</c:v>
                </c:pt>
                <c:pt idx="145">
                  <c:v>0.194174757281542</c:v>
                </c:pt>
                <c:pt idx="146">
                  <c:v>-0.80758426966291</c:v>
                </c:pt>
                <c:pt idx="147">
                  <c:v>1.1688835147118</c:v>
                </c:pt>
                <c:pt idx="148">
                  <c:v>-3.350515463917512</c:v>
                </c:pt>
                <c:pt idx="149">
                  <c:v>-0.198938992042448</c:v>
                </c:pt>
                <c:pt idx="150">
                  <c:v>-0.647249190938497</c:v>
                </c:pt>
                <c:pt idx="151">
                  <c:v>0.580781414994721</c:v>
                </c:pt>
                <c:pt idx="152">
                  <c:v>-6.910569105691053</c:v>
                </c:pt>
                <c:pt idx="153">
                  <c:v>-2.010869565217393</c:v>
                </c:pt>
                <c:pt idx="154">
                  <c:v>0.387051372273063</c:v>
                </c:pt>
                <c:pt idx="155">
                  <c:v>0.190839694656496</c:v>
                </c:pt>
                <c:pt idx="156">
                  <c:v>-0.606060606060593</c:v>
                </c:pt>
                <c:pt idx="157">
                  <c:v>-1.209677419354837</c:v>
                </c:pt>
                <c:pt idx="158">
                  <c:v>-0.541271989174585</c:v>
                </c:pt>
                <c:pt idx="159">
                  <c:v>2.999434069043575</c:v>
                </c:pt>
                <c:pt idx="160">
                  <c:v>4.420387911592223</c:v>
                </c:pt>
                <c:pt idx="161">
                  <c:v>-1.140065146579798</c:v>
                </c:pt>
                <c:pt idx="162">
                  <c:v>-3.232087227414317</c:v>
                </c:pt>
                <c:pt idx="163">
                  <c:v>-1.408450704225356</c:v>
                </c:pt>
                <c:pt idx="164">
                  <c:v>8.237986270022865</c:v>
                </c:pt>
                <c:pt idx="165">
                  <c:v>-2.861952861952855</c:v>
                </c:pt>
                <c:pt idx="166">
                  <c:v>-1.129363449691993</c:v>
                </c:pt>
                <c:pt idx="167">
                  <c:v>-3.927068723702668</c:v>
                </c:pt>
                <c:pt idx="168">
                  <c:v>1.216216216216195</c:v>
                </c:pt>
                <c:pt idx="169">
                  <c:v>-1.086956521739135</c:v>
                </c:pt>
                <c:pt idx="170">
                  <c:v>-2.21402214022141</c:v>
                </c:pt>
                <c:pt idx="171">
                  <c:v>2.838010204081623</c:v>
                </c:pt>
                <c:pt idx="172">
                  <c:v>-0.53859964093358</c:v>
                </c:pt>
                <c:pt idx="173">
                  <c:v>4.099307159353323</c:v>
                </c:pt>
                <c:pt idx="174">
                  <c:v>-2.680525164113785</c:v>
                </c:pt>
                <c:pt idx="175">
                  <c:v>-2.101769911504412</c:v>
                </c:pt>
                <c:pt idx="176">
                  <c:v>-5.569007263922536</c:v>
                </c:pt>
                <c:pt idx="177">
                  <c:v>-3.662089055347511</c:v>
                </c:pt>
                <c:pt idx="178">
                  <c:v>-1.28375387339532</c:v>
                </c:pt>
                <c:pt idx="179">
                  <c:v>-4.230769230769246</c:v>
                </c:pt>
                <c:pt idx="180">
                  <c:v>-0.949050949050959</c:v>
                </c:pt>
                <c:pt idx="181">
                  <c:v>-2.141434262948212</c:v>
                </c:pt>
                <c:pt idx="182">
                  <c:v>1.993166287015941</c:v>
                </c:pt>
                <c:pt idx="183">
                  <c:v>0.617283950617293</c:v>
                </c:pt>
                <c:pt idx="184">
                  <c:v>3.338391502276181</c:v>
                </c:pt>
                <c:pt idx="185">
                  <c:v>-2.499999999999991</c:v>
                </c:pt>
                <c:pt idx="186">
                  <c:v>0.182149362477248</c:v>
                </c:pt>
                <c:pt idx="187">
                  <c:v>2.017423200366802</c:v>
                </c:pt>
                <c:pt idx="188">
                  <c:v>-3.758777364725324</c:v>
                </c:pt>
                <c:pt idx="189">
                  <c:v>6.017191977077327</c:v>
                </c:pt>
                <c:pt idx="190">
                  <c:v>-3.44827586206897</c:v>
                </c:pt>
                <c:pt idx="191">
                  <c:v>4.054054054054045</c:v>
                </c:pt>
                <c:pt idx="192">
                  <c:v>1.895206243032341</c:v>
                </c:pt>
                <c:pt idx="193">
                  <c:v>0.363306085376926</c:v>
                </c:pt>
                <c:pt idx="194">
                  <c:v>-3.747534516765262</c:v>
                </c:pt>
                <c:pt idx="195">
                  <c:v>-5.338266384778013</c:v>
                </c:pt>
                <c:pt idx="196">
                  <c:v>-5.399568034557216</c:v>
                </c:pt>
                <c:pt idx="197">
                  <c:v>1.096491228070183</c:v>
                </c:pt>
                <c:pt idx="198">
                  <c:v>0.656814449917896</c:v>
                </c:pt>
                <c:pt idx="199">
                  <c:v>1.244101244101244</c:v>
                </c:pt>
                <c:pt idx="200">
                  <c:v>-1.346801346801354</c:v>
                </c:pt>
                <c:pt idx="201">
                  <c:v>-0.30769230769229</c:v>
                </c:pt>
                <c:pt idx="202">
                  <c:v>0.681818181818179</c:v>
                </c:pt>
                <c:pt idx="203">
                  <c:v>-1.911764705882349</c:v>
                </c:pt>
                <c:pt idx="204">
                  <c:v>2.343749999999977</c:v>
                </c:pt>
                <c:pt idx="205">
                  <c:v>1.355611601513262</c:v>
                </c:pt>
                <c:pt idx="206">
                  <c:v>2.530541012216417</c:v>
                </c:pt>
                <c:pt idx="207">
                  <c:v>1.301735647530042</c:v>
                </c:pt>
                <c:pt idx="208">
                  <c:v>-1.712328767123275</c:v>
                </c:pt>
                <c:pt idx="209">
                  <c:v>4.728370221327975</c:v>
                </c:pt>
                <c:pt idx="210">
                  <c:v>-1.02827763496143</c:v>
                </c:pt>
                <c:pt idx="211">
                  <c:v>6.16996507566938</c:v>
                </c:pt>
                <c:pt idx="212">
                  <c:v>-3.937947494033393</c:v>
                </c:pt>
                <c:pt idx="213">
                  <c:v>-0.222222222222221</c:v>
                </c:pt>
                <c:pt idx="214">
                  <c:v>-1.0759493670886</c:v>
                </c:pt>
                <c:pt idx="215">
                  <c:v>-1.416765053128701</c:v>
                </c:pt>
                <c:pt idx="216">
                  <c:v>2.176278563656139</c:v>
                </c:pt>
                <c:pt idx="217">
                  <c:v>-4.792468977321357</c:v>
                </c:pt>
                <c:pt idx="218">
                  <c:v>2.419984387197497</c:v>
                </c:pt>
                <c:pt idx="219">
                  <c:v>-1.324503311258273</c:v>
                </c:pt>
                <c:pt idx="220">
                  <c:v>-7.728215767634857</c:v>
                </c:pt>
                <c:pt idx="221">
                  <c:v>-4.64989059080962</c:v>
                </c:pt>
                <c:pt idx="222">
                  <c:v>0.859339665309804</c:v>
                </c:pt>
                <c:pt idx="223">
                  <c:v>0.871459694989092</c:v>
                </c:pt>
                <c:pt idx="224">
                  <c:v>-0.803673938002287</c:v>
                </c:pt>
                <c:pt idx="225">
                  <c:v>3.971962616822422</c:v>
                </c:pt>
                <c:pt idx="226">
                  <c:v>-1.17035110533161</c:v>
                </c:pt>
                <c:pt idx="227">
                  <c:v>-2.320675105485237</c:v>
                </c:pt>
                <c:pt idx="228">
                  <c:v>0.566150178784281</c:v>
                </c:pt>
                <c:pt idx="229">
                  <c:v>5.543358946212954</c:v>
                </c:pt>
                <c:pt idx="230">
                  <c:v>-1.306970509383368</c:v>
                </c:pt>
                <c:pt idx="231">
                  <c:v>-8.05300713557595</c:v>
                </c:pt>
                <c:pt idx="232">
                  <c:v>-4.098360655737698</c:v>
                </c:pt>
                <c:pt idx="233">
                  <c:v>-4.319041614123573</c:v>
                </c:pt>
                <c:pt idx="234">
                  <c:v>-0.0946969696969718</c:v>
                </c:pt>
                <c:pt idx="235">
                  <c:v>1.59235668789809</c:v>
                </c:pt>
                <c:pt idx="236">
                  <c:v>3.745318352059932</c:v>
                </c:pt>
                <c:pt idx="237">
                  <c:v>-2.481389578163763</c:v>
                </c:pt>
                <c:pt idx="238">
                  <c:v>-3.143781784558494</c:v>
                </c:pt>
                <c:pt idx="239">
                  <c:v>-1.823899371069175</c:v>
                </c:pt>
                <c:pt idx="240">
                  <c:v>-1.577909270216957</c:v>
                </c:pt>
                <c:pt idx="241">
                  <c:v>1.785714285714286</c:v>
                </c:pt>
                <c:pt idx="242">
                  <c:v>1.458333333333317</c:v>
                </c:pt>
                <c:pt idx="243">
                  <c:v>0.462962962962961</c:v>
                </c:pt>
                <c:pt idx="244">
                  <c:v>-3.135888501742155</c:v>
                </c:pt>
                <c:pt idx="245">
                  <c:v>-2.165874273639726</c:v>
                </c:pt>
                <c:pt idx="246">
                  <c:v>-3.279369032793683</c:v>
                </c:pt>
                <c:pt idx="247">
                  <c:v>-0.755767700875111</c:v>
                </c:pt>
                <c:pt idx="248">
                  <c:v>-2.741514360313315</c:v>
                </c:pt>
                <c:pt idx="249">
                  <c:v>-3.57142857142858</c:v>
                </c:pt>
                <c:pt idx="250">
                  <c:v>-0.494159928122198</c:v>
                </c:pt>
                <c:pt idx="251">
                  <c:v>1.55555555555555</c:v>
                </c:pt>
                <c:pt idx="252">
                  <c:v>-1.149425287356323</c:v>
                </c:pt>
                <c:pt idx="253">
                  <c:v>1.207056638811517</c:v>
                </c:pt>
                <c:pt idx="254">
                  <c:v>-2.237136465324376</c:v>
                </c:pt>
                <c:pt idx="255">
                  <c:v>-6.962025316455684</c:v>
                </c:pt>
                <c:pt idx="256">
                  <c:v>-0.689655172413791</c:v>
                </c:pt>
                <c:pt idx="257">
                  <c:v>-2.140672782874626</c:v>
                </c:pt>
                <c:pt idx="258">
                  <c:v>-3.937947494033414</c:v>
                </c:pt>
                <c:pt idx="259">
                  <c:v>-2.877697841726621</c:v>
                </c:pt>
                <c:pt idx="260">
                  <c:v>-4.857397504456316</c:v>
                </c:pt>
                <c:pt idx="261">
                  <c:v>0.943396226415074</c:v>
                </c:pt>
                <c:pt idx="262">
                  <c:v>-0.0646830530401021</c:v>
                </c:pt>
                <c:pt idx="263">
                  <c:v>1.505016722408012</c:v>
                </c:pt>
                <c:pt idx="264">
                  <c:v>5.79902611775124</c:v>
                </c:pt>
                <c:pt idx="265">
                  <c:v>-0.104712041884822</c:v>
                </c:pt>
                <c:pt idx="266">
                  <c:v>3.801169590643257</c:v>
                </c:pt>
                <c:pt idx="267">
                  <c:v>-5.371428571428582</c:v>
                </c:pt>
                <c:pt idx="268">
                  <c:v>2.118644067796602</c:v>
                </c:pt>
                <c:pt idx="269">
                  <c:v>2.316602316602336</c:v>
                </c:pt>
                <c:pt idx="270">
                  <c:v>-2.278562259306818</c:v>
                </c:pt>
                <c:pt idx="271">
                  <c:v>-1.40625000000001</c:v>
                </c:pt>
                <c:pt idx="272">
                  <c:v>-2.369668246445502</c:v>
                </c:pt>
                <c:pt idx="273">
                  <c:v>-3.794940079893489</c:v>
                </c:pt>
                <c:pt idx="274">
                  <c:v>-1.156069364161825</c:v>
                </c:pt>
                <c:pt idx="275">
                  <c:v>1.037437979251222</c:v>
                </c:pt>
                <c:pt idx="276">
                  <c:v>-1.44230769230769</c:v>
                </c:pt>
                <c:pt idx="277">
                  <c:v>-2.07275803722505</c:v>
                </c:pt>
                <c:pt idx="278">
                  <c:v>-2.739090064995352</c:v>
                </c:pt>
                <c:pt idx="279">
                  <c:v>4.433497536945818</c:v>
                </c:pt>
                <c:pt idx="280">
                  <c:v>-2.531645569620252</c:v>
                </c:pt>
                <c:pt idx="281">
                  <c:v>-3.239051094890494</c:v>
                </c:pt>
                <c:pt idx="282">
                  <c:v>0.353669319186557</c:v>
                </c:pt>
                <c:pt idx="283">
                  <c:v>-1.157981803143065</c:v>
                </c:pt>
                <c:pt idx="284">
                  <c:v>-0.395927601809968</c:v>
                </c:pt>
                <c:pt idx="285">
                  <c:v>-1.750972762645912</c:v>
                </c:pt>
                <c:pt idx="286">
                  <c:v>2.527420123986649</c:v>
                </c:pt>
                <c:pt idx="287">
                  <c:v>4.020570359981281</c:v>
                </c:pt>
                <c:pt idx="288">
                  <c:v>-2.760084925690023</c:v>
                </c:pt>
                <c:pt idx="289">
                  <c:v>0.37243947858474</c:v>
                </c:pt>
                <c:pt idx="290">
                  <c:v>-0.554400554400555</c:v>
                </c:pt>
                <c:pt idx="291">
                  <c:v>5.046094129063548</c:v>
                </c:pt>
                <c:pt idx="292">
                  <c:v>0.597609561752987</c:v>
                </c:pt>
                <c:pt idx="293">
                  <c:v>-1.845819761129195</c:v>
                </c:pt>
                <c:pt idx="294">
                  <c:v>-0.855920114122676</c:v>
                </c:pt>
                <c:pt idx="295">
                  <c:v>-3.076274757690674</c:v>
                </c:pt>
                <c:pt idx="296">
                  <c:v>0.698995194408043</c:v>
                </c:pt>
                <c:pt idx="297">
                  <c:v>-2.894491129785226</c:v>
                </c:pt>
                <c:pt idx="298">
                  <c:v>1.653696498054483</c:v>
                </c:pt>
                <c:pt idx="299">
                  <c:v>-0.978407557354935</c:v>
                </c:pt>
                <c:pt idx="300">
                  <c:v>-1.315789473684217</c:v>
                </c:pt>
                <c:pt idx="301">
                  <c:v>1.04895104895104</c:v>
                </c:pt>
                <c:pt idx="302">
                  <c:v>-2.42825607064018</c:v>
                </c:pt>
                <c:pt idx="303">
                  <c:v>3.733170134638942</c:v>
                </c:pt>
                <c:pt idx="304">
                  <c:v>6.387665198237861</c:v>
                </c:pt>
                <c:pt idx="305">
                  <c:v>-0.862068965517245</c:v>
                </c:pt>
                <c:pt idx="306">
                  <c:v>-0.744818652849754</c:v>
                </c:pt>
                <c:pt idx="307">
                  <c:v>3.292737934145227</c:v>
                </c:pt>
                <c:pt idx="308">
                  <c:v>-1.378122308354875</c:v>
                </c:pt>
                <c:pt idx="309">
                  <c:v>-1.948717948717958</c:v>
                </c:pt>
                <c:pt idx="310">
                  <c:v>-0.566994926887494</c:v>
                </c:pt>
                <c:pt idx="311">
                  <c:v>4.396843291995481</c:v>
                </c:pt>
                <c:pt idx="312">
                  <c:v>0.360824742268043</c:v>
                </c:pt>
                <c:pt idx="313">
                  <c:v>2.841596130592496</c:v>
                </c:pt>
                <c:pt idx="314">
                  <c:v>-12.27213541666667</c:v>
                </c:pt>
                <c:pt idx="315">
                  <c:v>-7.578947368421048</c:v>
                </c:pt>
                <c:pt idx="316">
                  <c:v>0.298408488063672</c:v>
                </c:pt>
                <c:pt idx="317">
                  <c:v>0.572737686139752</c:v>
                </c:pt>
                <c:pt idx="318">
                  <c:v>4.148471615720533</c:v>
                </c:pt>
                <c:pt idx="319">
                  <c:v>-2.243589743589728</c:v>
                </c:pt>
                <c:pt idx="320">
                  <c:v>-0.20964360587002</c:v>
                </c:pt>
                <c:pt idx="321">
                  <c:v>-1.71840354767185</c:v>
                </c:pt>
                <c:pt idx="322">
                  <c:v>0.983020554066129</c:v>
                </c:pt>
                <c:pt idx="323">
                  <c:v>1.396276595744674</c:v>
                </c:pt>
                <c:pt idx="324">
                  <c:v>-2.076502732240447</c:v>
                </c:pt>
                <c:pt idx="325">
                  <c:v>0.205338809034896</c:v>
                </c:pt>
                <c:pt idx="326">
                  <c:v>1.839237057220693</c:v>
                </c:pt>
                <c:pt idx="327">
                  <c:v>-5.697445972495067</c:v>
                </c:pt>
                <c:pt idx="328">
                  <c:v>-1.071025930101465</c:v>
                </c:pt>
                <c:pt idx="329">
                  <c:v>1.507092198581548</c:v>
                </c:pt>
                <c:pt idx="330">
                  <c:v>-3.137789904502052</c:v>
                </c:pt>
                <c:pt idx="331">
                  <c:v>-1.381509032943655</c:v>
                </c:pt>
                <c:pt idx="332">
                  <c:v>-1.249999999999984</c:v>
                </c:pt>
                <c:pt idx="333">
                  <c:v>0.0</c:v>
                </c:pt>
                <c:pt idx="334">
                  <c:v>4.588607594936717</c:v>
                </c:pt>
                <c:pt idx="335">
                  <c:v>4.824561403508786</c:v>
                </c:pt>
                <c:pt idx="336">
                  <c:v>1.639344262295082</c:v>
                </c:pt>
                <c:pt idx="337">
                  <c:v>-0.622037914691967</c:v>
                </c:pt>
                <c:pt idx="338">
                  <c:v>-1.60427807486631</c:v>
                </c:pt>
                <c:pt idx="339">
                  <c:v>7.235142118863056</c:v>
                </c:pt>
                <c:pt idx="340">
                  <c:v>1.826484018264846</c:v>
                </c:pt>
                <c:pt idx="341">
                  <c:v>-2.813299232736581</c:v>
                </c:pt>
                <c:pt idx="342">
                  <c:v>2.603550295857991</c:v>
                </c:pt>
                <c:pt idx="343">
                  <c:v>-0.438596491228057</c:v>
                </c:pt>
                <c:pt idx="344">
                  <c:v>1.649628252788113</c:v>
                </c:pt>
                <c:pt idx="345">
                  <c:v>0.64102564102565</c:v>
                </c:pt>
                <c:pt idx="346">
                  <c:v>-1.043841336116907</c:v>
                </c:pt>
                <c:pt idx="347">
                  <c:v>0.912810827824989</c:v>
                </c:pt>
                <c:pt idx="348">
                  <c:v>1.262967974740658</c:v>
                </c:pt>
                <c:pt idx="349">
                  <c:v>4.16666666666667</c:v>
                </c:pt>
                <c:pt idx="350">
                  <c:v>1.050620821394482</c:v>
                </c:pt>
                <c:pt idx="351">
                  <c:v>-1.329901329901332</c:v>
                </c:pt>
                <c:pt idx="352">
                  <c:v>-7.471264367816096</c:v>
                </c:pt>
                <c:pt idx="353">
                  <c:v>1.244101244101244</c:v>
                </c:pt>
                <c:pt idx="354">
                  <c:v>0.907029478458047</c:v>
                </c:pt>
                <c:pt idx="355">
                  <c:v>3.575297941495117</c:v>
                </c:pt>
                <c:pt idx="356">
                  <c:v>2.602905569007271</c:v>
                </c:pt>
                <c:pt idx="357">
                  <c:v>1.149425287356315</c:v>
                </c:pt>
                <c:pt idx="358">
                  <c:v>-0.841080123948652</c:v>
                </c:pt>
                <c:pt idx="359">
                  <c:v>1.385390428211591</c:v>
                </c:pt>
                <c:pt idx="360">
                  <c:v>-3.500000000000002</c:v>
                </c:pt>
                <c:pt idx="361">
                  <c:v>-1.666666666666661</c:v>
                </c:pt>
                <c:pt idx="362">
                  <c:v>1.411509229098783</c:v>
                </c:pt>
                <c:pt idx="363">
                  <c:v>3.219696969696955</c:v>
                </c:pt>
                <c:pt idx="364">
                  <c:v>1.033057851239654</c:v>
                </c:pt>
                <c:pt idx="365">
                  <c:v>-1.890034364261171</c:v>
                </c:pt>
                <c:pt idx="366">
                  <c:v>-2.042577675489091</c:v>
                </c:pt>
                <c:pt idx="367">
                  <c:v>6.80907877169559</c:v>
                </c:pt>
                <c:pt idx="368">
                  <c:v>-2.254009536194186</c:v>
                </c:pt>
                <c:pt idx="369">
                  <c:v>-0.846702317290542</c:v>
                </c:pt>
                <c:pt idx="370">
                  <c:v>2.960969044414544</c:v>
                </c:pt>
                <c:pt idx="371">
                  <c:v>-0.792079207920768</c:v>
                </c:pt>
                <c:pt idx="372">
                  <c:v>-1.15273775216138</c:v>
                </c:pt>
                <c:pt idx="373">
                  <c:v>-3.472222222222222</c:v>
                </c:pt>
                <c:pt idx="374">
                  <c:v>-3.031290743155149</c:v>
                </c:pt>
                <c:pt idx="375">
                  <c:v>2.376302083333333</c:v>
                </c:pt>
                <c:pt idx="376">
                  <c:v>1.859099804305262</c:v>
                </c:pt>
                <c:pt idx="377">
                  <c:v>1.817116060961297</c:v>
                </c:pt>
                <c:pt idx="378">
                  <c:v>-3.245192307692323</c:v>
                </c:pt>
                <c:pt idx="379">
                  <c:v>-1.918976545842222</c:v>
                </c:pt>
                <c:pt idx="380">
                  <c:v>-0.0638569604086832</c:v>
                </c:pt>
                <c:pt idx="381">
                  <c:v>1.85185185185185</c:v>
                </c:pt>
                <c:pt idx="382">
                  <c:v>-3.235294117647047</c:v>
                </c:pt>
                <c:pt idx="383">
                  <c:v>3.050108932461875</c:v>
                </c:pt>
                <c:pt idx="384">
                  <c:v>-0.0310945273632</c:v>
                </c:pt>
                <c:pt idx="385">
                  <c:v>0.73684210526315</c:v>
                </c:pt>
                <c:pt idx="386">
                  <c:v>1.403061224489811</c:v>
                </c:pt>
                <c:pt idx="387">
                  <c:v>0.816582914572871</c:v>
                </c:pt>
                <c:pt idx="388">
                  <c:v>-2.060737527114977</c:v>
                </c:pt>
                <c:pt idx="389">
                  <c:v>0.0</c:v>
                </c:pt>
                <c:pt idx="390">
                  <c:v>0.770077007700773</c:v>
                </c:pt>
                <c:pt idx="391">
                  <c:v>-6.148867313915859</c:v>
                </c:pt>
                <c:pt idx="392">
                  <c:v>-0.826446280991743</c:v>
                </c:pt>
                <c:pt idx="393">
                  <c:v>3.464818763326222</c:v>
                </c:pt>
                <c:pt idx="394">
                  <c:v>1.456542502387778</c:v>
                </c:pt>
                <c:pt idx="395">
                  <c:v>-5.03875968992247</c:v>
                </c:pt>
                <c:pt idx="396">
                  <c:v>-6.480117820324009</c:v>
                </c:pt>
                <c:pt idx="397">
                  <c:v>0.0</c:v>
                </c:pt>
                <c:pt idx="398">
                  <c:v>-0.0309789343246591</c:v>
                </c:pt>
                <c:pt idx="399">
                  <c:v>0.0491642084562646</c:v>
                </c:pt>
                <c:pt idx="400">
                  <c:v>2.277432712215301</c:v>
                </c:pt>
                <c:pt idx="401">
                  <c:v>0.386779184247524</c:v>
                </c:pt>
                <c:pt idx="402">
                  <c:v>-0.188323917137461</c:v>
                </c:pt>
                <c:pt idx="403">
                  <c:v>-4.992816091954013</c:v>
                </c:pt>
                <c:pt idx="404">
                  <c:v>-5.35248041775456</c:v>
                </c:pt>
                <c:pt idx="405">
                  <c:v>1.320132013201327</c:v>
                </c:pt>
                <c:pt idx="406">
                  <c:v>-1.0566762728146</c:v>
                </c:pt>
                <c:pt idx="407">
                  <c:v>0.626740947075208</c:v>
                </c:pt>
                <c:pt idx="408">
                  <c:v>1.590106007067135</c:v>
                </c:pt>
                <c:pt idx="409">
                  <c:v>-2.275769745649263</c:v>
                </c:pt>
                <c:pt idx="410">
                  <c:v>-1.09389243391065</c:v>
                </c:pt>
                <c:pt idx="411">
                  <c:v>2.110389610389606</c:v>
                </c:pt>
                <c:pt idx="412">
                  <c:v>-2.227934875749777</c:v>
                </c:pt>
                <c:pt idx="413">
                  <c:v>-0.649350649350647</c:v>
                </c:pt>
                <c:pt idx="414">
                  <c:v>-9.936908517350171</c:v>
                </c:pt>
                <c:pt idx="415">
                  <c:v>0.156201187128998</c:v>
                </c:pt>
                <c:pt idx="416">
                  <c:v>-1.634382566585975</c:v>
                </c:pt>
                <c:pt idx="417">
                  <c:v>-2.333333333333331</c:v>
                </c:pt>
                <c:pt idx="418">
                  <c:v>-0.113250283125713</c:v>
                </c:pt>
                <c:pt idx="419">
                  <c:v>-0.673400673400666</c:v>
                </c:pt>
                <c:pt idx="420">
                  <c:v>1.732991014120665</c:v>
                </c:pt>
                <c:pt idx="421">
                  <c:v>-2.79870828848223</c:v>
                </c:pt>
                <c:pt idx="422">
                  <c:v>0.649350649350647</c:v>
                </c:pt>
                <c:pt idx="423">
                  <c:v>-0.941377834831002</c:v>
                </c:pt>
                <c:pt idx="424">
                  <c:v>1.744820065430758</c:v>
                </c:pt>
                <c:pt idx="425">
                  <c:v>0.0304692260816802</c:v>
                </c:pt>
                <c:pt idx="426">
                  <c:v>3.218884120171686</c:v>
                </c:pt>
                <c:pt idx="427">
                  <c:v>-2.486910994764403</c:v>
                </c:pt>
                <c:pt idx="428">
                  <c:v>1.085481682496609</c:v>
                </c:pt>
                <c:pt idx="429">
                  <c:v>-1.528013582342964</c:v>
                </c:pt>
                <c:pt idx="430">
                  <c:v>0.493218249075205</c:v>
                </c:pt>
                <c:pt idx="431">
                  <c:v>0.981055480378875</c:v>
                </c:pt>
                <c:pt idx="432">
                  <c:v>2.702702702702705</c:v>
                </c:pt>
                <c:pt idx="433">
                  <c:v>-1.417525773195892</c:v>
                </c:pt>
                <c:pt idx="434">
                  <c:v>-5.912162162162188</c:v>
                </c:pt>
                <c:pt idx="435">
                  <c:v>-4.663774403470728</c:v>
                </c:pt>
                <c:pt idx="436">
                  <c:v>-2.198295199641092</c:v>
                </c:pt>
                <c:pt idx="437">
                  <c:v>-1.623376623376612</c:v>
                </c:pt>
                <c:pt idx="438">
                  <c:v>2.98850574712645</c:v>
                </c:pt>
                <c:pt idx="439">
                  <c:v>-1.132502831257086</c:v>
                </c:pt>
                <c:pt idx="440">
                  <c:v>3.810541310541299</c:v>
                </c:pt>
                <c:pt idx="441">
                  <c:v>-0.0984251968504104</c:v>
                </c:pt>
                <c:pt idx="442">
                  <c:v>1.46310432569976</c:v>
                </c:pt>
                <c:pt idx="443">
                  <c:v>-2.828282828282818</c:v>
                </c:pt>
                <c:pt idx="444">
                  <c:v>3.884462151394409</c:v>
                </c:pt>
                <c:pt idx="445">
                  <c:v>-0.442477876106205</c:v>
                </c:pt>
                <c:pt idx="446">
                  <c:v>-0.581395348837197</c:v>
                </c:pt>
                <c:pt idx="447">
                  <c:v>-2.059688944934857</c:v>
                </c:pt>
                <c:pt idx="448">
                  <c:v>-2.921953094963482</c:v>
                </c:pt>
                <c:pt idx="449">
                  <c:v>-2.272727272727272</c:v>
                </c:pt>
                <c:pt idx="450">
                  <c:v>1.241900647948174</c:v>
                </c:pt>
                <c:pt idx="451">
                  <c:v>-0.0437445319335035</c:v>
                </c:pt>
                <c:pt idx="452">
                  <c:v>0.139082058414474</c:v>
                </c:pt>
                <c:pt idx="453">
                  <c:v>-0.927197802197789</c:v>
                </c:pt>
                <c:pt idx="454">
                  <c:v>-4.285714285714283</c:v>
                </c:pt>
                <c:pt idx="455">
                  <c:v>-2.861445783132538</c:v>
                </c:pt>
                <c:pt idx="456">
                  <c:v>-3.532008830022062</c:v>
                </c:pt>
                <c:pt idx="457">
                  <c:v>0.0</c:v>
                </c:pt>
                <c:pt idx="458">
                  <c:v>-0.702426564495538</c:v>
                </c:pt>
                <c:pt idx="459">
                  <c:v>-3.475711892797305</c:v>
                </c:pt>
                <c:pt idx="460">
                  <c:v>-1.821862348178142</c:v>
                </c:pt>
                <c:pt idx="461">
                  <c:v>0.208768267223381</c:v>
                </c:pt>
                <c:pt idx="462">
                  <c:v>1.277955271565502</c:v>
                </c:pt>
                <c:pt idx="463">
                  <c:v>1.828231292517009</c:v>
                </c:pt>
                <c:pt idx="464">
                  <c:v>-0.935374149659863</c:v>
                </c:pt>
                <c:pt idx="465">
                  <c:v>-0.882352941176462</c:v>
                </c:pt>
                <c:pt idx="466">
                  <c:v>5.18080667593879</c:v>
                </c:pt>
                <c:pt idx="467">
                  <c:v>-1.539973787680218</c:v>
                </c:pt>
                <c:pt idx="468">
                  <c:v>0.282485875706209</c:v>
                </c:pt>
                <c:pt idx="469">
                  <c:v>2.43506493506491</c:v>
                </c:pt>
                <c:pt idx="470">
                  <c:v>2.413793103448274</c:v>
                </c:pt>
                <c:pt idx="471">
                  <c:v>-2.811366384522369</c:v>
                </c:pt>
                <c:pt idx="472">
                  <c:v>-1.242937853107334</c:v>
                </c:pt>
                <c:pt idx="473">
                  <c:v>-3.878942881500431</c:v>
                </c:pt>
                <c:pt idx="474">
                  <c:v>-0.969237252423088</c:v>
                </c:pt>
                <c:pt idx="475">
                  <c:v>-1.602564102564091</c:v>
                </c:pt>
                <c:pt idx="476">
                  <c:v>-0.980392156862742</c:v>
                </c:pt>
                <c:pt idx="477">
                  <c:v>-2.856135401974619</c:v>
                </c:pt>
                <c:pt idx="478">
                  <c:v>-2.700186219739284</c:v>
                </c:pt>
                <c:pt idx="479">
                  <c:v>-1.773533424283764</c:v>
                </c:pt>
                <c:pt idx="480">
                  <c:v>3.144654088050314</c:v>
                </c:pt>
                <c:pt idx="481">
                  <c:v>-8.868808567603753</c:v>
                </c:pt>
                <c:pt idx="482">
                  <c:v>-0.621118012422369</c:v>
                </c:pt>
                <c:pt idx="483">
                  <c:v>2.352941176470592</c:v>
                </c:pt>
                <c:pt idx="484">
                  <c:v>0.41841004184102</c:v>
                </c:pt>
                <c:pt idx="485">
                  <c:v>-2.586566541510203</c:v>
                </c:pt>
                <c:pt idx="486">
                  <c:v>3.962703962703948</c:v>
                </c:pt>
                <c:pt idx="487">
                  <c:v>-4.783393501805044</c:v>
                </c:pt>
                <c:pt idx="488">
                  <c:v>-0.126422250316075</c:v>
                </c:pt>
                <c:pt idx="489">
                  <c:v>-4.255319148936166</c:v>
                </c:pt>
                <c:pt idx="490">
                  <c:v>-1.993865030674842</c:v>
                </c:pt>
                <c:pt idx="491">
                  <c:v>-5.950095969289817</c:v>
                </c:pt>
                <c:pt idx="492">
                  <c:v>-5.773195876288661</c:v>
                </c:pt>
                <c:pt idx="493">
                  <c:v>-1.360544217687058</c:v>
                </c:pt>
                <c:pt idx="494">
                  <c:v>2.665706051873206</c:v>
                </c:pt>
                <c:pt idx="495">
                  <c:v>1.506916996047422</c:v>
                </c:pt>
                <c:pt idx="496">
                  <c:v>1.342773437499998</c:v>
                </c:pt>
                <c:pt idx="497">
                  <c:v>-1.925391095066187</c:v>
                </c:pt>
                <c:pt idx="498">
                  <c:v>2.599179206566352</c:v>
                </c:pt>
                <c:pt idx="499">
                  <c:v>-1.022604951560817</c:v>
                </c:pt>
                <c:pt idx="500">
                  <c:v>1.800554016620484</c:v>
                </c:pt>
                <c:pt idx="501">
                  <c:v>0.452488687782804</c:v>
                </c:pt>
                <c:pt idx="502">
                  <c:v>-0.134048257372639</c:v>
                </c:pt>
                <c:pt idx="503">
                  <c:v>0.0</c:v>
                </c:pt>
                <c:pt idx="504">
                  <c:v>-0.628930817610061</c:v>
                </c:pt>
                <c:pt idx="505">
                  <c:v>-0.730337078651692</c:v>
                </c:pt>
                <c:pt idx="506">
                  <c:v>-2.827918170878474</c:v>
                </c:pt>
                <c:pt idx="507">
                  <c:v>-0.753424657534252</c:v>
                </c:pt>
                <c:pt idx="508">
                  <c:v>-0.796178343949045</c:v>
                </c:pt>
                <c:pt idx="509">
                  <c:v>18.77022653721684</c:v>
                </c:pt>
                <c:pt idx="510">
                  <c:v>1.890756302521005</c:v>
                </c:pt>
                <c:pt idx="511">
                  <c:v>0.928792569659456</c:v>
                </c:pt>
                <c:pt idx="512">
                  <c:v>4.79632063074899</c:v>
                </c:pt>
                <c:pt idx="513">
                  <c:v>-5.766526019690603</c:v>
                </c:pt>
                <c:pt idx="514">
                  <c:v>-1.36125654450262</c:v>
                </c:pt>
                <c:pt idx="515">
                  <c:v>1.814058956916105</c:v>
                </c:pt>
                <c:pt idx="516">
                  <c:v>-2.74163568773235</c:v>
                </c:pt>
                <c:pt idx="517">
                  <c:v>2.093944538766248</c:v>
                </c:pt>
                <c:pt idx="518">
                  <c:v>-0.326797385620931</c:v>
                </c:pt>
                <c:pt idx="519">
                  <c:v>3.716216216216233</c:v>
                </c:pt>
                <c:pt idx="520">
                  <c:v>0.533807829181494</c:v>
                </c:pt>
                <c:pt idx="521">
                  <c:v>0.816582914572858</c:v>
                </c:pt>
                <c:pt idx="522">
                  <c:v>2.192982456140343</c:v>
                </c:pt>
                <c:pt idx="523">
                  <c:v>3.417266187050362</c:v>
                </c:pt>
                <c:pt idx="524">
                  <c:v>0.613695090439281</c:v>
                </c:pt>
                <c:pt idx="525">
                  <c:v>5.47945205479453</c:v>
                </c:pt>
                <c:pt idx="526">
                  <c:v>-0.724637681159418</c:v>
                </c:pt>
                <c:pt idx="527">
                  <c:v>0.202429149797554</c:v>
                </c:pt>
                <c:pt idx="528">
                  <c:v>1.933514246947084</c:v>
                </c:pt>
                <c:pt idx="529">
                  <c:v>-0.750625521267728</c:v>
                </c:pt>
                <c:pt idx="530">
                  <c:v>-2.964959568733162</c:v>
                </c:pt>
                <c:pt idx="531">
                  <c:v>-1.223776223776216</c:v>
                </c:pt>
                <c:pt idx="532">
                  <c:v>1.993534482758622</c:v>
                </c:pt>
                <c:pt idx="533">
                  <c:v>1.165980795610449</c:v>
                </c:pt>
                <c:pt idx="534">
                  <c:v>1.287688442211067</c:v>
                </c:pt>
                <c:pt idx="535">
                  <c:v>0.371747211895925</c:v>
                </c:pt>
                <c:pt idx="536">
                  <c:v>-3.846153846153876</c:v>
                </c:pt>
                <c:pt idx="537">
                  <c:v>3.436426116838497</c:v>
                </c:pt>
                <c:pt idx="538">
                  <c:v>-8.06223479490804</c:v>
                </c:pt>
                <c:pt idx="539">
                  <c:v>13.28320802005013</c:v>
                </c:pt>
                <c:pt idx="540">
                  <c:v>-0.628306878306882</c:v>
                </c:pt>
                <c:pt idx="541">
                  <c:v>-2.388535031847134</c:v>
                </c:pt>
                <c:pt idx="542">
                  <c:v>2.123142250530801</c:v>
                </c:pt>
                <c:pt idx="543">
                  <c:v>1.865671641791038</c:v>
                </c:pt>
                <c:pt idx="544">
                  <c:v>0.617283950617315</c:v>
                </c:pt>
                <c:pt idx="545">
                  <c:v>0.826446280991732</c:v>
                </c:pt>
                <c:pt idx="546">
                  <c:v>0.551267916207269</c:v>
                </c:pt>
                <c:pt idx="547">
                  <c:v>-7.20663265306123</c:v>
                </c:pt>
                <c:pt idx="548">
                  <c:v>0.203804347826095</c:v>
                </c:pt>
                <c:pt idx="549">
                  <c:v>-1.17891816920942</c:v>
                </c:pt>
                <c:pt idx="550">
                  <c:v>1.176808266360516</c:v>
                </c:pt>
                <c:pt idx="551">
                  <c:v>0.378787878787882</c:v>
                </c:pt>
                <c:pt idx="552">
                  <c:v>7.415902140672773</c:v>
                </c:pt>
                <c:pt idx="553">
                  <c:v>-4.973649538866935</c:v>
                </c:pt>
                <c:pt idx="554">
                  <c:v>0.578406169665809</c:v>
                </c:pt>
                <c:pt idx="555">
                  <c:v>-0.78125</c:v>
                </c:pt>
                <c:pt idx="556">
                  <c:v>0.280504908835911</c:v>
                </c:pt>
                <c:pt idx="557">
                  <c:v>3.399433427762043</c:v>
                </c:pt>
                <c:pt idx="558">
                  <c:v>3.290246768507652</c:v>
                </c:pt>
                <c:pt idx="559">
                  <c:v>-0.497512437810935</c:v>
                </c:pt>
                <c:pt idx="560">
                  <c:v>2.452153110047842</c:v>
                </c:pt>
                <c:pt idx="561">
                  <c:v>1.476014760147614</c:v>
                </c:pt>
                <c:pt idx="562">
                  <c:v>-1.204427083333348</c:v>
                </c:pt>
                <c:pt idx="563">
                  <c:v>-0.900900900900903</c:v>
                </c:pt>
                <c:pt idx="564">
                  <c:v>1.412066752246462</c:v>
                </c:pt>
                <c:pt idx="565">
                  <c:v>0.522466039707423</c:v>
                </c:pt>
                <c:pt idx="566">
                  <c:v>2.862849533954716</c:v>
                </c:pt>
                <c:pt idx="567">
                  <c:v>2.902374670184681</c:v>
                </c:pt>
                <c:pt idx="568">
                  <c:v>-0.578034682080933</c:v>
                </c:pt>
                <c:pt idx="569">
                  <c:v>1.524390243902457</c:v>
                </c:pt>
                <c:pt idx="570">
                  <c:v>3.436185133239824</c:v>
                </c:pt>
                <c:pt idx="571">
                  <c:v>4.354669464847836</c:v>
                </c:pt>
                <c:pt idx="572">
                  <c:v>-1.656626506024088</c:v>
                </c:pt>
                <c:pt idx="573">
                  <c:v>1.315789473684217</c:v>
                </c:pt>
                <c:pt idx="574">
                  <c:v>3.583061889250807</c:v>
                </c:pt>
                <c:pt idx="575">
                  <c:v>-0.57755775577558</c:v>
                </c:pt>
                <c:pt idx="576">
                  <c:v>-0.6371359223301</c:v>
                </c:pt>
                <c:pt idx="577">
                  <c:v>-4.147196261682224</c:v>
                </c:pt>
                <c:pt idx="578">
                  <c:v>-1.652119700748133</c:v>
                </c:pt>
                <c:pt idx="579">
                  <c:v>-0.146455770357362</c:v>
                </c:pt>
                <c:pt idx="580">
                  <c:v>-0.813008130081298</c:v>
                </c:pt>
                <c:pt idx="581">
                  <c:v>2.631578947368424</c:v>
                </c:pt>
                <c:pt idx="582">
                  <c:v>1.818181818181818</c:v>
                </c:pt>
                <c:pt idx="583">
                  <c:v>1.418205804749328</c:v>
                </c:pt>
                <c:pt idx="584">
                  <c:v>-1.697944593386944</c:v>
                </c:pt>
                <c:pt idx="585">
                  <c:v>1.518833535844476</c:v>
                </c:pt>
                <c:pt idx="586">
                  <c:v>2.001404494382024</c:v>
                </c:pt>
                <c:pt idx="587">
                  <c:v>-0.201612903225802</c:v>
                </c:pt>
                <c:pt idx="588">
                  <c:v>-3.339460784313716</c:v>
                </c:pt>
                <c:pt idx="589">
                  <c:v>0.789835164835178</c:v>
                </c:pt>
                <c:pt idx="590">
                  <c:v>0.889679715302504</c:v>
                </c:pt>
                <c:pt idx="591">
                  <c:v>-2.573529411764728</c:v>
                </c:pt>
                <c:pt idx="592">
                  <c:v>0.744416873449136</c:v>
                </c:pt>
                <c:pt idx="593">
                  <c:v>11.67763157894736</c:v>
                </c:pt>
                <c:pt idx="594">
                  <c:v>0.406504065040671</c:v>
                </c:pt>
                <c:pt idx="595">
                  <c:v>-4.702970297029696</c:v>
                </c:pt>
                <c:pt idx="596">
                  <c:v>-1.356350184956858</c:v>
                </c:pt>
                <c:pt idx="597">
                  <c:v>-0.843881856540093</c:v>
                </c:pt>
                <c:pt idx="598">
                  <c:v>-2.742749054224478</c:v>
                </c:pt>
                <c:pt idx="599">
                  <c:v>4.231625835189308</c:v>
                </c:pt>
                <c:pt idx="600">
                  <c:v>-0.134952766531711</c:v>
                </c:pt>
                <c:pt idx="601">
                  <c:v>2.27272727272727</c:v>
                </c:pt>
                <c:pt idx="602">
                  <c:v>-1.874340021119334</c:v>
                </c:pt>
                <c:pt idx="603">
                  <c:v>4.03364969801554</c:v>
                </c:pt>
                <c:pt idx="604">
                  <c:v>-3.295605858854866</c:v>
                </c:pt>
                <c:pt idx="605">
                  <c:v>0.961538461538464</c:v>
                </c:pt>
                <c:pt idx="606">
                  <c:v>1.274623406720743</c:v>
                </c:pt>
                <c:pt idx="607">
                  <c:v>-0.980392156862759</c:v>
                </c:pt>
                <c:pt idx="608">
                  <c:v>0.949094046591897</c:v>
                </c:pt>
                <c:pt idx="609">
                  <c:v>4.700854700854698</c:v>
                </c:pt>
                <c:pt idx="610">
                  <c:v>0.937499999999969</c:v>
                </c:pt>
                <c:pt idx="611">
                  <c:v>-2.972399150743088</c:v>
                </c:pt>
                <c:pt idx="612">
                  <c:v>-2.116402116402107</c:v>
                </c:pt>
                <c:pt idx="613">
                  <c:v>1.562500000000013</c:v>
                </c:pt>
                <c:pt idx="614">
                  <c:v>1.590909090909097</c:v>
                </c:pt>
                <c:pt idx="615">
                  <c:v>-1.854364540931694</c:v>
                </c:pt>
                <c:pt idx="616">
                  <c:v>-2.503293807641638</c:v>
                </c:pt>
                <c:pt idx="617">
                  <c:v>1.285347043701812</c:v>
                </c:pt>
                <c:pt idx="618">
                  <c:v>0.290613193839021</c:v>
                </c:pt>
                <c:pt idx="619">
                  <c:v>0.398936170212781</c:v>
                </c:pt>
                <c:pt idx="620">
                  <c:v>-3.000411015207571</c:v>
                </c:pt>
                <c:pt idx="621">
                  <c:v>0.483729111697455</c:v>
                </c:pt>
                <c:pt idx="622">
                  <c:v>5.99909788001803</c:v>
                </c:pt>
                <c:pt idx="623">
                  <c:v>-0.83539603960397</c:v>
                </c:pt>
                <c:pt idx="624">
                  <c:v>0.462962962962937</c:v>
                </c:pt>
                <c:pt idx="625">
                  <c:v>5.080409356725162</c:v>
                </c:pt>
                <c:pt idx="626">
                  <c:v>1.150202976995928</c:v>
                </c:pt>
                <c:pt idx="627">
                  <c:v>0.312500000000004</c:v>
                </c:pt>
                <c:pt idx="628">
                  <c:v>-2.691831683168297</c:v>
                </c:pt>
                <c:pt idx="629">
                  <c:v>-9.915891987605117</c:v>
                </c:pt>
                <c:pt idx="630">
                  <c:v>-4.118404118404134</c:v>
                </c:pt>
                <c:pt idx="631">
                  <c:v>-0.588482555695673</c:v>
                </c:pt>
                <c:pt idx="632">
                  <c:v>1.089588377723947</c:v>
                </c:pt>
                <c:pt idx="633">
                  <c:v>-1.552511415525109</c:v>
                </c:pt>
                <c:pt idx="634">
                  <c:v>-1.542056074766367</c:v>
                </c:pt>
                <c:pt idx="635">
                  <c:v>-4.171704957678338</c:v>
                </c:pt>
                <c:pt idx="636">
                  <c:v>-2.09481808158765</c:v>
                </c:pt>
                <c:pt idx="637">
                  <c:v>-4.989816700610975</c:v>
                </c:pt>
                <c:pt idx="638">
                  <c:v>-3.313253012048197</c:v>
                </c:pt>
                <c:pt idx="639">
                  <c:v>-2.116402116402099</c:v>
                </c:pt>
                <c:pt idx="640">
                  <c:v>-1.616266944734095</c:v>
                </c:pt>
                <c:pt idx="641">
                  <c:v>3.112175102599162</c:v>
                </c:pt>
                <c:pt idx="642">
                  <c:v>2.486559139784938</c:v>
                </c:pt>
                <c:pt idx="643">
                  <c:v>1.883561643835619</c:v>
                </c:pt>
                <c:pt idx="644">
                  <c:v>-0.934579439252328</c:v>
                </c:pt>
                <c:pt idx="645">
                  <c:v>-1.154891304347814</c:v>
                </c:pt>
                <c:pt idx="646">
                  <c:v>3.120978120978106</c:v>
                </c:pt>
                <c:pt idx="647">
                  <c:v>-1.202749140893476</c:v>
                </c:pt>
                <c:pt idx="648">
                  <c:v>4.783950617283966</c:v>
                </c:pt>
                <c:pt idx="649">
                  <c:v>1.024327784891175</c:v>
                </c:pt>
                <c:pt idx="650">
                  <c:v>-1.455026455026448</c:v>
                </c:pt>
                <c:pt idx="651">
                  <c:v>-9.298464092984604</c:v>
                </c:pt>
                <c:pt idx="652">
                  <c:v>5.295566502463028</c:v>
                </c:pt>
                <c:pt idx="653">
                  <c:v>-3.281519861830738</c:v>
                </c:pt>
                <c:pt idx="654">
                  <c:v>1.620370370370365</c:v>
                </c:pt>
                <c:pt idx="655">
                  <c:v>0.183823529411767</c:v>
                </c:pt>
                <c:pt idx="656">
                  <c:v>5.426765015806108</c:v>
                </c:pt>
                <c:pt idx="657">
                  <c:v>2.412280701754401</c:v>
                </c:pt>
                <c:pt idx="658">
                  <c:v>-6.12244897959182</c:v>
                </c:pt>
                <c:pt idx="659">
                  <c:v>-2.5</c:v>
                </c:pt>
                <c:pt idx="660">
                  <c:v>-1.551724137931044</c:v>
                </c:pt>
                <c:pt idx="661">
                  <c:v>-4.476950354609932</c:v>
                </c:pt>
                <c:pt idx="662">
                  <c:v>-0.548696844993154</c:v>
                </c:pt>
                <c:pt idx="663">
                  <c:v>2.346805736636253</c:v>
                </c:pt>
                <c:pt idx="664">
                  <c:v>-4.545454545454541</c:v>
                </c:pt>
                <c:pt idx="665">
                  <c:v>-2.04973118279571</c:v>
                </c:pt>
                <c:pt idx="666">
                  <c:v>1.262916188289312</c:v>
                </c:pt>
                <c:pt idx="667">
                  <c:v>-0.662251655629137</c:v>
                </c:pt>
                <c:pt idx="668">
                  <c:v>-0.534045393858467</c:v>
                </c:pt>
                <c:pt idx="669">
                  <c:v>-5.028462998102461</c:v>
                </c:pt>
                <c:pt idx="670">
                  <c:v>-1.502145922746787</c:v>
                </c:pt>
                <c:pt idx="671">
                  <c:v>-1.157894736842084</c:v>
                </c:pt>
                <c:pt idx="672">
                  <c:v>3.532277710109634</c:v>
                </c:pt>
                <c:pt idx="673">
                  <c:v>1.85185185185184</c:v>
                </c:pt>
                <c:pt idx="674">
                  <c:v>0.490196078431374</c:v>
                </c:pt>
                <c:pt idx="675">
                  <c:v>0.808314087759831</c:v>
                </c:pt>
                <c:pt idx="676">
                  <c:v>4.107648725212468</c:v>
                </c:pt>
                <c:pt idx="677">
                  <c:v>-2.403282532239169</c:v>
                </c:pt>
                <c:pt idx="678">
                  <c:v>2.569832402234645</c:v>
                </c:pt>
                <c:pt idx="679">
                  <c:v>3.584804708400238</c:v>
                </c:pt>
                <c:pt idx="680">
                  <c:v>2.423638778220453</c:v>
                </c:pt>
                <c:pt idx="681">
                  <c:v>-0.384193194291988</c:v>
                </c:pt>
                <c:pt idx="682">
                  <c:v>-1.627218934911243</c:v>
                </c:pt>
                <c:pt idx="683">
                  <c:v>0.110864745011068</c:v>
                </c:pt>
                <c:pt idx="684">
                  <c:v>0.177304964538993</c:v>
                </c:pt>
                <c:pt idx="685">
                  <c:v>3.366524419156006</c:v>
                </c:pt>
                <c:pt idx="686">
                  <c:v>2.666666666666669</c:v>
                </c:pt>
                <c:pt idx="687">
                  <c:v>2.684346701164312</c:v>
                </c:pt>
                <c:pt idx="688">
                  <c:v>-5.196182396606575</c:v>
                </c:pt>
                <c:pt idx="689">
                  <c:v>1.508916323731143</c:v>
                </c:pt>
                <c:pt idx="690">
                  <c:v>-2.850877192982458</c:v>
                </c:pt>
                <c:pt idx="691">
                  <c:v>-5.419580419580423</c:v>
                </c:pt>
                <c:pt idx="692">
                  <c:v>2.92164674634795</c:v>
                </c:pt>
                <c:pt idx="693">
                  <c:v>6.542397660818724</c:v>
                </c:pt>
                <c:pt idx="694">
                  <c:v>4.765013054830302</c:v>
                </c:pt>
                <c:pt idx="695">
                  <c:v>0.640113798008546</c:v>
                </c:pt>
                <c:pt idx="696">
                  <c:v>1.91507077435469</c:v>
                </c:pt>
                <c:pt idx="697">
                  <c:v>-1.083591331269354</c:v>
                </c:pt>
                <c:pt idx="698">
                  <c:v>0.636942675159233</c:v>
                </c:pt>
                <c:pt idx="699">
                  <c:v>0.419664268585134</c:v>
                </c:pt>
                <c:pt idx="700">
                  <c:v>-1.468788249693993</c:v>
                </c:pt>
                <c:pt idx="701">
                  <c:v>1.03448275862068</c:v>
                </c:pt>
                <c:pt idx="702">
                  <c:v>0.206611570247942</c:v>
                </c:pt>
                <c:pt idx="703">
                  <c:v>0.699300699300684</c:v>
                </c:pt>
                <c:pt idx="704">
                  <c:v>-5.116959064327476</c:v>
                </c:pt>
                <c:pt idx="705">
                  <c:v>2.3972602739726</c:v>
                </c:pt>
                <c:pt idx="706">
                  <c:v>0.0</c:v>
                </c:pt>
                <c:pt idx="707">
                  <c:v>-1.913988657845004</c:v>
                </c:pt>
                <c:pt idx="708">
                  <c:v>-0.639906922629433</c:v>
                </c:pt>
                <c:pt idx="709">
                  <c:v>1.150951748561325</c:v>
                </c:pt>
                <c:pt idx="710">
                  <c:v>-0.900900900900905</c:v>
                </c:pt>
                <c:pt idx="711">
                  <c:v>-3.10077519379844</c:v>
                </c:pt>
                <c:pt idx="712">
                  <c:v>-0.0534759358288854</c:v>
                </c:pt>
                <c:pt idx="713">
                  <c:v>2.726063829787247</c:v>
                </c:pt>
                <c:pt idx="714">
                  <c:v>0.0</c:v>
                </c:pt>
                <c:pt idx="715">
                  <c:v>0.0</c:v>
                </c:pt>
                <c:pt idx="716">
                  <c:v>-2.726715686274511</c:v>
                </c:pt>
                <c:pt idx="717">
                  <c:v>-0.411522633744833</c:v>
                </c:pt>
                <c:pt idx="718">
                  <c:v>3.735144312393892</c:v>
                </c:pt>
                <c:pt idx="719">
                  <c:v>5.337078651685394</c:v>
                </c:pt>
                <c:pt idx="720">
                  <c:v>4.081632653061221</c:v>
                </c:pt>
                <c:pt idx="721">
                  <c:v>#N/A</c:v>
                </c:pt>
                <c:pt idx="722">
                  <c:v>-1.581356637536438</c:v>
                </c:pt>
                <c:pt idx="723">
                  <c:v>-0.660883932259412</c:v>
                </c:pt>
                <c:pt idx="724">
                  <c:v>4.005167958656338</c:v>
                </c:pt>
                <c:pt idx="725">
                  <c:v>-0.350877192982461</c:v>
                </c:pt>
                <c:pt idx="726">
                  <c:v>-1.190476190476195</c:v>
                </c:pt>
                <c:pt idx="727">
                  <c:v>4.487179487179494</c:v>
                </c:pt>
                <c:pt idx="728">
                  <c:v>-1.894451962110945</c:v>
                </c:pt>
                <c:pt idx="729">
                  <c:v>1.876675603217153</c:v>
                </c:pt>
                <c:pt idx="730">
                  <c:v>0.620567375886515</c:v>
                </c:pt>
                <c:pt idx="731">
                  <c:v>5.723370429252773</c:v>
                </c:pt>
                <c:pt idx="732">
                  <c:v>-2.484472049689454</c:v>
                </c:pt>
                <c:pt idx="733">
                  <c:v>-0.856389986824751</c:v>
                </c:pt>
                <c:pt idx="734">
                  <c:v>0.666666666666664</c:v>
                </c:pt>
                <c:pt idx="735">
                  <c:v>1.523631840796004</c:v>
                </c:pt>
                <c:pt idx="736">
                  <c:v>15.3985507246377</c:v>
                </c:pt>
                <c:pt idx="737">
                  <c:v>-1.660280970625797</c:v>
                </c:pt>
                <c:pt idx="738">
                  <c:v>-4.595530374567208</c:v>
                </c:pt>
                <c:pt idx="739">
                  <c:v>1.406799531066835</c:v>
                </c:pt>
                <c:pt idx="740">
                  <c:v>1.652367333968865</c:v>
                </c:pt>
                <c:pt idx="741">
                  <c:v>1.056081573197375</c:v>
                </c:pt>
                <c:pt idx="742">
                  <c:v>-1.483050847457633</c:v>
                </c:pt>
                <c:pt idx="743">
                  <c:v>-5.295315682281062</c:v>
                </c:pt>
                <c:pt idx="744">
                  <c:v>-3.823529411764702</c:v>
                </c:pt>
                <c:pt idx="745">
                  <c:v>2.678571428571436</c:v>
                </c:pt>
                <c:pt idx="746">
                  <c:v>2.693602693602687</c:v>
                </c:pt>
                <c:pt idx="747">
                  <c:v>-0.277008310249314</c:v>
                </c:pt>
                <c:pt idx="748">
                  <c:v>-3.277378097521962</c:v>
                </c:pt>
                <c:pt idx="749">
                  <c:v>4.324097397145247</c:v>
                </c:pt>
                <c:pt idx="750">
                  <c:v>-0.447427293064875</c:v>
                </c:pt>
                <c:pt idx="751">
                  <c:v>-0.173611111111104</c:v>
                </c:pt>
                <c:pt idx="752">
                  <c:v>-0.562040639861636</c:v>
                </c:pt>
                <c:pt idx="753">
                  <c:v>0.801068090787712</c:v>
                </c:pt>
                <c:pt idx="754">
                  <c:v>-0.692840646651255</c:v>
                </c:pt>
                <c:pt idx="755">
                  <c:v>-1.840490797546016</c:v>
                </c:pt>
                <c:pt idx="756">
                  <c:v>0.728699551569501</c:v>
                </c:pt>
                <c:pt idx="757">
                  <c:v>3.117505995203834</c:v>
                </c:pt>
                <c:pt idx="758">
                  <c:v>0.45998160073598</c:v>
                </c:pt>
                <c:pt idx="759">
                  <c:v>0.662251655629137</c:v>
                </c:pt>
                <c:pt idx="760">
                  <c:v>-1.495016611295679</c:v>
                </c:pt>
                <c:pt idx="761">
                  <c:v>-0.198938992042448</c:v>
                </c:pt>
                <c:pt idx="762">
                  <c:v>4.634397528321314</c:v>
                </c:pt>
                <c:pt idx="763">
                  <c:v>2.673147023086256</c:v>
                </c:pt>
                <c:pt idx="764">
                  <c:v>1.35605006954102</c:v>
                </c:pt>
                <c:pt idx="765">
                  <c:v>-0.562040639861636</c:v>
                </c:pt>
                <c:pt idx="766">
                  <c:v>0.780234070221061</c:v>
                </c:pt>
                <c:pt idx="767">
                  <c:v>4.00132275132277</c:v>
                </c:pt>
                <c:pt idx="768">
                  <c:v>0.623813398426913</c:v>
                </c:pt>
                <c:pt idx="769">
                  <c:v>-2.429543245869783</c:v>
                </c:pt>
                <c:pt idx="770">
                  <c:v>-3.497409326424876</c:v>
                </c:pt>
                <c:pt idx="771">
                  <c:v>-1.285583103764915</c:v>
                </c:pt>
                <c:pt idx="772">
                  <c:v>0.318133616118752</c:v>
                </c:pt>
                <c:pt idx="773">
                  <c:v>1.047904191616771</c:v>
                </c:pt>
                <c:pt idx="774">
                  <c:v>-0.235531628532963</c:v>
                </c:pt>
                <c:pt idx="775">
                  <c:v>-0.388026607538828</c:v>
                </c:pt>
                <c:pt idx="776">
                  <c:v>-2.668089647812173</c:v>
                </c:pt>
                <c:pt idx="777">
                  <c:v>-0.293944738389179</c:v>
                </c:pt>
                <c:pt idx="778">
                  <c:v>3.174603174603176</c:v>
                </c:pt>
                <c:pt idx="779">
                  <c:v>-5.298759864712514</c:v>
                </c:pt>
                <c:pt idx="780">
                  <c:v>-4.505076142131974</c:v>
                </c:pt>
                <c:pt idx="781">
                  <c:v>-1.190476190476186</c:v>
                </c:pt>
                <c:pt idx="782">
                  <c:v>1.056338028168992</c:v>
                </c:pt>
                <c:pt idx="783">
                  <c:v>-0.453955901426709</c:v>
                </c:pt>
                <c:pt idx="784">
                  <c:v>-1.822323462414584</c:v>
                </c:pt>
                <c:pt idx="785">
                  <c:v>-2.62843488649939</c:v>
                </c:pt>
                <c:pt idx="786">
                  <c:v>1.092896174863401</c:v>
                </c:pt>
                <c:pt idx="787">
                  <c:v>-1.580459770114955</c:v>
                </c:pt>
                <c:pt idx="788">
                  <c:v>0.0411861614497476</c:v>
                </c:pt>
                <c:pt idx="789">
                  <c:v>4.477611940298509</c:v>
                </c:pt>
                <c:pt idx="790">
                  <c:v>-4.525032092426199</c:v>
                </c:pt>
                <c:pt idx="791">
                  <c:v>6.521739130434784</c:v>
                </c:pt>
                <c:pt idx="792">
                  <c:v>-0.739957716701883</c:v>
                </c:pt>
                <c:pt idx="793">
                  <c:v>#N/A</c:v>
                </c:pt>
                <c:pt idx="794">
                  <c:v>0.550055005500554</c:v>
                </c:pt>
                <c:pt idx="795">
                  <c:v>-3.723887375113546</c:v>
                </c:pt>
                <c:pt idx="796">
                  <c:v>-3.143712574850291</c:v>
                </c:pt>
                <c:pt idx="797">
                  <c:v>0.779967159277495</c:v>
                </c:pt>
                <c:pt idx="798">
                  <c:v>-0.833333333333341</c:v>
                </c:pt>
                <c:pt idx="799">
                  <c:v>0.717703349282268</c:v>
                </c:pt>
                <c:pt idx="800">
                  <c:v>-0.838926174496656</c:v>
                </c:pt>
                <c:pt idx="801">
                  <c:v>-0.934579439252317</c:v>
                </c:pt>
                <c:pt idx="802">
                  <c:v>2.619047619047623</c:v>
                </c:pt>
                <c:pt idx="803">
                  <c:v>2.878787878787866</c:v>
                </c:pt>
                <c:pt idx="804">
                  <c:v>-2.805836139169477</c:v>
                </c:pt>
                <c:pt idx="805">
                  <c:v>0.335195530726274</c:v>
                </c:pt>
                <c:pt idx="806">
                  <c:v>3.782505910165484</c:v>
                </c:pt>
                <c:pt idx="807">
                  <c:v>0.460122699386499</c:v>
                </c:pt>
                <c:pt idx="808">
                  <c:v>-1.242787394585003</c:v>
                </c:pt>
                <c:pt idx="809">
                  <c:v>2.819237147595355</c:v>
                </c:pt>
                <c:pt idx="810">
                  <c:v>5.409356725146212</c:v>
                </c:pt>
                <c:pt idx="811">
                  <c:v>3.274559193954658</c:v>
                </c:pt>
                <c:pt idx="812">
                  <c:v>4.80349344978167</c:v>
                </c:pt>
                <c:pt idx="813">
                  <c:v>-0.051975051975049</c:v>
                </c:pt>
                <c:pt idx="814">
                  <c:v>11.3970588235294</c:v>
                </c:pt>
                <c:pt idx="815">
                  <c:v>-0.704225352112694</c:v>
                </c:pt>
                <c:pt idx="816">
                  <c:v>0.910245554614711</c:v>
                </c:pt>
                <c:pt idx="817">
                  <c:v>-0.226757369614524</c:v>
                </c:pt>
                <c:pt idx="818">
                  <c:v>1.160602258469274</c:v>
                </c:pt>
                <c:pt idx="819">
                  <c:v>2.800953516090599</c:v>
                </c:pt>
                <c:pt idx="820">
                  <c:v>4.614695340501787</c:v>
                </c:pt>
                <c:pt idx="821">
                  <c:v>-1.570680628272237</c:v>
                </c:pt>
                <c:pt idx="822">
                  <c:v>0.0515995872032829</c:v>
                </c:pt>
                <c:pt idx="823">
                  <c:v>-1.535380507343127</c:v>
                </c:pt>
                <c:pt idx="824">
                  <c:v>0.424592391304338</c:v>
                </c:pt>
                <c:pt idx="825">
                  <c:v>-1.529636711281083</c:v>
                </c:pt>
                <c:pt idx="826">
                  <c:v>-2.012808783165597</c:v>
                </c:pt>
                <c:pt idx="827">
                  <c:v>4.018369690011472</c:v>
                </c:pt>
                <c:pt idx="828">
                  <c:v>-1.446280991735532</c:v>
                </c:pt>
                <c:pt idx="829">
                  <c:v>2.9723991507431</c:v>
                </c:pt>
                <c:pt idx="830">
                  <c:v>-2.146892655367242</c:v>
                </c:pt>
                <c:pt idx="831">
                  <c:v>-0.322580645161295</c:v>
                </c:pt>
                <c:pt idx="832">
                  <c:v>-1.408450704225356</c:v>
                </c:pt>
                <c:pt idx="833">
                  <c:v>-3.025477707006356</c:v>
                </c:pt>
                <c:pt idx="834">
                  <c:v>-4.424398625429546</c:v>
                </c:pt>
                <c:pt idx="835">
                  <c:v>-0.773195876288655</c:v>
                </c:pt>
                <c:pt idx="836">
                  <c:v>-9.320477502295686</c:v>
                </c:pt>
                <c:pt idx="837">
                  <c:v>1.157082748948113</c:v>
                </c:pt>
                <c:pt idx="838">
                  <c:v>5.888376856118795</c:v>
                </c:pt>
                <c:pt idx="839">
                  <c:v>-2.541436464088406</c:v>
                </c:pt>
                <c:pt idx="840">
                  <c:v>4.987293519695034</c:v>
                </c:pt>
                <c:pt idx="841">
                  <c:v>2.253401360544196</c:v>
                </c:pt>
                <c:pt idx="842">
                  <c:v>0.847457627118644</c:v>
                </c:pt>
                <c:pt idx="843">
                  <c:v>0.102564102564097</c:v>
                </c:pt>
                <c:pt idx="844">
                  <c:v>-2.28215767634854</c:v>
                </c:pt>
                <c:pt idx="845">
                  <c:v>-3.340184994861239</c:v>
                </c:pt>
                <c:pt idx="846">
                  <c:v>2.317290552584662</c:v>
                </c:pt>
                <c:pt idx="847">
                  <c:v>1.075268817204297</c:v>
                </c:pt>
                <c:pt idx="848">
                  <c:v>-0.673400673400655</c:v>
                </c:pt>
                <c:pt idx="849">
                  <c:v>-1.921132457027277</c:v>
                </c:pt>
                <c:pt idx="850">
                  <c:v>6.770833333333308</c:v>
                </c:pt>
                <c:pt idx="851">
                  <c:v>7.368753953194203</c:v>
                </c:pt>
                <c:pt idx="852">
                  <c:v>0.961538461538472</c:v>
                </c:pt>
                <c:pt idx="853">
                  <c:v>-2.9709228824273</c:v>
                </c:pt>
                <c:pt idx="854">
                  <c:v>-1.072705601907035</c:v>
                </c:pt>
                <c:pt idx="855">
                  <c:v>-0.219298245614025</c:v>
                </c:pt>
                <c:pt idx="856">
                  <c:v>0.242382271468133</c:v>
                </c:pt>
                <c:pt idx="857">
                  <c:v>5.629139072847668</c:v>
                </c:pt>
                <c:pt idx="858">
                  <c:v>-2.56518082422204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6192104"/>
        <c:axId val="2116142248"/>
      </c:scatterChart>
      <c:valAx>
        <c:axId val="2116192104"/>
        <c:scaling>
          <c:orientation val="minMax"/>
          <c:max val="855.0"/>
          <c:min val="0.0"/>
        </c:scaling>
        <c:delete val="0"/>
        <c:axPos val="b"/>
        <c:majorTickMark val="out"/>
        <c:minorTickMark val="none"/>
        <c:tickLblPos val="nextTo"/>
        <c:spPr>
          <a:solidFill>
            <a:srgbClr val="FFFF00"/>
          </a:solidFill>
        </c:spPr>
        <c:txPr>
          <a:bodyPr/>
          <a:lstStyle/>
          <a:p>
            <a:pPr>
              <a:defRPr b="1" i="0">
                <a:solidFill>
                  <a:srgbClr val="0000FF"/>
                </a:solidFill>
                <a:latin typeface="Arial"/>
              </a:defRPr>
            </a:pPr>
            <a:endParaRPr lang="en-US"/>
          </a:p>
        </c:txPr>
        <c:crossAx val="2116142248"/>
        <c:crosses val="autoZero"/>
        <c:crossBetween val="midCat"/>
      </c:valAx>
      <c:valAx>
        <c:axId val="2116142248"/>
        <c:scaling>
          <c:orientation val="minMax"/>
          <c:max val="10.0"/>
          <c:min val="-1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0" i="0">
                <a:latin typeface="Arial"/>
              </a:defRPr>
            </a:pPr>
            <a:endParaRPr lang="en-US"/>
          </a:p>
        </c:txPr>
        <c:crossAx val="211619210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B9DD7D-542A-4447-952C-C926B21CC355}" type="datetimeFigureOut">
              <a:rPr kumimoji="1" lang="ja-JP" altLang="en-US" smtClean="0"/>
              <a:t>20/01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B8083D-D0F1-7641-9703-0795C19C0D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29830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531CA6-8472-F045-87B1-B955CDCDD070}" type="datetimeFigureOut">
              <a:rPr lang="en-US" smtClean="0"/>
              <a:t>20/01/18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43C585-3AA0-034F-BBF6-79EBEAABBB5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6239534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FontTx/>
              <a:buNone/>
            </a:pP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8608CBC-A4C5-F54E-AD33-9CC34E1032F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3725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FontTx/>
              <a:buNone/>
            </a:pP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43C585-3AA0-034F-BBF6-79EBEAABBB57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72411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endParaRPr kumimoji="1" lang="ja-JP" altLang="en-US" sz="1200" dirty="0">
              <a:latin typeface="MS PGothic" charset="-128"/>
              <a:ea typeface="MS PGothic" charset="-128"/>
              <a:cs typeface="MS PGothic" charset="-128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43C585-3AA0-034F-BBF6-79EBEAABBB57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68236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E2F25-15D9-724D-A502-655D2D6A4B86}" type="datetime1">
              <a:rPr lang="ja-JP" altLang="en-US" smtClean="0"/>
              <a:t>20/01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4475A-9A00-4546-A101-AEDF80008D6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7172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DE9EC-408F-564D-8BD2-2AA2203CFBA6}" type="datetime1">
              <a:rPr lang="ja-JP" altLang="en-US" smtClean="0"/>
              <a:t>20/01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4475A-9A00-4546-A101-AEDF80008D6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7247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66F61-A2D4-2B42-9ACA-759DF539290F}" type="datetime1">
              <a:rPr lang="ja-JP" altLang="en-US" smtClean="0"/>
              <a:t>20/01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4475A-9A00-4546-A101-AEDF80008D6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7783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317BE-A8B0-F947-9D89-FDA8A7172416}" type="datetime1">
              <a:rPr lang="ja-JP" altLang="en-US" smtClean="0"/>
              <a:t>20/01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4475A-9A00-4546-A101-AEDF80008D6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3863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B1A97-3944-F64F-8BA7-9BB43FCD282B}" type="datetime1">
              <a:rPr lang="ja-JP" altLang="en-US" smtClean="0"/>
              <a:t>20/01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4475A-9A00-4546-A101-AEDF80008D6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107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F4035-871A-3447-AE54-E855B251AC4F}" type="datetime1">
              <a:rPr lang="ja-JP" altLang="en-US" smtClean="0"/>
              <a:t>20/01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4475A-9A00-4546-A101-AEDF80008D6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578591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DFA15-CFB2-6B4B-AB25-C37A804E8738}" type="datetime1">
              <a:rPr lang="ja-JP" altLang="en-US" smtClean="0"/>
              <a:t>20/01/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4475A-9A00-4546-A101-AEDF80008D6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4423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ADCF6-CD3F-6143-88F4-D7CD160C6C76}" type="datetime1">
              <a:rPr lang="ja-JP" altLang="en-US" smtClean="0"/>
              <a:t>20/01/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4475A-9A00-4546-A101-AEDF80008D6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2698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BDF24-2092-A549-8FFC-D0F1DEE1CBBE}" type="datetime1">
              <a:rPr lang="ja-JP" altLang="en-US" smtClean="0"/>
              <a:t>20/01/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4475A-9A00-4546-A101-AEDF80008D6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1856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DBB32-452C-B446-9D6F-E77342C21860}" type="datetime1">
              <a:rPr lang="ja-JP" altLang="en-US" smtClean="0"/>
              <a:t>20/01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4475A-9A00-4546-A101-AEDF80008D6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5318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45927-472E-FE4C-8846-7FD84EE64B72}" type="datetime1">
              <a:rPr lang="ja-JP" altLang="en-US" smtClean="0"/>
              <a:t>20/01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4475A-9A00-4546-A101-AEDF80008D6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3547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6DF5C8-583C-8D44-99C5-696ED84434DA}" type="datetime1">
              <a:rPr lang="ja-JP" altLang="en-US" smtClean="0"/>
              <a:t>20/01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D4475A-9A00-4546-A101-AEDF80008D6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0734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microsoft.com/office/2007/relationships/hdphoto" Target="../media/hdphoto1.wdp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4" Type="http://schemas.openxmlformats.org/officeDocument/2006/relationships/image" Target="../media/image6.jpeg"/><Relationship Id="rId5" Type="http://schemas.openxmlformats.org/officeDocument/2006/relationships/image" Target="../media/image7.jpeg"/><Relationship Id="rId6" Type="http://schemas.openxmlformats.org/officeDocument/2006/relationships/image" Target="../media/image8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5347" y="63309"/>
            <a:ext cx="934076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l Figure </a:t>
            </a:r>
            <a:r>
              <a:rPr lang="en-US" sz="1200" b="1" dirty="0" smtClean="0">
                <a:latin typeface="Times New Roman"/>
                <a:cs typeface="Times New Roman"/>
              </a:rPr>
              <a:t>1: </a:t>
            </a:r>
            <a:endParaRPr lang="en-US" sz="1200" b="1" dirty="0">
              <a:latin typeface="Times New Roman"/>
              <a:cs typeface="Times New Roman"/>
            </a:endParaRPr>
          </a:p>
          <a:p>
            <a:r>
              <a:rPr lang="en-US" sz="1200" b="1" dirty="0" smtClean="0">
                <a:latin typeface="Times New Roman"/>
                <a:cs typeface="Times New Roman"/>
              </a:rPr>
              <a:t>Evaluation </a:t>
            </a:r>
            <a:r>
              <a:rPr lang="en-US" sz="1200" b="1" dirty="0">
                <a:latin typeface="Times New Roman"/>
                <a:cs typeface="Times New Roman"/>
              </a:rPr>
              <a:t>of internal dose effects for those who were internally exposed</a:t>
            </a:r>
            <a:endParaRPr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4475A-9A00-4546-A101-AEDF80008D61}" type="slidenum">
              <a:rPr lang="en-US" smtClean="0"/>
              <a:t>1</a:t>
            </a:fld>
            <a:endParaRPr lang="en-US" dirty="0"/>
          </a:p>
        </p:txBody>
      </p:sp>
      <p:grpSp>
        <p:nvGrpSpPr>
          <p:cNvPr id="22" name="図形グループ 9"/>
          <p:cNvGrpSpPr/>
          <p:nvPr/>
        </p:nvGrpSpPr>
        <p:grpSpPr>
          <a:xfrm>
            <a:off x="2605944" y="1563198"/>
            <a:ext cx="3749404" cy="3263191"/>
            <a:chOff x="5573820" y="1637809"/>
            <a:chExt cx="2553669" cy="2630828"/>
          </a:xfrm>
        </p:grpSpPr>
        <p:grpSp>
          <p:nvGrpSpPr>
            <p:cNvPr id="23" name="図形グループ 105"/>
            <p:cNvGrpSpPr/>
            <p:nvPr/>
          </p:nvGrpSpPr>
          <p:grpSpPr>
            <a:xfrm>
              <a:off x="5573820" y="1637809"/>
              <a:ext cx="2553669" cy="2630828"/>
              <a:chOff x="3331990" y="1038634"/>
              <a:chExt cx="2721377" cy="2223775"/>
            </a:xfrm>
          </p:grpSpPr>
          <p:sp>
            <p:nvSpPr>
              <p:cNvPr id="31" name="TextBox 55"/>
              <p:cNvSpPr txBox="1"/>
              <p:nvPr/>
            </p:nvSpPr>
            <p:spPr>
              <a:xfrm>
                <a:off x="3730994" y="3073642"/>
                <a:ext cx="2201648" cy="1887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/>
                    <a:cs typeface="Times New Roman"/>
                  </a:rPr>
                  <a:t>Bone marrow dose by I-131 inhalation (</a:t>
                </a:r>
                <a:r>
                  <a:rPr lang="en-US" sz="1200" dirty="0" err="1" smtClean="0">
                    <a:latin typeface="Times New Roman"/>
                    <a:cs typeface="Times New Roman"/>
                  </a:rPr>
                  <a:t>mSv</a:t>
                </a:r>
                <a:r>
                  <a:rPr lang="en-US" sz="1200" dirty="0" smtClean="0">
                    <a:latin typeface="Times New Roman"/>
                    <a:cs typeface="Times New Roman"/>
                  </a:rPr>
                  <a:t>)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  <p:pic>
            <p:nvPicPr>
              <p:cNvPr id="32" name="図 122" descr="RM.jpg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27844" y="1148202"/>
                <a:ext cx="2525523" cy="1864126"/>
              </a:xfrm>
              <a:prstGeom prst="rect">
                <a:avLst/>
              </a:prstGeom>
            </p:spPr>
          </p:pic>
          <p:grpSp>
            <p:nvGrpSpPr>
              <p:cNvPr id="33" name="図形グループ 123"/>
              <p:cNvGrpSpPr/>
              <p:nvPr/>
            </p:nvGrpSpPr>
            <p:grpSpPr>
              <a:xfrm>
                <a:off x="3645172" y="2720016"/>
                <a:ext cx="1944060" cy="294022"/>
                <a:chOff x="411030" y="2320148"/>
                <a:chExt cx="1731227" cy="294022"/>
              </a:xfrm>
            </p:grpSpPr>
            <p:sp>
              <p:nvSpPr>
                <p:cNvPr id="40" name="TextBox 50"/>
                <p:cNvSpPr txBox="1"/>
                <p:nvPr/>
              </p:nvSpPr>
              <p:spPr>
                <a:xfrm>
                  <a:off x="411030" y="2320148"/>
                  <a:ext cx="172552" cy="18876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/>
                      <a:cs typeface="Times New Roman"/>
                    </a:rPr>
                    <a:t>0</a:t>
                  </a:r>
                  <a:endParaRPr lang="en-US" sz="1200" dirty="0"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41" name="TextBox 43"/>
                <p:cNvSpPr txBox="1"/>
                <p:nvPr/>
              </p:nvSpPr>
              <p:spPr>
                <a:xfrm>
                  <a:off x="1275327" y="2425403"/>
                  <a:ext cx="274063" cy="18876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smtClean="0">
                      <a:latin typeface="Times New Roman"/>
                      <a:cs typeface="Times New Roman"/>
                    </a:rPr>
                    <a:t>10</a:t>
                  </a:r>
                  <a:r>
                    <a:rPr lang="en-US" sz="1200" baseline="30000" dirty="0" smtClean="0">
                      <a:latin typeface="Times New Roman"/>
                      <a:cs typeface="Times New Roman"/>
                    </a:rPr>
                    <a:t>-1</a:t>
                  </a:r>
                  <a:endParaRPr lang="en-US" sz="1200" baseline="30000" dirty="0"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42" name="TextBox 44"/>
                <p:cNvSpPr txBox="1"/>
                <p:nvPr/>
              </p:nvSpPr>
              <p:spPr>
                <a:xfrm>
                  <a:off x="706152" y="2425403"/>
                  <a:ext cx="276848" cy="18876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smtClean="0">
                      <a:latin typeface="Times New Roman"/>
                      <a:cs typeface="Times New Roman"/>
                    </a:rPr>
                    <a:t>10</a:t>
                  </a:r>
                  <a:r>
                    <a:rPr lang="en-US" sz="1200" baseline="30000" dirty="0" smtClean="0">
                      <a:latin typeface="Times New Roman"/>
                      <a:cs typeface="Times New Roman"/>
                    </a:rPr>
                    <a:t>-2</a:t>
                  </a:r>
                  <a:endParaRPr lang="en-US" sz="1200" baseline="30000" dirty="0"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43" name="TextBox 47"/>
                <p:cNvSpPr txBox="1"/>
                <p:nvPr/>
              </p:nvSpPr>
              <p:spPr>
                <a:xfrm>
                  <a:off x="1890276" y="2417707"/>
                  <a:ext cx="251981" cy="18876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smtClean="0">
                      <a:latin typeface="Times New Roman"/>
                      <a:cs typeface="Times New Roman"/>
                    </a:rPr>
                    <a:t>10</a:t>
                  </a:r>
                  <a:r>
                    <a:rPr lang="en-US" sz="1200" baseline="30000" dirty="0" smtClean="0">
                      <a:latin typeface="Times New Roman"/>
                      <a:cs typeface="Times New Roman"/>
                    </a:rPr>
                    <a:t>0</a:t>
                  </a:r>
                  <a:endParaRPr lang="en-US" sz="1200" baseline="30000" dirty="0">
                    <a:latin typeface="Times New Roman"/>
                    <a:cs typeface="Times New Roman"/>
                  </a:endParaRPr>
                </a:p>
              </p:txBody>
            </p:sp>
          </p:grpSp>
          <p:grpSp>
            <p:nvGrpSpPr>
              <p:cNvPr id="34" name="図形グループ 124"/>
              <p:cNvGrpSpPr/>
              <p:nvPr/>
            </p:nvGrpSpPr>
            <p:grpSpPr>
              <a:xfrm>
                <a:off x="3527844" y="1206427"/>
                <a:ext cx="321036" cy="1178642"/>
                <a:chOff x="512764" y="1055293"/>
                <a:chExt cx="390634" cy="1178642"/>
              </a:xfrm>
              <a:solidFill>
                <a:schemeClr val="bg1"/>
              </a:solidFill>
            </p:grpSpPr>
            <p:sp>
              <p:nvSpPr>
                <p:cNvPr id="37" name="TextBox 51"/>
                <p:cNvSpPr txBox="1"/>
                <p:nvPr/>
              </p:nvSpPr>
              <p:spPr>
                <a:xfrm>
                  <a:off x="568861" y="2045168"/>
                  <a:ext cx="334536" cy="188767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/>
                      <a:cs typeface="Times New Roman"/>
                    </a:rPr>
                    <a:t>40</a:t>
                  </a:r>
                  <a:endParaRPr lang="en-US" sz="1200" dirty="0"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38" name="TextBox 52"/>
                <p:cNvSpPr txBox="1"/>
                <p:nvPr/>
              </p:nvSpPr>
              <p:spPr>
                <a:xfrm>
                  <a:off x="575502" y="1559092"/>
                  <a:ext cx="327896" cy="188767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/>
                      <a:cs typeface="Times New Roman"/>
                    </a:rPr>
                    <a:t>80</a:t>
                  </a:r>
                  <a:endParaRPr lang="en-US" sz="1200" dirty="0"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39" name="TextBox 53"/>
                <p:cNvSpPr txBox="1"/>
                <p:nvPr/>
              </p:nvSpPr>
              <p:spPr>
                <a:xfrm>
                  <a:off x="512764" y="1055293"/>
                  <a:ext cx="381746" cy="188767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/>
                      <a:cs typeface="Times New Roman"/>
                    </a:rPr>
                    <a:t>120</a:t>
                  </a:r>
                  <a:endParaRPr lang="en-US" sz="1200" dirty="0">
                    <a:latin typeface="Times New Roman"/>
                    <a:cs typeface="Times New Roman"/>
                  </a:endParaRPr>
                </a:p>
              </p:txBody>
            </p:sp>
          </p:grpSp>
          <p:sp>
            <p:nvSpPr>
              <p:cNvPr id="35" name="TextBox 54"/>
              <p:cNvSpPr txBox="1"/>
              <p:nvPr/>
            </p:nvSpPr>
            <p:spPr>
              <a:xfrm rot="16200000">
                <a:off x="2948121" y="1924445"/>
                <a:ext cx="968787" cy="201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/>
                    <a:cs typeface="Times New Roman"/>
                  </a:rPr>
                  <a:t>Number of Workers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36" name="TextBox 49"/>
              <p:cNvSpPr txBox="1"/>
              <p:nvPr/>
            </p:nvSpPr>
            <p:spPr>
              <a:xfrm>
                <a:off x="4259902" y="1038634"/>
                <a:ext cx="1269250" cy="1887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/>
                    <a:cs typeface="Times New Roman"/>
                  </a:rPr>
                  <a:t>Log (bone marrow dose )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</p:grpSp>
        <p:sp>
          <p:nvSpPr>
            <p:cNvPr id="24" name="正方形/長方形 132"/>
            <p:cNvSpPr/>
            <p:nvPr/>
          </p:nvSpPr>
          <p:spPr>
            <a:xfrm>
              <a:off x="6041370" y="3759938"/>
              <a:ext cx="110617" cy="85886"/>
            </a:xfrm>
            <a:prstGeom prst="rect">
              <a:avLst/>
            </a:prstGeom>
            <a:ln>
              <a:noFill/>
            </a:ln>
            <a:effectLst/>
          </p:spPr>
          <p:style>
            <a:lnRef idx="1">
              <a:schemeClr val="accent1"/>
            </a:lnRef>
            <a:fillRef idx="1001">
              <a:schemeClr val="l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Times New Roman"/>
                <a:cs typeface="Times New Roman"/>
              </a:endParaRPr>
            </a:p>
          </p:txBody>
        </p:sp>
        <p:sp>
          <p:nvSpPr>
            <p:cNvPr id="25" name="正方形/長方形 135"/>
            <p:cNvSpPr/>
            <p:nvPr/>
          </p:nvSpPr>
          <p:spPr>
            <a:xfrm>
              <a:off x="6642502" y="3768399"/>
              <a:ext cx="110617" cy="85886"/>
            </a:xfrm>
            <a:prstGeom prst="rect">
              <a:avLst/>
            </a:prstGeom>
            <a:ln>
              <a:noFill/>
            </a:ln>
            <a:effectLst/>
          </p:spPr>
          <p:style>
            <a:lnRef idx="1">
              <a:schemeClr val="accent1"/>
            </a:lnRef>
            <a:fillRef idx="1001">
              <a:schemeClr val="l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Times New Roman"/>
                <a:cs typeface="Times New Roman"/>
              </a:endParaRPr>
            </a:p>
          </p:txBody>
        </p:sp>
        <p:sp>
          <p:nvSpPr>
            <p:cNvPr id="26" name="正方形/長方形 136"/>
            <p:cNvSpPr/>
            <p:nvPr/>
          </p:nvSpPr>
          <p:spPr>
            <a:xfrm>
              <a:off x="7836305" y="3759934"/>
              <a:ext cx="110617" cy="85886"/>
            </a:xfrm>
            <a:prstGeom prst="rect">
              <a:avLst/>
            </a:prstGeom>
            <a:ln>
              <a:noFill/>
            </a:ln>
            <a:effectLst/>
          </p:spPr>
          <p:style>
            <a:lnRef idx="1">
              <a:schemeClr val="accent1"/>
            </a:lnRef>
            <a:fillRef idx="1001">
              <a:schemeClr val="l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Times New Roman"/>
                <a:cs typeface="Times New Roman"/>
              </a:endParaRPr>
            </a:p>
          </p:txBody>
        </p:sp>
        <p:sp>
          <p:nvSpPr>
            <p:cNvPr id="27" name="正方形/長方形 139"/>
            <p:cNvSpPr/>
            <p:nvPr/>
          </p:nvSpPr>
          <p:spPr>
            <a:xfrm>
              <a:off x="7243638" y="3759931"/>
              <a:ext cx="110617" cy="85886"/>
            </a:xfrm>
            <a:prstGeom prst="rect">
              <a:avLst/>
            </a:prstGeom>
            <a:ln>
              <a:noFill/>
            </a:ln>
            <a:effectLst/>
          </p:spPr>
          <p:style>
            <a:lnRef idx="1">
              <a:schemeClr val="accent1"/>
            </a:lnRef>
            <a:fillRef idx="1001">
              <a:schemeClr val="l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Times New Roman"/>
                <a:cs typeface="Times New Roman"/>
              </a:endParaRPr>
            </a:p>
          </p:txBody>
        </p:sp>
        <p:sp>
          <p:nvSpPr>
            <p:cNvPr id="28" name="正方形/長方形 140"/>
            <p:cNvSpPr/>
            <p:nvPr/>
          </p:nvSpPr>
          <p:spPr>
            <a:xfrm>
              <a:off x="5948235" y="3370471"/>
              <a:ext cx="110617" cy="85886"/>
            </a:xfrm>
            <a:prstGeom prst="rect">
              <a:avLst/>
            </a:prstGeom>
            <a:ln>
              <a:noFill/>
            </a:ln>
            <a:effectLst/>
          </p:spPr>
          <p:style>
            <a:lnRef idx="1">
              <a:schemeClr val="accent1"/>
            </a:lnRef>
            <a:fillRef idx="1001">
              <a:schemeClr val="l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Times New Roman"/>
                <a:cs typeface="Times New Roman"/>
              </a:endParaRPr>
            </a:p>
          </p:txBody>
        </p:sp>
        <p:sp>
          <p:nvSpPr>
            <p:cNvPr id="29" name="正方形/長方形 141"/>
            <p:cNvSpPr/>
            <p:nvPr/>
          </p:nvSpPr>
          <p:spPr>
            <a:xfrm>
              <a:off x="5948234" y="2803201"/>
              <a:ext cx="110617" cy="85886"/>
            </a:xfrm>
            <a:prstGeom prst="rect">
              <a:avLst/>
            </a:prstGeom>
            <a:ln>
              <a:noFill/>
            </a:ln>
            <a:effectLst/>
          </p:spPr>
          <p:style>
            <a:lnRef idx="1">
              <a:schemeClr val="accent1"/>
            </a:lnRef>
            <a:fillRef idx="1001">
              <a:schemeClr val="l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Times New Roman"/>
                <a:cs typeface="Times New Roman"/>
              </a:endParaRPr>
            </a:p>
          </p:txBody>
        </p:sp>
        <p:sp>
          <p:nvSpPr>
            <p:cNvPr id="30" name="正方形/長方形 142"/>
            <p:cNvSpPr/>
            <p:nvPr/>
          </p:nvSpPr>
          <p:spPr>
            <a:xfrm>
              <a:off x="5948233" y="2210532"/>
              <a:ext cx="110617" cy="85886"/>
            </a:xfrm>
            <a:prstGeom prst="rect">
              <a:avLst/>
            </a:prstGeom>
            <a:ln>
              <a:noFill/>
            </a:ln>
            <a:effectLst/>
          </p:spPr>
          <p:style>
            <a:lnRef idx="1">
              <a:schemeClr val="accent1"/>
            </a:lnRef>
            <a:fillRef idx="1001">
              <a:schemeClr val="l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Times New Roman"/>
                <a:cs typeface="Times New Roman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567716" y="5427979"/>
            <a:ext cx="60371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"/>
                <a:cs typeface="Times"/>
              </a:rPr>
              <a:t>Histogram </a:t>
            </a:r>
            <a:r>
              <a:rPr lang="en-US" sz="1200" dirty="0">
                <a:latin typeface="Times"/>
                <a:cs typeface="Times"/>
              </a:rPr>
              <a:t>of bone marrow dose due to inhalation of I-131. </a:t>
            </a:r>
            <a:endParaRPr lang="en-US" sz="1200" dirty="0" smtClean="0">
              <a:latin typeface="Times"/>
              <a:cs typeface="Times"/>
            </a:endParaRPr>
          </a:p>
          <a:p>
            <a:r>
              <a:rPr lang="en-US" sz="1200" dirty="0" smtClean="0">
                <a:latin typeface="Times"/>
                <a:cs typeface="Times"/>
              </a:rPr>
              <a:t>BM</a:t>
            </a:r>
            <a:r>
              <a:rPr lang="en-US" sz="1200" dirty="0">
                <a:latin typeface="Times"/>
                <a:cs typeface="Times"/>
              </a:rPr>
              <a:t>: Bone marrow. Bone marrow doses are shown in logarithmically from 10</a:t>
            </a:r>
            <a:r>
              <a:rPr lang="en-US" sz="1200" baseline="30000" dirty="0">
                <a:latin typeface="Times"/>
                <a:cs typeface="Times"/>
              </a:rPr>
              <a:t>-2 </a:t>
            </a:r>
            <a:r>
              <a:rPr lang="en-US" sz="1200" dirty="0" err="1">
                <a:latin typeface="Times"/>
                <a:cs typeface="Times"/>
              </a:rPr>
              <a:t>mGy</a:t>
            </a:r>
            <a:r>
              <a:rPr lang="en-US" sz="1200" dirty="0">
                <a:latin typeface="Times"/>
                <a:cs typeface="Times"/>
              </a:rPr>
              <a:t> to 1 </a:t>
            </a:r>
            <a:r>
              <a:rPr lang="en-US" sz="1200" dirty="0" err="1">
                <a:latin typeface="Times"/>
                <a:cs typeface="Times"/>
              </a:rPr>
              <a:t>mGy</a:t>
            </a:r>
            <a:r>
              <a:rPr lang="en-US" sz="1200" dirty="0" smtClean="0">
                <a:latin typeface="Times"/>
                <a:cs typeface="Times"/>
              </a:rPr>
              <a:t>.</a:t>
            </a:r>
            <a:endParaRPr lang="ja-JP" altLang="en-US" sz="1200" dirty="0"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31533441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TextBox 31"/>
          <p:cNvSpPr txBox="1"/>
          <p:nvPr/>
        </p:nvSpPr>
        <p:spPr>
          <a:xfrm>
            <a:off x="104393" y="3003079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B</a:t>
            </a:r>
            <a:endParaRPr lang="en-US" dirty="0">
              <a:latin typeface="Times New Roman"/>
              <a:cs typeface="Times New Roman"/>
            </a:endParaRPr>
          </a:p>
        </p:txBody>
      </p:sp>
      <p:grpSp>
        <p:nvGrpSpPr>
          <p:cNvPr id="186" name="図形グループ 185"/>
          <p:cNvGrpSpPr/>
          <p:nvPr/>
        </p:nvGrpSpPr>
        <p:grpSpPr>
          <a:xfrm>
            <a:off x="550309" y="765199"/>
            <a:ext cx="3762699" cy="2308869"/>
            <a:chOff x="2696010" y="3834994"/>
            <a:chExt cx="4052217" cy="2560549"/>
          </a:xfrm>
        </p:grpSpPr>
        <p:pic>
          <p:nvPicPr>
            <p:cNvPr id="187" name="図 186" descr="スクリーンショット 2015-04-21 15.29.28.png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65" t="3571" r="926" b="4810"/>
            <a:stretch/>
          </p:blipFill>
          <p:spPr>
            <a:xfrm>
              <a:off x="3171942" y="4167446"/>
              <a:ext cx="3448526" cy="1755494"/>
            </a:xfrm>
            <a:prstGeom prst="rect">
              <a:avLst/>
            </a:prstGeom>
          </p:spPr>
        </p:pic>
        <p:sp>
          <p:nvSpPr>
            <p:cNvPr id="188" name="TextBox 102"/>
            <p:cNvSpPr txBox="1"/>
            <p:nvPr/>
          </p:nvSpPr>
          <p:spPr>
            <a:xfrm>
              <a:off x="3550560" y="3834994"/>
              <a:ext cx="25219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/>
                  <a:cs typeface="Times New Roman"/>
                </a:rPr>
                <a:t>External and Internal exposure for Hb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189" name="TextBox 100"/>
            <p:cNvSpPr txBox="1"/>
            <p:nvPr/>
          </p:nvSpPr>
          <p:spPr>
            <a:xfrm>
              <a:off x="5196712" y="4396945"/>
              <a:ext cx="796832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Smoking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90" name="TextBox 101"/>
            <p:cNvSpPr txBox="1"/>
            <p:nvPr/>
          </p:nvSpPr>
          <p:spPr>
            <a:xfrm>
              <a:off x="3498912" y="4431187"/>
              <a:ext cx="651353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BM dose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91" name="TextBox 105"/>
            <p:cNvSpPr txBox="1"/>
            <p:nvPr/>
          </p:nvSpPr>
          <p:spPr>
            <a:xfrm>
              <a:off x="3528771" y="5558970"/>
              <a:ext cx="6809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*P=0.019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92" name="TextBox 106"/>
            <p:cNvSpPr txBox="1"/>
            <p:nvPr/>
          </p:nvSpPr>
          <p:spPr>
            <a:xfrm>
              <a:off x="5777738" y="5544251"/>
              <a:ext cx="6809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*P=0.026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93" name="TextBox 107"/>
            <p:cNvSpPr txBox="1"/>
            <p:nvPr/>
          </p:nvSpPr>
          <p:spPr>
            <a:xfrm rot="16200000">
              <a:off x="2432334" y="4864281"/>
              <a:ext cx="8043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/>
                  <a:cs typeface="Times New Roman"/>
                </a:rPr>
                <a:t>Hb (g/dL)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194" name="TextBox 108"/>
            <p:cNvSpPr txBox="1"/>
            <p:nvPr/>
          </p:nvSpPr>
          <p:spPr>
            <a:xfrm>
              <a:off x="5106330" y="6118544"/>
              <a:ext cx="12529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/>
                  <a:cs typeface="Times New Roman"/>
                </a:rPr>
                <a:t>(Cigarettes / day)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195" name="TextBox 109"/>
            <p:cNvSpPr txBox="1"/>
            <p:nvPr/>
          </p:nvSpPr>
          <p:spPr>
            <a:xfrm>
              <a:off x="3850345" y="6095850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/>
                  <a:cs typeface="Times New Roman"/>
                </a:rPr>
                <a:t>(mSv)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196" name="TextBox 112"/>
            <p:cNvSpPr txBox="1"/>
            <p:nvPr/>
          </p:nvSpPr>
          <p:spPr>
            <a:xfrm>
              <a:off x="3398332" y="5928019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4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97" name="TextBox 113"/>
            <p:cNvSpPr txBox="1"/>
            <p:nvPr/>
          </p:nvSpPr>
          <p:spPr>
            <a:xfrm>
              <a:off x="4113539" y="5932704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12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98" name="TextBox 114"/>
            <p:cNvSpPr txBox="1"/>
            <p:nvPr/>
          </p:nvSpPr>
          <p:spPr>
            <a:xfrm>
              <a:off x="3777542" y="5932913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8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199" name="TextBox 115"/>
            <p:cNvSpPr txBox="1"/>
            <p:nvPr/>
          </p:nvSpPr>
          <p:spPr>
            <a:xfrm>
              <a:off x="4488298" y="5922731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16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00" name="TextBox 116"/>
            <p:cNvSpPr txBox="1"/>
            <p:nvPr/>
          </p:nvSpPr>
          <p:spPr>
            <a:xfrm>
              <a:off x="4815035" y="5922731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01" name="TextBox 117"/>
            <p:cNvSpPr txBox="1"/>
            <p:nvPr/>
          </p:nvSpPr>
          <p:spPr>
            <a:xfrm>
              <a:off x="5587984" y="5922731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2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02" name="TextBox 118"/>
            <p:cNvSpPr txBox="1"/>
            <p:nvPr/>
          </p:nvSpPr>
          <p:spPr>
            <a:xfrm>
              <a:off x="5164315" y="5922731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1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03" name="TextBox 119"/>
            <p:cNvSpPr txBox="1"/>
            <p:nvPr/>
          </p:nvSpPr>
          <p:spPr>
            <a:xfrm>
              <a:off x="6009370" y="5922731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3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04" name="TextBox 120"/>
            <p:cNvSpPr txBox="1"/>
            <p:nvPr/>
          </p:nvSpPr>
          <p:spPr>
            <a:xfrm>
              <a:off x="6435321" y="5922731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4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05" name="TextBox 121"/>
            <p:cNvSpPr txBox="1"/>
            <p:nvPr/>
          </p:nvSpPr>
          <p:spPr>
            <a:xfrm>
              <a:off x="3085868" y="5922731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06" name="TextBox 38"/>
            <p:cNvSpPr txBox="1"/>
            <p:nvPr/>
          </p:nvSpPr>
          <p:spPr>
            <a:xfrm>
              <a:off x="2927734" y="5755800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15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07" name="TextBox 39"/>
            <p:cNvSpPr txBox="1"/>
            <p:nvPr/>
          </p:nvSpPr>
          <p:spPr>
            <a:xfrm>
              <a:off x="2917835" y="4891445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16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08" name="TextBox 48"/>
            <p:cNvSpPr txBox="1"/>
            <p:nvPr/>
          </p:nvSpPr>
          <p:spPr>
            <a:xfrm>
              <a:off x="2929431" y="4070667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17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209" name="直線コネクタ 208"/>
            <p:cNvCxnSpPr/>
            <p:nvPr/>
          </p:nvCxnSpPr>
          <p:spPr>
            <a:xfrm flipV="1">
              <a:off x="3231866" y="5065725"/>
              <a:ext cx="1689902" cy="576000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210" name="直線コネクタ 209"/>
            <p:cNvCxnSpPr/>
            <p:nvPr/>
          </p:nvCxnSpPr>
          <p:spPr>
            <a:xfrm flipV="1">
              <a:off x="4910981" y="5002945"/>
              <a:ext cx="1685011" cy="484765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sp>
          <p:nvSpPr>
            <p:cNvPr id="211" name="正方形/長方形 210"/>
            <p:cNvSpPr/>
            <p:nvPr/>
          </p:nvSpPr>
          <p:spPr>
            <a:xfrm>
              <a:off x="3157654" y="4143355"/>
              <a:ext cx="45719" cy="1763662"/>
            </a:xfrm>
            <a:prstGeom prst="rect">
              <a:avLst/>
            </a:prstGeom>
            <a:ln>
              <a:noFill/>
            </a:ln>
            <a:effectLst/>
          </p:spPr>
          <p:style>
            <a:lnRef idx="1">
              <a:schemeClr val="accent1"/>
            </a:lnRef>
            <a:fillRef idx="1001">
              <a:schemeClr val="l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Times New Roman"/>
                <a:cs typeface="Times New Roman"/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117837" y="42395"/>
            <a:ext cx="870132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lemental Figure 2: </a:t>
            </a:r>
          </a:p>
          <a:p>
            <a:r>
              <a:rPr lang="en-US" sz="1200" b="1" dirty="0" smtClean="0">
                <a:latin typeface="Times New Roman"/>
                <a:cs typeface="Times New Roman"/>
              </a:rPr>
              <a:t>Evaluation </a:t>
            </a:r>
            <a:r>
              <a:rPr lang="en-US" sz="1200" b="1" dirty="0">
                <a:latin typeface="Times New Roman"/>
                <a:cs typeface="Times New Roman"/>
              </a:rPr>
              <a:t>of external and internal dose </a:t>
            </a:r>
            <a:r>
              <a:rPr lang="en-US" sz="1200" b="1" dirty="0" smtClean="0">
                <a:latin typeface="Times New Roman"/>
                <a:cs typeface="Times New Roman"/>
              </a:rPr>
              <a:t>effect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s</a:t>
            </a:r>
            <a:r>
              <a:rPr lang="en-US" sz="1200" b="1" dirty="0" smtClean="0">
                <a:latin typeface="Times New Roman"/>
                <a:cs typeface="Times New Roman"/>
              </a:rPr>
              <a:t> </a:t>
            </a:r>
            <a:r>
              <a:rPr lang="en-US" sz="1200" b="1" dirty="0">
                <a:latin typeface="Times New Roman"/>
                <a:cs typeface="Times New Roman"/>
              </a:rPr>
              <a:t>on the </a:t>
            </a:r>
            <a:r>
              <a:rPr lang="en-US" sz="1200" b="1" dirty="0" smtClean="0">
                <a:latin typeface="Times New Roman"/>
                <a:cs typeface="Times New Roman"/>
              </a:rPr>
              <a:t>correlations between </a:t>
            </a:r>
            <a:r>
              <a:rPr lang="en-US" sz="1200" b="1" dirty="0">
                <a:latin typeface="Times New Roman"/>
                <a:cs typeface="Times New Roman"/>
              </a:rPr>
              <a:t>blood cells with bone marrow </a:t>
            </a:r>
            <a:r>
              <a:rPr lang="en-US" sz="1200" b="1" dirty="0" smtClean="0">
                <a:latin typeface="Times New Roman"/>
                <a:cs typeface="Times New Roman"/>
              </a:rPr>
              <a:t>dose </a:t>
            </a:r>
            <a:r>
              <a:rPr lang="en-US" sz="1200" b="1" dirty="0">
                <a:latin typeface="Times New Roman"/>
                <a:cs typeface="Times New Roman"/>
              </a:rPr>
              <a:t>or smoking</a:t>
            </a:r>
            <a:endParaRPr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88" name="TextBox 31"/>
          <p:cNvSpPr txBox="1"/>
          <p:nvPr/>
        </p:nvSpPr>
        <p:spPr>
          <a:xfrm>
            <a:off x="83864" y="475883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A</a:t>
            </a:r>
          </a:p>
        </p:txBody>
      </p:sp>
      <p:grpSp>
        <p:nvGrpSpPr>
          <p:cNvPr id="87" name="図形グループ 2"/>
          <p:cNvGrpSpPr/>
          <p:nvPr/>
        </p:nvGrpSpPr>
        <p:grpSpPr>
          <a:xfrm>
            <a:off x="460532" y="3235272"/>
            <a:ext cx="5512980" cy="2116129"/>
            <a:chOff x="1274404" y="432160"/>
            <a:chExt cx="6863658" cy="2887203"/>
          </a:xfrm>
        </p:grpSpPr>
        <p:sp>
          <p:nvSpPr>
            <p:cNvPr id="89" name="TextBox 126"/>
            <p:cNvSpPr txBox="1"/>
            <p:nvPr/>
          </p:nvSpPr>
          <p:spPr>
            <a:xfrm>
              <a:off x="3751960" y="432160"/>
              <a:ext cx="23865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/>
                  <a:ea typeface="Helvetica" charset="0"/>
                  <a:cs typeface="Times New Roman"/>
                </a:rPr>
                <a:t>External + Internal</a:t>
              </a:r>
              <a:r>
                <a:rPr lang="en-US" sz="1200" dirty="0" smtClean="0">
                  <a:latin typeface="Times New Roman"/>
                  <a:ea typeface="Helvetica" charset="0"/>
                  <a:cs typeface="Times New Roman"/>
                </a:rPr>
                <a:t> exposure for Hb</a:t>
              </a:r>
              <a:endParaRPr lang="en-US" sz="1200" dirty="0">
                <a:latin typeface="Times New Roman"/>
                <a:ea typeface="Helvetica" charset="0"/>
                <a:cs typeface="Times New Roman"/>
              </a:endParaRPr>
            </a:p>
          </p:txBody>
        </p:sp>
        <p:grpSp>
          <p:nvGrpSpPr>
            <p:cNvPr id="90" name="図形グループ 69"/>
            <p:cNvGrpSpPr/>
            <p:nvPr/>
          </p:nvGrpSpPr>
          <p:grpSpPr>
            <a:xfrm>
              <a:off x="1274404" y="678079"/>
              <a:ext cx="6863658" cy="2641284"/>
              <a:chOff x="1288485" y="529820"/>
              <a:chExt cx="6863658" cy="2641284"/>
            </a:xfrm>
          </p:grpSpPr>
          <p:pic>
            <p:nvPicPr>
              <p:cNvPr id="94" name="図 72" descr="スクリーンショット 2015-04-21 15.41.00.png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50000"/>
                        </a14:imgEffect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47" b="3933"/>
              <a:stretch/>
            </p:blipFill>
            <p:spPr>
              <a:xfrm>
                <a:off x="1860987" y="637637"/>
                <a:ext cx="6168862" cy="2124434"/>
              </a:xfrm>
              <a:prstGeom prst="rect">
                <a:avLst/>
              </a:prstGeom>
            </p:spPr>
          </p:pic>
          <p:sp>
            <p:nvSpPr>
              <p:cNvPr id="95" name="TextBox 124"/>
              <p:cNvSpPr txBox="1"/>
              <p:nvPr/>
            </p:nvSpPr>
            <p:spPr>
              <a:xfrm>
                <a:off x="4183662" y="750184"/>
                <a:ext cx="911800" cy="33593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Smoking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96" name="TextBox 125"/>
              <p:cNvSpPr txBox="1"/>
              <p:nvPr/>
            </p:nvSpPr>
            <p:spPr>
              <a:xfrm>
                <a:off x="2177222" y="750184"/>
                <a:ext cx="916737" cy="33593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BM dose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97" name="TextBox 127"/>
              <p:cNvSpPr txBox="1"/>
              <p:nvPr/>
            </p:nvSpPr>
            <p:spPr>
              <a:xfrm>
                <a:off x="2264759" y="2360540"/>
                <a:ext cx="6809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ea typeface="Helvetica" charset="0"/>
                    <a:cs typeface="Times New Roman"/>
                  </a:rPr>
                  <a:t>*P=0.026</a:t>
                </a:r>
                <a:endParaRPr lang="en-US" sz="1000" dirty="0">
                  <a:latin typeface="Times New Roman"/>
                  <a:ea typeface="Helvetica" charset="0"/>
                  <a:cs typeface="Times New Roman"/>
                </a:endParaRPr>
              </a:p>
            </p:txBody>
          </p:sp>
          <p:sp>
            <p:nvSpPr>
              <p:cNvPr id="98" name="TextBox 128"/>
              <p:cNvSpPr txBox="1"/>
              <p:nvPr/>
            </p:nvSpPr>
            <p:spPr>
              <a:xfrm>
                <a:off x="6078964" y="2328224"/>
                <a:ext cx="6809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ea typeface="Helvetica" charset="0"/>
                    <a:cs typeface="Times New Roman"/>
                  </a:rPr>
                  <a:t>*P=0.013</a:t>
                </a:r>
                <a:endParaRPr lang="en-US" sz="1000" dirty="0">
                  <a:latin typeface="Times New Roman"/>
                  <a:ea typeface="Helvetica" charset="0"/>
                  <a:cs typeface="Times New Roman"/>
                </a:endParaRPr>
              </a:p>
            </p:txBody>
          </p:sp>
          <p:sp>
            <p:nvSpPr>
              <p:cNvPr id="99" name="TextBox 129"/>
              <p:cNvSpPr txBox="1"/>
              <p:nvPr/>
            </p:nvSpPr>
            <p:spPr>
              <a:xfrm>
                <a:off x="6325290" y="750184"/>
                <a:ext cx="1394920" cy="33593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Drinking </a:t>
                </a:r>
                <a:r>
                  <a:rPr lang="en-US" sz="1000" dirty="0">
                    <a:latin typeface="Times New Roman"/>
                    <a:cs typeface="Times New Roman"/>
                  </a:rPr>
                  <a:t>Freq. </a:t>
                </a:r>
              </a:p>
            </p:txBody>
          </p:sp>
          <p:sp>
            <p:nvSpPr>
              <p:cNvPr id="100" name="TextBox 130"/>
              <p:cNvSpPr txBox="1"/>
              <p:nvPr/>
            </p:nvSpPr>
            <p:spPr>
              <a:xfrm>
                <a:off x="4191834" y="2328224"/>
                <a:ext cx="8870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ea typeface="Helvetica" charset="0"/>
                    <a:cs typeface="Times New Roman"/>
                  </a:rPr>
                  <a:t>***P=0.0012</a:t>
                </a:r>
                <a:endParaRPr lang="en-US" sz="1000" dirty="0">
                  <a:latin typeface="Times New Roman"/>
                  <a:ea typeface="Helvetica" charset="0"/>
                  <a:cs typeface="Times New Roman"/>
                </a:endParaRPr>
              </a:p>
            </p:txBody>
          </p:sp>
          <p:sp>
            <p:nvSpPr>
              <p:cNvPr id="101" name="TextBox 139"/>
              <p:cNvSpPr txBox="1"/>
              <p:nvPr/>
            </p:nvSpPr>
            <p:spPr>
              <a:xfrm>
                <a:off x="4344711" y="2894105"/>
                <a:ext cx="12529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/>
                    <a:cs typeface="Times New Roman"/>
                  </a:rPr>
                  <a:t>(Cigarettes / day)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02" name="TextBox 140"/>
              <p:cNvSpPr txBox="1"/>
              <p:nvPr/>
            </p:nvSpPr>
            <p:spPr>
              <a:xfrm>
                <a:off x="2777717" y="2894105"/>
                <a:ext cx="5693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/>
                    <a:cs typeface="Times New Roman"/>
                  </a:rPr>
                  <a:t>(mSv)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03" name="TextBox 141"/>
              <p:cNvSpPr txBox="1"/>
              <p:nvPr/>
            </p:nvSpPr>
            <p:spPr>
              <a:xfrm>
                <a:off x="2276725" y="2745564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4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04" name="TextBox 142"/>
              <p:cNvSpPr txBox="1"/>
              <p:nvPr/>
            </p:nvSpPr>
            <p:spPr>
              <a:xfrm>
                <a:off x="3085269" y="2745564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12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05" name="TextBox 143"/>
              <p:cNvSpPr txBox="1"/>
              <p:nvPr/>
            </p:nvSpPr>
            <p:spPr>
              <a:xfrm>
                <a:off x="2722308" y="2745564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8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06" name="TextBox 144"/>
              <p:cNvSpPr txBox="1"/>
              <p:nvPr/>
            </p:nvSpPr>
            <p:spPr>
              <a:xfrm>
                <a:off x="3537134" y="2745564"/>
                <a:ext cx="4607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16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07" name="TextBox 145"/>
              <p:cNvSpPr txBox="1"/>
              <p:nvPr/>
            </p:nvSpPr>
            <p:spPr>
              <a:xfrm>
                <a:off x="3906682" y="2732683"/>
                <a:ext cx="2559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08" name="TextBox 146"/>
              <p:cNvSpPr txBox="1"/>
              <p:nvPr/>
            </p:nvSpPr>
            <p:spPr>
              <a:xfrm>
                <a:off x="4794241" y="2732683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2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09" name="TextBox 147"/>
              <p:cNvSpPr txBox="1"/>
              <p:nvPr/>
            </p:nvSpPr>
            <p:spPr>
              <a:xfrm>
                <a:off x="4318092" y="2732683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1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10" name="TextBox 148"/>
              <p:cNvSpPr txBox="1"/>
              <p:nvPr/>
            </p:nvSpPr>
            <p:spPr>
              <a:xfrm>
                <a:off x="5303543" y="2732683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3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11" name="TextBox 149"/>
              <p:cNvSpPr txBox="1"/>
              <p:nvPr/>
            </p:nvSpPr>
            <p:spPr>
              <a:xfrm>
                <a:off x="5753567" y="2732683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4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12" name="TextBox 150"/>
              <p:cNvSpPr txBox="1"/>
              <p:nvPr/>
            </p:nvSpPr>
            <p:spPr>
              <a:xfrm>
                <a:off x="1897789" y="2745564"/>
                <a:ext cx="2559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13" name="TextBox 151"/>
              <p:cNvSpPr txBox="1"/>
              <p:nvPr/>
            </p:nvSpPr>
            <p:spPr>
              <a:xfrm>
                <a:off x="7003491" y="2727072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6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14" name="TextBox 152"/>
              <p:cNvSpPr txBox="1"/>
              <p:nvPr/>
            </p:nvSpPr>
            <p:spPr>
              <a:xfrm>
                <a:off x="6182611" y="2727072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2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15" name="TextBox 153"/>
              <p:cNvSpPr txBox="1"/>
              <p:nvPr/>
            </p:nvSpPr>
            <p:spPr>
              <a:xfrm>
                <a:off x="7407305" y="2727072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Times New Roman"/>
                    <a:cs typeface="Times New Roman"/>
                  </a:rPr>
                  <a:t>8</a:t>
                </a:r>
                <a:r>
                  <a:rPr lang="en-US" sz="1000" dirty="0" smtClean="0">
                    <a:latin typeface="Times New Roman"/>
                    <a:cs typeface="Times New Roman"/>
                  </a:rPr>
                  <a:t>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16" name="TextBox 155"/>
              <p:cNvSpPr txBox="1"/>
              <p:nvPr/>
            </p:nvSpPr>
            <p:spPr>
              <a:xfrm>
                <a:off x="6586425" y="2727072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4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17" name="TextBox 156"/>
              <p:cNvSpPr txBox="1"/>
              <p:nvPr/>
            </p:nvSpPr>
            <p:spPr>
              <a:xfrm>
                <a:off x="7771362" y="2727072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cs typeface="Times New Roman"/>
                  </a:rPr>
                  <a:t>100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18" name="TextBox 157"/>
              <p:cNvSpPr txBox="1"/>
              <p:nvPr/>
            </p:nvSpPr>
            <p:spPr>
              <a:xfrm>
                <a:off x="6175303" y="2894105"/>
                <a:ext cx="16336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/>
                    <a:cs typeface="Times New Roman"/>
                  </a:rPr>
                  <a:t>(D</a:t>
                </a:r>
                <a:r>
                  <a:rPr lang="en-US" altLang="ja-JP" sz="1200" dirty="0" smtClean="0">
                    <a:latin typeface="Times New Roman"/>
                    <a:cs typeface="Times New Roman"/>
                  </a:rPr>
                  <a:t>rinking unit / month</a:t>
                </a:r>
                <a:r>
                  <a:rPr lang="en-US" sz="1200" dirty="0" smtClean="0">
                    <a:latin typeface="Times New Roman"/>
                    <a:cs typeface="Times New Roman"/>
                  </a:rPr>
                  <a:t>)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19" name="TextBox 131"/>
              <p:cNvSpPr txBox="1"/>
              <p:nvPr/>
            </p:nvSpPr>
            <p:spPr>
              <a:xfrm rot="16200000">
                <a:off x="1024809" y="1625438"/>
                <a:ext cx="8043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/>
                    <a:cs typeface="Times New Roman"/>
                  </a:rPr>
                  <a:t>Hb (g/dL)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20" name="正方形/長方形 1"/>
              <p:cNvSpPr/>
              <p:nvPr/>
            </p:nvSpPr>
            <p:spPr>
              <a:xfrm>
                <a:off x="1811417" y="561904"/>
                <a:ext cx="155586" cy="220016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>
                  <a:latin typeface="Times New Roman"/>
                  <a:cs typeface="Times New Roman"/>
                </a:endParaRPr>
              </a:p>
            </p:txBody>
          </p:sp>
          <p:sp>
            <p:nvSpPr>
              <p:cNvPr id="121" name="TextBox 133"/>
              <p:cNvSpPr txBox="1"/>
              <p:nvPr/>
            </p:nvSpPr>
            <p:spPr>
              <a:xfrm>
                <a:off x="1631235" y="2103881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ea typeface="Helvetica" charset="0"/>
                    <a:cs typeface="Times New Roman"/>
                  </a:rPr>
                  <a:t>15</a:t>
                </a:r>
                <a:endParaRPr lang="en-US" sz="1000" dirty="0">
                  <a:latin typeface="Times New Roman"/>
                  <a:ea typeface="Helvetica" charset="0"/>
                  <a:cs typeface="Times New Roman"/>
                </a:endParaRPr>
              </a:p>
            </p:txBody>
          </p:sp>
          <p:sp>
            <p:nvSpPr>
              <p:cNvPr id="122" name="TextBox 134"/>
              <p:cNvSpPr txBox="1"/>
              <p:nvPr/>
            </p:nvSpPr>
            <p:spPr>
              <a:xfrm>
                <a:off x="1632819" y="1303597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ea typeface="Helvetica" charset="0"/>
                    <a:cs typeface="Times New Roman"/>
                  </a:rPr>
                  <a:t>16</a:t>
                </a:r>
                <a:endParaRPr lang="en-US" sz="1000" dirty="0">
                  <a:latin typeface="Times New Roman"/>
                  <a:ea typeface="Helvetica" charset="0"/>
                  <a:cs typeface="Times New Roman"/>
                </a:endParaRPr>
              </a:p>
            </p:txBody>
          </p:sp>
          <p:sp>
            <p:nvSpPr>
              <p:cNvPr id="123" name="TextBox 135"/>
              <p:cNvSpPr txBox="1"/>
              <p:nvPr/>
            </p:nvSpPr>
            <p:spPr>
              <a:xfrm>
                <a:off x="1632819" y="529820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ea typeface="Helvetica" charset="0"/>
                    <a:cs typeface="Times New Roman"/>
                  </a:rPr>
                  <a:t>17</a:t>
                </a:r>
                <a:endParaRPr lang="en-US" sz="1000" dirty="0">
                  <a:latin typeface="Times New Roman"/>
                  <a:ea typeface="Helvetica" charset="0"/>
                  <a:cs typeface="Times New Roman"/>
                </a:endParaRPr>
              </a:p>
            </p:txBody>
          </p:sp>
          <p:sp>
            <p:nvSpPr>
              <p:cNvPr id="124" name="TextBox 136"/>
              <p:cNvSpPr txBox="1"/>
              <p:nvPr/>
            </p:nvSpPr>
            <p:spPr>
              <a:xfrm>
                <a:off x="1522010" y="1710364"/>
                <a:ext cx="4090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ea typeface="Helvetica" charset="0"/>
                    <a:cs typeface="Times New Roman"/>
                  </a:rPr>
                  <a:t>15.5</a:t>
                </a:r>
                <a:endParaRPr lang="en-US" sz="1000" dirty="0">
                  <a:latin typeface="Times New Roman"/>
                  <a:ea typeface="Helvetica" charset="0"/>
                  <a:cs typeface="Times New Roman"/>
                </a:endParaRPr>
              </a:p>
            </p:txBody>
          </p:sp>
          <p:sp>
            <p:nvSpPr>
              <p:cNvPr id="125" name="TextBox 137"/>
              <p:cNvSpPr txBox="1"/>
              <p:nvPr/>
            </p:nvSpPr>
            <p:spPr>
              <a:xfrm>
                <a:off x="1522010" y="896831"/>
                <a:ext cx="4090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ea typeface="Helvetica" charset="0"/>
                    <a:cs typeface="Times New Roman"/>
                  </a:rPr>
                  <a:t>16.5</a:t>
                </a:r>
                <a:endParaRPr lang="en-US" sz="1000" dirty="0">
                  <a:latin typeface="Times New Roman"/>
                  <a:ea typeface="Helvetica" charset="0"/>
                  <a:cs typeface="Times New Roman"/>
                </a:endParaRPr>
              </a:p>
            </p:txBody>
          </p:sp>
          <p:sp>
            <p:nvSpPr>
              <p:cNvPr id="126" name="TextBox 138"/>
              <p:cNvSpPr txBox="1"/>
              <p:nvPr/>
            </p:nvSpPr>
            <p:spPr>
              <a:xfrm>
                <a:off x="1522010" y="2510649"/>
                <a:ext cx="4090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/>
                    <a:ea typeface="Helvetica" charset="0"/>
                    <a:cs typeface="Times New Roman"/>
                  </a:rPr>
                  <a:t>14.5</a:t>
                </a:r>
                <a:endParaRPr lang="en-US" sz="1000" dirty="0">
                  <a:latin typeface="Times New Roman"/>
                  <a:ea typeface="Helvetica" charset="0"/>
                  <a:cs typeface="Times New Roman"/>
                </a:endParaRPr>
              </a:p>
            </p:txBody>
          </p:sp>
          <p:sp>
            <p:nvSpPr>
              <p:cNvPr id="127" name="正方形/長方形 73"/>
              <p:cNvSpPr/>
              <p:nvPr/>
            </p:nvSpPr>
            <p:spPr>
              <a:xfrm>
                <a:off x="7996557" y="560900"/>
                <a:ext cx="155586" cy="220016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>
                  <a:latin typeface="Times New Roman"/>
                  <a:cs typeface="Times New Roman"/>
                </a:endParaRPr>
              </a:p>
            </p:txBody>
          </p:sp>
        </p:grpSp>
        <p:cxnSp>
          <p:nvCxnSpPr>
            <p:cNvPr id="91" name="直線コネクタ 80"/>
            <p:cNvCxnSpPr/>
            <p:nvPr/>
          </p:nvCxnSpPr>
          <p:spPr>
            <a:xfrm flipV="1">
              <a:off x="3962840" y="1653218"/>
              <a:ext cx="1988585" cy="546605"/>
            </a:xfrm>
            <a:prstGeom prst="line">
              <a:avLst/>
            </a:prstGeom>
            <a:ln>
              <a:solidFill>
                <a:srgbClr val="00B05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82"/>
            <p:cNvCxnSpPr/>
            <p:nvPr/>
          </p:nvCxnSpPr>
          <p:spPr>
            <a:xfrm flipV="1">
              <a:off x="2023602" y="1653218"/>
              <a:ext cx="1939238" cy="546605"/>
            </a:xfrm>
            <a:prstGeom prst="line">
              <a:avLst/>
            </a:prstGeom>
            <a:ln>
              <a:solidFill>
                <a:srgbClr val="00B05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0"/>
            <p:cNvCxnSpPr/>
            <p:nvPr/>
          </p:nvCxnSpPr>
          <p:spPr>
            <a:xfrm>
              <a:off x="5951425" y="1692696"/>
              <a:ext cx="1997830" cy="465791"/>
            </a:xfrm>
            <a:prstGeom prst="line">
              <a:avLst/>
            </a:prstGeom>
            <a:ln>
              <a:solidFill>
                <a:srgbClr val="00B05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Box 2"/>
          <p:cNvSpPr txBox="1"/>
          <p:nvPr/>
        </p:nvSpPr>
        <p:spPr>
          <a:xfrm>
            <a:off x="253831" y="5561653"/>
            <a:ext cx="877811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Times"/>
                <a:cs typeface="Times"/>
              </a:rPr>
              <a:t>A: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Log-</a:t>
            </a:r>
            <a:r>
              <a:rPr lang="en-US" altLang="ja-JP" sz="1200" dirty="0">
                <a:latin typeface="Times"/>
                <a:cs typeface="Times"/>
              </a:rPr>
              <a:t>l</a:t>
            </a:r>
            <a:r>
              <a:rPr lang="en-US" sz="1200" dirty="0" smtClean="0">
                <a:latin typeface="Times"/>
                <a:cs typeface="Times"/>
              </a:rPr>
              <a:t>inear </a:t>
            </a:r>
            <a:r>
              <a:rPr lang="en-US" sz="1200" dirty="0">
                <a:latin typeface="Times"/>
                <a:cs typeface="Times"/>
              </a:rPr>
              <a:t>regression model analysis was performed to evaluate the correlation between the </a:t>
            </a:r>
            <a:r>
              <a:rPr lang="en-US" sz="1200" dirty="0" err="1" smtClean="0">
                <a:latin typeface="Times"/>
                <a:cs typeface="Times"/>
              </a:rPr>
              <a:t>Hb</a:t>
            </a:r>
            <a:r>
              <a:rPr lang="en-US" sz="1200" dirty="0" smtClean="0">
                <a:latin typeface="Times"/>
                <a:cs typeface="Times"/>
              </a:rPr>
              <a:t> and external and internal exposure in </a:t>
            </a:r>
          </a:p>
          <a:p>
            <a:r>
              <a:rPr lang="en-US" sz="1200" dirty="0">
                <a:latin typeface="Times"/>
                <a:cs typeface="Times"/>
              </a:rPr>
              <a:t> </a:t>
            </a:r>
            <a:r>
              <a:rPr lang="en-US" sz="1200" dirty="0" smtClean="0">
                <a:latin typeface="Times"/>
                <a:cs typeface="Times"/>
              </a:rPr>
              <a:t>    BM </a:t>
            </a:r>
            <a:r>
              <a:rPr lang="en-US" sz="1200" dirty="0">
                <a:latin typeface="Times"/>
                <a:cs typeface="Times"/>
              </a:rPr>
              <a:t>(bone marrow</a:t>
            </a:r>
            <a:r>
              <a:rPr lang="en-US" sz="1200" dirty="0" smtClean="0">
                <a:latin typeface="Times"/>
                <a:cs typeface="Times"/>
              </a:rPr>
              <a:t>) dose</a:t>
            </a:r>
            <a:r>
              <a:rPr lang="en-US" sz="1200" dirty="0">
                <a:latin typeface="Times"/>
                <a:cs typeface="Times"/>
              </a:rPr>
              <a:t> </a:t>
            </a:r>
            <a:r>
              <a:rPr lang="en-US" sz="1200" dirty="0" smtClean="0">
                <a:latin typeface="Times"/>
                <a:cs typeface="Times"/>
              </a:rPr>
              <a:t>or </a:t>
            </a:r>
            <a:r>
              <a:rPr lang="en-US" sz="1200" dirty="0" err="1" smtClean="0">
                <a:latin typeface="Times"/>
                <a:cs typeface="Times"/>
              </a:rPr>
              <a:t>Hb</a:t>
            </a:r>
            <a:r>
              <a:rPr lang="en-US" sz="1200" dirty="0" smtClean="0">
                <a:latin typeface="Times"/>
                <a:cs typeface="Times"/>
              </a:rPr>
              <a:t> and smoking cigarettes per day.</a:t>
            </a:r>
          </a:p>
          <a:p>
            <a:r>
              <a:rPr lang="en-US" sz="1200" dirty="0" smtClean="0">
                <a:latin typeface="Times"/>
                <a:cs typeface="Times"/>
              </a:rPr>
              <a:t>B: </a:t>
            </a:r>
            <a:r>
              <a:rPr lang="en-US" altLang="ja-JP" sz="1200" dirty="0">
                <a:latin typeface="Times"/>
                <a:cs typeface="Times"/>
              </a:rPr>
              <a:t>Log-l</a:t>
            </a:r>
            <a:r>
              <a:rPr lang="en-US" sz="1200" dirty="0">
                <a:latin typeface="Times"/>
                <a:cs typeface="Times"/>
              </a:rPr>
              <a:t>inear regression model analysis was performed to evaluate the correlation between the </a:t>
            </a:r>
            <a:r>
              <a:rPr lang="en-US" sz="1200" dirty="0" err="1">
                <a:latin typeface="Times"/>
                <a:cs typeface="Times"/>
              </a:rPr>
              <a:t>Hb</a:t>
            </a:r>
            <a:r>
              <a:rPr lang="en-US" sz="1200" dirty="0">
                <a:latin typeface="Times"/>
                <a:cs typeface="Times"/>
              </a:rPr>
              <a:t> and external and internal exposure in </a:t>
            </a:r>
          </a:p>
          <a:p>
            <a:r>
              <a:rPr lang="en-US" sz="1200" dirty="0">
                <a:latin typeface="Times"/>
                <a:cs typeface="Times"/>
              </a:rPr>
              <a:t>     BM (bone marrow) dose or </a:t>
            </a:r>
            <a:r>
              <a:rPr lang="en-US" sz="1200" dirty="0" err="1">
                <a:latin typeface="Times"/>
                <a:cs typeface="Times"/>
              </a:rPr>
              <a:t>Hb</a:t>
            </a:r>
            <a:r>
              <a:rPr lang="en-US" sz="1200" dirty="0">
                <a:latin typeface="Times"/>
                <a:cs typeface="Times"/>
              </a:rPr>
              <a:t> and smoking cigarettes per </a:t>
            </a:r>
            <a:r>
              <a:rPr lang="en-US" sz="1200" dirty="0" smtClean="0">
                <a:latin typeface="Times"/>
                <a:cs typeface="Times"/>
              </a:rPr>
              <a:t>day or </a:t>
            </a:r>
            <a:r>
              <a:rPr lang="en-US" sz="1200" dirty="0" err="1" smtClean="0">
                <a:latin typeface="Times"/>
                <a:cs typeface="Times"/>
              </a:rPr>
              <a:t>Hb</a:t>
            </a:r>
            <a:r>
              <a:rPr lang="en-US" sz="1200" dirty="0" smtClean="0">
                <a:latin typeface="Times"/>
                <a:cs typeface="Times"/>
              </a:rPr>
              <a:t> and drinking unit per month.</a:t>
            </a:r>
            <a:endParaRPr lang="en-US" sz="1200" dirty="0">
              <a:latin typeface="Times"/>
              <a:cs typeface="Times"/>
            </a:endParaRPr>
          </a:p>
          <a:p>
            <a:r>
              <a:rPr lang="en-US" sz="1200" dirty="0" smtClean="0">
                <a:latin typeface="Times"/>
                <a:cs typeface="Times"/>
              </a:rPr>
              <a:t>The </a:t>
            </a:r>
            <a:r>
              <a:rPr lang="en-US" sz="1200" dirty="0">
                <a:latin typeface="Times"/>
                <a:cs typeface="Times"/>
              </a:rPr>
              <a:t>center estimate value line is located between the lines that indicate the 95% confidence interval of regression residuals. </a:t>
            </a:r>
            <a:endParaRPr lang="en-US" sz="1200" dirty="0" smtClean="0">
              <a:latin typeface="Times"/>
              <a:cs typeface="Times"/>
            </a:endParaRPr>
          </a:p>
          <a:p>
            <a:r>
              <a:rPr lang="en-US" sz="1200" dirty="0" smtClean="0">
                <a:latin typeface="Times"/>
                <a:cs typeface="Times"/>
              </a:rPr>
              <a:t>P</a:t>
            </a:r>
            <a:r>
              <a:rPr lang="en-US" sz="1200" dirty="0">
                <a:latin typeface="Times"/>
                <a:cs typeface="Times"/>
              </a:rPr>
              <a:t>-values calculated by linear regression analysis are shown at the bottom of the figures</a:t>
            </a:r>
            <a:r>
              <a:rPr lang="en-US" sz="1200" dirty="0" smtClean="0">
                <a:latin typeface="Times"/>
                <a:cs typeface="Times"/>
              </a:rPr>
              <a:t>.</a:t>
            </a:r>
            <a:endParaRPr lang="ja-JP" altLang="en-US" sz="1200" dirty="0"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30404173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angle 23"/>
          <p:cNvSpPr/>
          <p:nvPr/>
        </p:nvSpPr>
        <p:spPr>
          <a:xfrm>
            <a:off x="136618" y="35832"/>
            <a:ext cx="89343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lemental </a:t>
            </a:r>
            <a:r>
              <a:rPr lang="en-US" sz="1200" b="1" dirty="0">
                <a:latin typeface="Times New Roman"/>
                <a:cs typeface="Times New Roman"/>
              </a:rPr>
              <a:t>Figure </a:t>
            </a:r>
            <a:r>
              <a:rPr lang="en-US" altLang="ja-JP" sz="1200" b="1" dirty="0">
                <a:latin typeface="Times New Roman"/>
                <a:cs typeface="Times New Roman"/>
              </a:rPr>
              <a:t>3</a:t>
            </a:r>
            <a:r>
              <a:rPr lang="en-US" sz="1200" b="1" dirty="0" smtClean="0">
                <a:latin typeface="Times New Roman"/>
                <a:cs typeface="Times New Roman"/>
              </a:rPr>
              <a:t>: Linear </a:t>
            </a:r>
            <a:r>
              <a:rPr lang="en-US" sz="1200" b="1" dirty="0">
                <a:latin typeface="Times New Roman"/>
                <a:cs typeface="Times New Roman"/>
              </a:rPr>
              <a:t>regression analysis of Hb change rate (%) for each dose </a:t>
            </a:r>
            <a:r>
              <a:rPr lang="en-US" sz="1200" b="1" dirty="0" smtClean="0">
                <a:latin typeface="Times New Roman"/>
                <a:cs typeface="Times New Roman"/>
              </a:rPr>
              <a:t>group</a:t>
            </a:r>
            <a:endParaRPr lang="ja-JP" altLang="en-US" sz="1200" b="1" dirty="0">
              <a:latin typeface="Times New Roman"/>
              <a:cs typeface="Times New Roman"/>
            </a:endParaRPr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5768329"/>
              </p:ext>
            </p:extLst>
          </p:nvPr>
        </p:nvGraphicFramePr>
        <p:xfrm>
          <a:off x="512530" y="533175"/>
          <a:ext cx="4285029" cy="25714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149918" y="358652"/>
            <a:ext cx="941859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&gt; 100 mSv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428230" y="358652"/>
            <a:ext cx="103165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50-100 mSv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143794" y="3261571"/>
            <a:ext cx="954107" cy="276999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10-50 mSv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574894" y="3261571"/>
            <a:ext cx="864339" cy="276999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&lt; 10 mSv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8" name="Right Triangle 7"/>
          <p:cNvSpPr/>
          <p:nvPr/>
        </p:nvSpPr>
        <p:spPr>
          <a:xfrm>
            <a:off x="899087" y="2697795"/>
            <a:ext cx="3654756" cy="250058"/>
          </a:xfrm>
          <a:prstGeom prst="rtTriangle">
            <a:avLst/>
          </a:prstGeom>
          <a:gradFill flip="none" rotWithShape="1">
            <a:gsLst>
              <a:gs pos="0">
                <a:srgbClr val="FF0000"/>
              </a:gs>
              <a:gs pos="100000">
                <a:srgbClr val="FFFFFF"/>
              </a:gs>
            </a:gsLst>
            <a:lin ang="0" scaled="1"/>
            <a:tileRect/>
          </a:gra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04263" y="2933240"/>
            <a:ext cx="40107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739</a:t>
            </a:r>
            <a:r>
              <a:rPr lang="ja-JP" altLang="en-US" sz="1000" dirty="0" smtClean="0">
                <a:latin typeface="Arial"/>
                <a:cs typeface="Arial"/>
              </a:rPr>
              <a:t>　　　　　　</a:t>
            </a:r>
            <a:r>
              <a:rPr lang="en-US" altLang="ja-JP" sz="1000" dirty="0" smtClean="0">
                <a:latin typeface="Arial"/>
                <a:cs typeface="Arial"/>
              </a:rPr>
              <a:t> External exposed dose (2011+2012) mSv</a:t>
            </a:r>
            <a:r>
              <a:rPr lang="ja-JP" altLang="en-US" sz="1000" dirty="0" smtClean="0">
                <a:latin typeface="Arial"/>
                <a:cs typeface="Arial"/>
              </a:rPr>
              <a:t>　　</a:t>
            </a:r>
            <a:r>
              <a:rPr lang="en-US" altLang="en-US" sz="1000" dirty="0">
                <a:latin typeface="Arial"/>
                <a:cs typeface="Arial"/>
              </a:rPr>
              <a:t> </a:t>
            </a:r>
            <a:r>
              <a:rPr lang="en-US" altLang="en-US" sz="1000" dirty="0" smtClean="0">
                <a:latin typeface="Arial"/>
                <a:cs typeface="Arial"/>
              </a:rPr>
              <a:t>   </a:t>
            </a:r>
            <a:r>
              <a:rPr lang="en-US" altLang="ja-JP" sz="1000" dirty="0" smtClean="0">
                <a:latin typeface="Arial"/>
                <a:cs typeface="Arial"/>
              </a:rPr>
              <a:t>     </a:t>
            </a:r>
            <a:r>
              <a:rPr lang="en-US" sz="1000" dirty="0" smtClean="0">
                <a:latin typeface="Arial"/>
                <a:cs typeface="Arial"/>
              </a:rPr>
              <a:t>100</a:t>
            </a:r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8821081"/>
              </p:ext>
            </p:extLst>
          </p:nvPr>
        </p:nvGraphicFramePr>
        <p:xfrm>
          <a:off x="4663784" y="519945"/>
          <a:ext cx="4248467" cy="25846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8000307"/>
              </p:ext>
            </p:extLst>
          </p:nvPr>
        </p:nvGraphicFramePr>
        <p:xfrm>
          <a:off x="512530" y="3425197"/>
          <a:ext cx="4285029" cy="2605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8118468"/>
              </p:ext>
            </p:extLst>
          </p:nvPr>
        </p:nvGraphicFramePr>
        <p:xfrm>
          <a:off x="4615474" y="3421357"/>
          <a:ext cx="4296777" cy="26095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13" name="Straight Connector 12"/>
          <p:cNvCxnSpPr/>
          <p:nvPr/>
        </p:nvCxnSpPr>
        <p:spPr>
          <a:xfrm>
            <a:off x="899518" y="1818908"/>
            <a:ext cx="3654324" cy="0"/>
          </a:xfrm>
          <a:prstGeom prst="line">
            <a:avLst/>
          </a:prstGeom>
          <a:ln w="38100" cmpd="sng">
            <a:solidFill>
              <a:srgbClr val="FF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5039028" y="1818908"/>
            <a:ext cx="3585765" cy="0"/>
          </a:xfrm>
          <a:prstGeom prst="line">
            <a:avLst/>
          </a:prstGeom>
          <a:ln w="38100" cmpd="sng">
            <a:solidFill>
              <a:srgbClr val="FF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4960052" y="4729550"/>
            <a:ext cx="3678396" cy="0"/>
          </a:xfrm>
          <a:prstGeom prst="line">
            <a:avLst/>
          </a:prstGeom>
          <a:ln w="38100" cmpd="sng">
            <a:solidFill>
              <a:srgbClr val="FF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Right Triangle 15"/>
          <p:cNvSpPr/>
          <p:nvPr/>
        </p:nvSpPr>
        <p:spPr>
          <a:xfrm>
            <a:off x="885858" y="5606637"/>
            <a:ext cx="3667985" cy="250058"/>
          </a:xfrm>
          <a:prstGeom prst="rtTriangle">
            <a:avLst/>
          </a:prstGeom>
          <a:gradFill flip="none" rotWithShape="1">
            <a:gsLst>
              <a:gs pos="0">
                <a:schemeClr val="accent2">
                  <a:lumMod val="60000"/>
                  <a:lumOff val="40000"/>
                </a:schemeClr>
              </a:gs>
              <a:gs pos="100000">
                <a:srgbClr val="FFFFFF"/>
              </a:gs>
            </a:gsLst>
            <a:lin ang="0" scaled="1"/>
            <a:tileRect/>
          </a:gra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17" name="Right Triangle 16"/>
          <p:cNvSpPr/>
          <p:nvPr/>
        </p:nvSpPr>
        <p:spPr>
          <a:xfrm>
            <a:off x="5039028" y="2680650"/>
            <a:ext cx="3585765" cy="250058"/>
          </a:xfrm>
          <a:prstGeom prst="rtTriangle">
            <a:avLst/>
          </a:prstGeom>
          <a:gradFill flip="none" rotWithShape="1">
            <a:gsLst>
              <a:gs pos="0">
                <a:srgbClr val="FF6666"/>
              </a:gs>
              <a:gs pos="100000">
                <a:srgbClr val="FFFFFF"/>
              </a:gs>
            </a:gsLst>
            <a:lin ang="0" scaled="1"/>
            <a:tileRect/>
          </a:gra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18" name="Right Triangle 17"/>
          <p:cNvSpPr/>
          <p:nvPr/>
        </p:nvSpPr>
        <p:spPr>
          <a:xfrm>
            <a:off x="5000866" y="5610471"/>
            <a:ext cx="3623927" cy="246224"/>
          </a:xfrm>
          <a:prstGeom prst="rtTriangle">
            <a:avLst/>
          </a:prstGeom>
          <a:gradFill flip="none" rotWithShape="1">
            <a:gsLst>
              <a:gs pos="0">
                <a:schemeClr val="accent2">
                  <a:lumMod val="20000"/>
                  <a:lumOff val="80000"/>
                </a:schemeClr>
              </a:gs>
              <a:gs pos="100000">
                <a:schemeClr val="bg1"/>
              </a:gs>
            </a:gsLst>
            <a:lin ang="0" scaled="1"/>
            <a:tileRect/>
          </a:gra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-721073" y="1627763"/>
            <a:ext cx="21463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/>
                <a:cs typeface="Arial"/>
              </a:rPr>
              <a:t> % Hb change ratio</a:t>
            </a:r>
          </a:p>
          <a:p>
            <a:pPr algn="ctr"/>
            <a:r>
              <a:rPr lang="en-US" sz="1000" dirty="0" smtClean="0">
                <a:latin typeface="Arial"/>
                <a:cs typeface="Arial"/>
              </a:rPr>
              <a:t> [(</a:t>
            </a:r>
            <a:r>
              <a:rPr lang="en-US" sz="1000" dirty="0">
                <a:latin typeface="Arial"/>
                <a:cs typeface="Arial"/>
              </a:rPr>
              <a:t>2011+2012</a:t>
            </a:r>
            <a:r>
              <a:rPr lang="en-US" sz="1000" dirty="0" smtClean="0">
                <a:latin typeface="Arial"/>
                <a:cs typeface="Arial"/>
              </a:rPr>
              <a:t>)Hb / (</a:t>
            </a:r>
            <a:r>
              <a:rPr lang="en-US" sz="1000" dirty="0">
                <a:latin typeface="Arial"/>
                <a:cs typeface="Arial"/>
              </a:rPr>
              <a:t>2006-2010</a:t>
            </a:r>
            <a:r>
              <a:rPr lang="en-US" sz="1000" dirty="0" smtClean="0">
                <a:latin typeface="Arial"/>
                <a:cs typeface="Arial"/>
              </a:rPr>
              <a:t>)Hb</a:t>
            </a:r>
            <a:r>
              <a:rPr lang="en-US" sz="1000" dirty="0">
                <a:latin typeface="Arial"/>
                <a:cs typeface="Arial"/>
              </a:rPr>
              <a:t>] 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884207" y="2933240"/>
            <a:ext cx="397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100</a:t>
            </a:r>
            <a:r>
              <a:rPr lang="ja-JP" altLang="en-US" sz="1000" dirty="0" smtClean="0">
                <a:latin typeface="Arial"/>
                <a:cs typeface="Arial"/>
              </a:rPr>
              <a:t>　　　　　</a:t>
            </a:r>
            <a:r>
              <a:rPr lang="en-US" altLang="ja-JP" sz="1000" dirty="0" smtClean="0">
                <a:latin typeface="Arial"/>
                <a:cs typeface="Arial"/>
              </a:rPr>
              <a:t> </a:t>
            </a:r>
            <a:r>
              <a:rPr lang="ja-JP" altLang="en-US" sz="1000" dirty="0" smtClean="0">
                <a:latin typeface="Arial"/>
                <a:cs typeface="Arial"/>
              </a:rPr>
              <a:t>　</a:t>
            </a:r>
            <a:r>
              <a:rPr lang="en-US" altLang="ja-JP" sz="1000" dirty="0">
                <a:latin typeface="Arial"/>
                <a:cs typeface="Arial"/>
              </a:rPr>
              <a:t>External exposed dose </a:t>
            </a:r>
            <a:r>
              <a:rPr lang="en-US" altLang="ja-JP" sz="1000" dirty="0" smtClean="0">
                <a:latin typeface="Arial"/>
                <a:cs typeface="Arial"/>
              </a:rPr>
              <a:t>(2011+2012) mSv</a:t>
            </a:r>
            <a:r>
              <a:rPr lang="ja-JP" altLang="en-US" sz="1000" dirty="0" smtClean="0">
                <a:latin typeface="Arial"/>
                <a:cs typeface="Arial"/>
              </a:rPr>
              <a:t>　　</a:t>
            </a:r>
            <a:r>
              <a:rPr lang="en-US" altLang="en-US" sz="1000" dirty="0">
                <a:latin typeface="Arial"/>
                <a:cs typeface="Arial"/>
              </a:rPr>
              <a:t> </a:t>
            </a:r>
            <a:r>
              <a:rPr lang="en-US" altLang="en-US" sz="1000" dirty="0" smtClean="0">
                <a:latin typeface="Arial"/>
                <a:cs typeface="Arial"/>
              </a:rPr>
              <a:t>   </a:t>
            </a:r>
            <a:r>
              <a:rPr lang="en-US" altLang="ja-JP" sz="1000" dirty="0" smtClean="0">
                <a:latin typeface="Arial"/>
                <a:cs typeface="Arial"/>
              </a:rPr>
              <a:t>    </a:t>
            </a:r>
            <a:r>
              <a:rPr lang="en-US" altLang="ja-JP" sz="1000" dirty="0">
                <a:latin typeface="Arial"/>
                <a:cs typeface="Arial"/>
              </a:rPr>
              <a:t>5</a:t>
            </a:r>
            <a:r>
              <a:rPr lang="en-US" sz="1000" dirty="0" smtClean="0">
                <a:latin typeface="Arial"/>
                <a:cs typeface="Arial"/>
              </a:rPr>
              <a:t>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38838" y="5845854"/>
            <a:ext cx="397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5</a:t>
            </a:r>
            <a:r>
              <a:rPr lang="en-US" altLang="ja-JP" sz="1000" dirty="0" smtClean="0">
                <a:latin typeface="Arial"/>
                <a:cs typeface="Arial"/>
              </a:rPr>
              <a:t>0</a:t>
            </a:r>
            <a:r>
              <a:rPr lang="ja-JP" altLang="en-US" sz="1000" dirty="0" smtClean="0">
                <a:latin typeface="Arial"/>
                <a:cs typeface="Arial"/>
              </a:rPr>
              <a:t>　　　　　</a:t>
            </a:r>
            <a:r>
              <a:rPr lang="en-US" altLang="ja-JP" sz="1000" dirty="0" smtClean="0">
                <a:latin typeface="Arial"/>
                <a:cs typeface="Arial"/>
              </a:rPr>
              <a:t> </a:t>
            </a:r>
            <a:r>
              <a:rPr lang="ja-JP" altLang="en-US" sz="1000" dirty="0" smtClean="0">
                <a:latin typeface="Arial"/>
                <a:cs typeface="Arial"/>
              </a:rPr>
              <a:t>　</a:t>
            </a:r>
            <a:r>
              <a:rPr lang="en-US" altLang="ja-JP" sz="1000" dirty="0">
                <a:latin typeface="Arial"/>
                <a:cs typeface="Arial"/>
              </a:rPr>
              <a:t>External exposed dose </a:t>
            </a:r>
            <a:r>
              <a:rPr lang="en-US" altLang="ja-JP" sz="1000" dirty="0" smtClean="0">
                <a:latin typeface="Arial"/>
                <a:cs typeface="Arial"/>
              </a:rPr>
              <a:t>(2011+2012) mSv</a:t>
            </a:r>
            <a:r>
              <a:rPr lang="ja-JP" altLang="en-US" sz="1000" dirty="0" smtClean="0">
                <a:latin typeface="Arial"/>
                <a:cs typeface="Arial"/>
              </a:rPr>
              <a:t>　　</a:t>
            </a:r>
            <a:r>
              <a:rPr lang="en-US" altLang="en-US" sz="1000" dirty="0">
                <a:latin typeface="Arial"/>
                <a:cs typeface="Arial"/>
              </a:rPr>
              <a:t> </a:t>
            </a:r>
            <a:r>
              <a:rPr lang="en-US" altLang="en-US" sz="1000" dirty="0" smtClean="0">
                <a:latin typeface="Arial"/>
                <a:cs typeface="Arial"/>
              </a:rPr>
              <a:t>   </a:t>
            </a:r>
            <a:r>
              <a:rPr lang="en-US" altLang="ja-JP" sz="1000" dirty="0" smtClean="0">
                <a:latin typeface="Arial"/>
                <a:cs typeface="Arial"/>
              </a:rPr>
              <a:t>      1</a:t>
            </a:r>
            <a:r>
              <a:rPr lang="en-US" sz="1000" dirty="0" smtClean="0">
                <a:latin typeface="Arial"/>
                <a:cs typeface="Arial"/>
              </a:rPr>
              <a:t>0</a:t>
            </a:r>
          </a:p>
        </p:txBody>
      </p:sp>
      <p:cxnSp>
        <p:nvCxnSpPr>
          <p:cNvPr id="22" name="Straight Connector 21"/>
          <p:cNvCxnSpPr/>
          <p:nvPr/>
        </p:nvCxnSpPr>
        <p:spPr>
          <a:xfrm>
            <a:off x="885858" y="4729550"/>
            <a:ext cx="3585765" cy="0"/>
          </a:xfrm>
          <a:prstGeom prst="line">
            <a:avLst/>
          </a:prstGeom>
          <a:ln w="38100" cmpd="sng">
            <a:solidFill>
              <a:srgbClr val="FF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4868947" y="5845854"/>
            <a:ext cx="3875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10</a:t>
            </a:r>
            <a:r>
              <a:rPr lang="ja-JP" altLang="en-US" sz="1000" dirty="0" smtClean="0">
                <a:latin typeface="Arial"/>
                <a:cs typeface="Arial"/>
              </a:rPr>
              <a:t>　　　　　　</a:t>
            </a:r>
            <a:r>
              <a:rPr lang="en-US" altLang="ja-JP" sz="1000" dirty="0">
                <a:latin typeface="Arial"/>
                <a:cs typeface="Arial"/>
              </a:rPr>
              <a:t> External exposed dose </a:t>
            </a:r>
            <a:r>
              <a:rPr lang="en-US" altLang="ja-JP" sz="1000" dirty="0" smtClean="0">
                <a:latin typeface="Arial"/>
                <a:cs typeface="Arial"/>
              </a:rPr>
              <a:t>(2011+2012) mSv</a:t>
            </a:r>
            <a:r>
              <a:rPr lang="ja-JP" altLang="en-US" sz="1000" dirty="0" smtClean="0">
                <a:latin typeface="Arial"/>
                <a:cs typeface="Arial"/>
              </a:rPr>
              <a:t>　　</a:t>
            </a:r>
            <a:r>
              <a:rPr lang="en-US" altLang="en-US" sz="1000" dirty="0">
                <a:latin typeface="Arial"/>
                <a:cs typeface="Arial"/>
              </a:rPr>
              <a:t> </a:t>
            </a:r>
            <a:r>
              <a:rPr lang="en-US" altLang="en-US" sz="1000" dirty="0" smtClean="0">
                <a:latin typeface="Arial"/>
                <a:cs typeface="Arial"/>
              </a:rPr>
              <a:t>   </a:t>
            </a:r>
            <a:r>
              <a:rPr lang="en-US" altLang="ja-JP" sz="1000" dirty="0" smtClean="0">
                <a:latin typeface="Arial"/>
                <a:cs typeface="Arial"/>
              </a:rPr>
              <a:t>      </a:t>
            </a:r>
            <a:r>
              <a:rPr lang="en-US" sz="1000" dirty="0" smtClean="0">
                <a:latin typeface="Arial"/>
                <a:cs typeface="Arial"/>
              </a:rPr>
              <a:t>0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-721073" y="4529495"/>
            <a:ext cx="21463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/>
                <a:cs typeface="Arial"/>
              </a:rPr>
              <a:t> % Hb change ratio</a:t>
            </a:r>
          </a:p>
          <a:p>
            <a:pPr algn="ctr"/>
            <a:r>
              <a:rPr lang="en-US" sz="1000" dirty="0" smtClean="0">
                <a:latin typeface="Arial"/>
                <a:cs typeface="Arial"/>
              </a:rPr>
              <a:t> [(</a:t>
            </a:r>
            <a:r>
              <a:rPr lang="en-US" sz="1000" dirty="0">
                <a:latin typeface="Arial"/>
                <a:cs typeface="Arial"/>
              </a:rPr>
              <a:t>2011+2012</a:t>
            </a:r>
            <a:r>
              <a:rPr lang="en-US" sz="1000" dirty="0" smtClean="0">
                <a:latin typeface="Arial"/>
                <a:cs typeface="Arial"/>
              </a:rPr>
              <a:t>)Hb / (</a:t>
            </a:r>
            <a:r>
              <a:rPr lang="en-US" sz="1000" dirty="0">
                <a:latin typeface="Arial"/>
                <a:cs typeface="Arial"/>
              </a:rPr>
              <a:t>2006-2010</a:t>
            </a:r>
            <a:r>
              <a:rPr lang="en-US" sz="1000" dirty="0" smtClean="0">
                <a:latin typeface="Arial"/>
                <a:cs typeface="Arial"/>
              </a:rPr>
              <a:t>)Hb</a:t>
            </a:r>
            <a:r>
              <a:rPr lang="en-US" sz="1000" dirty="0">
                <a:latin typeface="Arial"/>
                <a:cs typeface="Arial"/>
              </a:rPr>
              <a:t>]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47903" y="6199195"/>
            <a:ext cx="870074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Times"/>
                <a:cs typeface="Times"/>
              </a:rPr>
              <a:t>Hb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change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rate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(%)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in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four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groups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(&gt;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100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mSv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50-100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mSv,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10-50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mSv,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ja-JP" altLang="ja-JP" sz="1200" dirty="0" smtClean="0">
                <a:latin typeface="Times"/>
                <a:cs typeface="Times"/>
              </a:rPr>
              <a:t>&lt;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10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mSv)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are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shown.</a:t>
            </a:r>
            <a:r>
              <a:rPr lang="ja-JP" altLang="en-US" sz="1200" dirty="0" smtClean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Black </a:t>
            </a:r>
            <a:r>
              <a:rPr lang="en-US" altLang="ja-JP" sz="1200" dirty="0">
                <a:latin typeface="Times"/>
                <a:cs typeface="Times"/>
              </a:rPr>
              <a:t>line </a:t>
            </a:r>
            <a:r>
              <a:rPr lang="en-US" altLang="ja-JP" sz="1200" dirty="0" smtClean="0">
                <a:latin typeface="Times"/>
                <a:cs typeface="Times"/>
              </a:rPr>
              <a:t>indicates linear </a:t>
            </a:r>
            <a:r>
              <a:rPr lang="en-US" altLang="ja-JP" sz="1200" dirty="0">
                <a:latin typeface="Times"/>
                <a:cs typeface="Times"/>
              </a:rPr>
              <a:t>regression </a:t>
            </a:r>
            <a:r>
              <a:rPr lang="en-US" altLang="ja-JP" sz="1200" dirty="0" smtClean="0">
                <a:latin typeface="Times"/>
                <a:cs typeface="Times"/>
              </a:rPr>
              <a:t>slope</a:t>
            </a:r>
          </a:p>
          <a:p>
            <a:r>
              <a:rPr lang="en-US" altLang="ja-JP" sz="1200" dirty="0" smtClean="0">
                <a:latin typeface="Times"/>
                <a:cs typeface="Times"/>
              </a:rPr>
              <a:t>and resulting formula for each group is shown</a:t>
            </a:r>
            <a:r>
              <a:rPr lang="en-US" altLang="ja-JP" sz="1200" dirty="0">
                <a:latin typeface="Times"/>
                <a:cs typeface="Times"/>
              </a:rPr>
              <a:t> </a:t>
            </a:r>
            <a:r>
              <a:rPr lang="en-US" altLang="ja-JP" sz="1200" dirty="0" smtClean="0">
                <a:latin typeface="Times"/>
                <a:cs typeface="Times"/>
              </a:rPr>
              <a:t>inside the box. Blue number indicates number </a:t>
            </a:r>
            <a:r>
              <a:rPr lang="en-US" altLang="ja-JP" sz="1200" dirty="0">
                <a:latin typeface="Times"/>
                <a:cs typeface="Times"/>
              </a:rPr>
              <a:t>of emergency workers </a:t>
            </a:r>
            <a:r>
              <a:rPr lang="en-US" altLang="ja-JP" sz="1200" dirty="0" smtClean="0">
                <a:latin typeface="Times"/>
                <a:cs typeface="Times"/>
              </a:rPr>
              <a:t>and</a:t>
            </a:r>
            <a:r>
              <a:rPr lang="en-US" altLang="en-US" sz="1200" dirty="0">
                <a:latin typeface="Times"/>
                <a:cs typeface="Times"/>
              </a:rPr>
              <a:t> </a:t>
            </a:r>
            <a:r>
              <a:rPr lang="en-US" altLang="ja-JP" sz="1200" dirty="0">
                <a:latin typeface="Times"/>
                <a:cs typeface="Times"/>
              </a:rPr>
              <a:t>r</a:t>
            </a:r>
            <a:r>
              <a:rPr lang="en-US" altLang="ja-JP" sz="1200" dirty="0" smtClean="0">
                <a:latin typeface="Times"/>
                <a:cs typeface="Times"/>
              </a:rPr>
              <a:t>anked </a:t>
            </a:r>
            <a:r>
              <a:rPr lang="en-US" altLang="ja-JP" sz="1200" dirty="0">
                <a:latin typeface="Times"/>
                <a:cs typeface="Times"/>
              </a:rPr>
              <a:t>according </a:t>
            </a:r>
            <a:endParaRPr lang="en-US" altLang="ja-JP" sz="1200" dirty="0" smtClean="0">
              <a:latin typeface="Times"/>
              <a:cs typeface="Times"/>
            </a:endParaRPr>
          </a:p>
          <a:p>
            <a:r>
              <a:rPr lang="en-US" altLang="ja-JP" sz="1200" dirty="0" smtClean="0">
                <a:latin typeface="Times"/>
                <a:cs typeface="Times"/>
              </a:rPr>
              <a:t>to external exposed dose (2011+2012). Red dotted line indicates no Hb change ratio between “before” and “after” the accident. </a:t>
            </a:r>
          </a:p>
        </p:txBody>
      </p:sp>
    </p:spTree>
    <p:extLst>
      <p:ext uri="{BB962C8B-B14F-4D97-AF65-F5344CB8AC3E}">
        <p14:creationId xmlns:p14="http://schemas.microsoft.com/office/powerpoint/2010/main" val="270066216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6568006" y="5842273"/>
            <a:ext cx="2133600" cy="365125"/>
          </a:xfrm>
        </p:spPr>
        <p:txBody>
          <a:bodyPr/>
          <a:lstStyle/>
          <a:p>
            <a:fld id="{44D4475A-9A00-4546-A101-AEDF80008D61}" type="slidenum">
              <a:rPr lang="en-US" smtClean="0"/>
              <a:t>4</a:t>
            </a:fld>
            <a:endParaRPr lang="en-US" dirty="0"/>
          </a:p>
        </p:txBody>
      </p:sp>
      <p:sp>
        <p:nvSpPr>
          <p:cNvPr id="3" name="Slide Number Placeholder 1"/>
          <p:cNvSpPr txBox="1">
            <a:spLocks/>
          </p:cNvSpPr>
          <p:nvPr/>
        </p:nvSpPr>
        <p:spPr>
          <a:xfrm>
            <a:off x="6568006" y="584227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44D4475A-9A00-4546-A101-AEDF80008D61}" type="slidenum">
              <a:rPr lang="en-US" smtClean="0">
                <a:latin typeface="Times New Roman"/>
                <a:cs typeface="Times New Roman"/>
              </a:rPr>
              <a:pPr/>
              <a:t>4</a:t>
            </a:fld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36618" y="35832"/>
            <a:ext cx="893433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lemental </a:t>
            </a:r>
            <a:r>
              <a:rPr lang="en-US" sz="1200" b="1" dirty="0">
                <a:latin typeface="Times New Roman"/>
                <a:cs typeface="Times New Roman"/>
              </a:rPr>
              <a:t>Figure </a:t>
            </a:r>
            <a:r>
              <a:rPr lang="ja-JP" altLang="ja-JP" sz="1200" b="1" dirty="0" smtClean="0">
                <a:latin typeface="Times New Roman"/>
                <a:cs typeface="Times New Roman"/>
              </a:rPr>
              <a:t>4</a:t>
            </a:r>
            <a:r>
              <a:rPr lang="en-US" sz="1200" b="1" dirty="0" smtClean="0">
                <a:latin typeface="Times New Roman"/>
                <a:cs typeface="Times New Roman"/>
              </a:rPr>
              <a:t>: </a:t>
            </a:r>
            <a:endParaRPr lang="en-US" sz="1200" b="1" dirty="0">
              <a:latin typeface="Times New Roman"/>
              <a:cs typeface="Times New Roman"/>
            </a:endParaRPr>
          </a:p>
          <a:p>
            <a:r>
              <a:rPr lang="en-US" sz="1200" b="1" dirty="0" smtClean="0">
                <a:latin typeface="Times New Roman"/>
                <a:cs typeface="Times New Roman"/>
              </a:rPr>
              <a:t>Supplied foods at Main </a:t>
            </a:r>
            <a:r>
              <a:rPr lang="en-US" sz="1200" b="1" dirty="0">
                <a:latin typeface="Times New Roman"/>
                <a:cs typeface="Times New Roman"/>
              </a:rPr>
              <a:t>Anti-Earthquake Building </a:t>
            </a:r>
            <a:r>
              <a:rPr lang="en-US" sz="1200" b="1" dirty="0" smtClean="0">
                <a:latin typeface="Times New Roman"/>
                <a:cs typeface="Times New Roman"/>
              </a:rPr>
              <a:t>during emergency period and the period after the Sept 2011 </a:t>
            </a:r>
            <a:endParaRPr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5" name="TextBox 31"/>
          <p:cNvSpPr txBox="1"/>
          <p:nvPr/>
        </p:nvSpPr>
        <p:spPr>
          <a:xfrm>
            <a:off x="263773" y="446676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A</a:t>
            </a:r>
          </a:p>
        </p:txBody>
      </p:sp>
      <p:sp>
        <p:nvSpPr>
          <p:cNvPr id="6" name="TextBox 31"/>
          <p:cNvSpPr txBox="1"/>
          <p:nvPr/>
        </p:nvSpPr>
        <p:spPr>
          <a:xfrm>
            <a:off x="4660685" y="446676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B</a:t>
            </a:r>
            <a:endParaRPr lang="en-US" dirty="0">
              <a:latin typeface="Times New Roman"/>
              <a:cs typeface="Times New Roman"/>
            </a:endParaRPr>
          </a:p>
        </p:txBody>
      </p:sp>
      <p:pic>
        <p:nvPicPr>
          <p:cNvPr id="7" name="図 5" descr="2011-06-01 11.56.27.jpg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19352" y="995988"/>
            <a:ext cx="1951973" cy="1463979"/>
          </a:xfrm>
          <a:prstGeom prst="rect">
            <a:avLst/>
          </a:prstGeom>
        </p:spPr>
      </p:pic>
      <p:pic>
        <p:nvPicPr>
          <p:cNvPr id="8" name="図 4" descr="2011-06-01 11.52.40.jpg"/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85065" y="995988"/>
            <a:ext cx="1951974" cy="146398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625920" y="710186"/>
            <a:ext cx="1970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P</a:t>
            </a:r>
            <a:r>
              <a:rPr lang="en-US" sz="1200" dirty="0">
                <a:latin typeface="Times New Roman"/>
                <a:cs typeface="Times New Roman"/>
              </a:rPr>
              <a:t>a</a:t>
            </a:r>
            <a:r>
              <a:rPr lang="en-US" sz="1200" dirty="0" smtClean="0">
                <a:latin typeface="Times New Roman"/>
                <a:cs typeface="Times New Roman"/>
              </a:rPr>
              <a:t>stry, </a:t>
            </a:r>
            <a:r>
              <a:rPr lang="en-US" sz="1200" dirty="0">
                <a:latin typeface="Times New Roman"/>
                <a:cs typeface="Times New Roman"/>
              </a:rPr>
              <a:t>f</a:t>
            </a:r>
            <a:r>
              <a:rPr lang="en-US" sz="1200" dirty="0" smtClean="0">
                <a:latin typeface="Times New Roman"/>
                <a:cs typeface="Times New Roman"/>
              </a:rPr>
              <a:t>illed or </a:t>
            </a:r>
            <a:r>
              <a:rPr lang="en-US" sz="1200" dirty="0">
                <a:latin typeface="Times New Roman"/>
                <a:cs typeface="Times New Roman"/>
              </a:rPr>
              <a:t>s</a:t>
            </a:r>
            <a:r>
              <a:rPr lang="en-US" sz="1200" dirty="0" smtClean="0">
                <a:latin typeface="Times New Roman"/>
                <a:cs typeface="Times New Roman"/>
              </a:rPr>
              <a:t>tuffed bread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898784" y="707348"/>
            <a:ext cx="1633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Milk or vegetable </a:t>
            </a:r>
            <a:r>
              <a:rPr lang="en-US" sz="1200" dirty="0">
                <a:latin typeface="Times New Roman"/>
                <a:cs typeface="Times New Roman"/>
              </a:rPr>
              <a:t>j</a:t>
            </a:r>
            <a:r>
              <a:rPr lang="en-US" sz="1200" dirty="0" smtClean="0">
                <a:latin typeface="Times New Roman"/>
                <a:cs typeface="Times New Roman"/>
              </a:rPr>
              <a:t>uice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038607" y="2419279"/>
            <a:ext cx="33424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Times New Roman"/>
                <a:cs typeface="Times New Roman"/>
              </a:rPr>
              <a:t>One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each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of food and drink at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b</a:t>
            </a:r>
            <a:r>
              <a:rPr lang="en-US" sz="1200" dirty="0" smtClean="0">
                <a:latin typeface="Times New Roman"/>
                <a:cs typeface="Times New Roman"/>
              </a:rPr>
              <a:t>reakfast and lunch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12" name="図 2" descr="2011-06-01 11.53.45.jpg"/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334325" y="984347"/>
            <a:ext cx="2314708" cy="173603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5334325" y="585175"/>
            <a:ext cx="23682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Retort rice with curry</a:t>
            </a:r>
            <a:r>
              <a:rPr lang="en-US" altLang="en-US" sz="1200" dirty="0">
                <a:latin typeface="Times New Roman"/>
                <a:cs typeface="Times New Roman"/>
              </a:rPr>
              <a:t> </a:t>
            </a:r>
            <a:r>
              <a:rPr lang="en-US" altLang="en-US" sz="1200" dirty="0" smtClean="0">
                <a:latin typeface="Times New Roman"/>
                <a:cs typeface="Times New Roman"/>
              </a:rPr>
              <a:t>or beef bowl, </a:t>
            </a:r>
          </a:p>
          <a:p>
            <a:r>
              <a:rPr lang="en-US" altLang="en-US" sz="1200" dirty="0" smtClean="0">
                <a:latin typeface="Times New Roman"/>
                <a:cs typeface="Times New Roman"/>
              </a:rPr>
              <a:t>and bottle of green tea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262010" y="2639730"/>
            <a:ext cx="6119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Dinner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15" name="図 3" descr="P1000634.JPG"/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5400000">
            <a:off x="717470" y="3444881"/>
            <a:ext cx="2029043" cy="1521782"/>
          </a:xfrm>
          <a:prstGeom prst="rect">
            <a:avLst/>
          </a:prstGeom>
        </p:spPr>
      </p:pic>
      <p:sp>
        <p:nvSpPr>
          <p:cNvPr id="16" name="TextBox 31"/>
          <p:cNvSpPr txBox="1"/>
          <p:nvPr/>
        </p:nvSpPr>
        <p:spPr>
          <a:xfrm>
            <a:off x="278579" y="2695924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C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998557" y="2914250"/>
            <a:ext cx="1800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Heating </a:t>
            </a:r>
            <a:r>
              <a:rPr lang="en-US" sz="1200" dirty="0" smtClean="0">
                <a:latin typeface="Times New Roman"/>
                <a:cs typeface="Times New Roman"/>
              </a:rPr>
              <a:t>bag</a:t>
            </a:r>
            <a:r>
              <a:rPr lang="en-US" altLang="en-US" sz="1200" dirty="0" smtClean="0">
                <a:latin typeface="Times New Roman"/>
                <a:cs typeface="Times New Roman"/>
              </a:rPr>
              <a:t> for</a:t>
            </a:r>
            <a:r>
              <a:rPr lang="en-US" altLang="en-US" sz="1200" dirty="0">
                <a:latin typeface="Times New Roman"/>
                <a:cs typeface="Times New Roman"/>
              </a:rPr>
              <a:t> </a:t>
            </a:r>
            <a:r>
              <a:rPr lang="en-US" altLang="en-US" sz="1200" dirty="0" smtClean="0">
                <a:latin typeface="Times New Roman"/>
                <a:cs typeface="Times New Roman"/>
              </a:rPr>
              <a:t>hot meals 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8" name="TextBox 31"/>
          <p:cNvSpPr txBox="1"/>
          <p:nvPr/>
        </p:nvSpPr>
        <p:spPr>
          <a:xfrm>
            <a:off x="4252193" y="269592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Times New Roman"/>
                <a:cs typeface="Times New Roman"/>
              </a:rPr>
              <a:t>D</a:t>
            </a:r>
            <a:endParaRPr lang="en-US" dirty="0">
              <a:latin typeface="Times New Roman"/>
              <a:cs typeface="Times New Roman"/>
            </a:endParaRPr>
          </a:p>
        </p:txBody>
      </p:sp>
      <p:pic>
        <p:nvPicPr>
          <p:cNvPr id="19" name="図 3" descr="DSCF1261.JPG"/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671325" y="3310747"/>
            <a:ext cx="2546063" cy="1909547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5230132" y="3033748"/>
            <a:ext cx="20737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B</a:t>
            </a:r>
            <a:r>
              <a:rPr lang="en-US" sz="1200" dirty="0" smtClean="0">
                <a:latin typeface="Times New Roman"/>
                <a:cs typeface="Times New Roman"/>
              </a:rPr>
              <a:t>oxed </a:t>
            </a:r>
            <a:r>
              <a:rPr lang="en-US" sz="1200" dirty="0">
                <a:latin typeface="Times New Roman"/>
                <a:cs typeface="Times New Roman"/>
              </a:rPr>
              <a:t>lunches with fresh food 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84413" y="5331906"/>
            <a:ext cx="7814960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"/>
                <a:cs typeface="Times"/>
              </a:rPr>
              <a:t>A. Representative </a:t>
            </a:r>
            <a:r>
              <a:rPr lang="en-US" sz="1200" dirty="0">
                <a:latin typeface="Times"/>
                <a:cs typeface="Times"/>
              </a:rPr>
              <a:t>images of breakfast and lunch during the emergency period. Emergency workers chose one food among </a:t>
            </a:r>
            <a:endParaRPr lang="en-US" sz="1200" dirty="0" smtClean="0">
              <a:latin typeface="Times"/>
              <a:cs typeface="Times"/>
            </a:endParaRPr>
          </a:p>
          <a:p>
            <a:r>
              <a:rPr lang="en-US" sz="1200" dirty="0">
                <a:latin typeface="Times"/>
                <a:cs typeface="Times"/>
              </a:rPr>
              <a:t> </a:t>
            </a:r>
            <a:r>
              <a:rPr lang="en-US" sz="1200" dirty="0" smtClean="0">
                <a:latin typeface="Times"/>
                <a:cs typeface="Times"/>
              </a:rPr>
              <a:t>    pasty</a:t>
            </a:r>
            <a:r>
              <a:rPr lang="en-US" sz="1200" dirty="0">
                <a:latin typeface="Times"/>
                <a:cs typeface="Times"/>
              </a:rPr>
              <a:t>, </a:t>
            </a:r>
            <a:r>
              <a:rPr lang="en-US" sz="1200" dirty="0" smtClean="0">
                <a:latin typeface="Times"/>
                <a:cs typeface="Times"/>
              </a:rPr>
              <a:t>filled </a:t>
            </a:r>
            <a:r>
              <a:rPr lang="en-US" sz="1200" dirty="0">
                <a:latin typeface="Times"/>
                <a:cs typeface="Times"/>
              </a:rPr>
              <a:t>or stuffed breads and one drink between milk and vegetable juice for breakfast and lunch, respectively.</a:t>
            </a:r>
            <a:endParaRPr lang="ja-JP" altLang="en-US" sz="1200" dirty="0">
              <a:latin typeface="Times"/>
              <a:cs typeface="Times"/>
            </a:endParaRPr>
          </a:p>
          <a:p>
            <a:r>
              <a:rPr lang="en-US" sz="1200" dirty="0">
                <a:latin typeface="Times"/>
                <a:cs typeface="Times"/>
              </a:rPr>
              <a:t>B. </a:t>
            </a:r>
            <a:r>
              <a:rPr lang="en-US" sz="1200" dirty="0" smtClean="0">
                <a:latin typeface="Times"/>
                <a:cs typeface="Times"/>
              </a:rPr>
              <a:t>Representative </a:t>
            </a:r>
            <a:r>
              <a:rPr lang="en-US" sz="1200" dirty="0">
                <a:latin typeface="Times"/>
                <a:cs typeface="Times"/>
              </a:rPr>
              <a:t>image of dinner during the emergency period. Emergency workers received green tea and chose one food </a:t>
            </a:r>
            <a:endParaRPr lang="en-US" sz="1200" dirty="0" smtClean="0">
              <a:latin typeface="Times"/>
              <a:cs typeface="Times"/>
            </a:endParaRPr>
          </a:p>
          <a:p>
            <a:r>
              <a:rPr lang="en-US" sz="1200" dirty="0">
                <a:latin typeface="Times"/>
                <a:cs typeface="Times"/>
              </a:rPr>
              <a:t> </a:t>
            </a:r>
            <a:r>
              <a:rPr lang="en-US" sz="1200" dirty="0" smtClean="0">
                <a:latin typeface="Times"/>
                <a:cs typeface="Times"/>
              </a:rPr>
              <a:t>    between </a:t>
            </a:r>
            <a:r>
              <a:rPr lang="en-US" sz="1200" dirty="0">
                <a:latin typeface="Times"/>
                <a:cs typeface="Times"/>
              </a:rPr>
              <a:t>curry and beef bowl with rice for dinner.</a:t>
            </a:r>
            <a:endParaRPr lang="ja-JP" altLang="en-US" sz="1200" dirty="0">
              <a:latin typeface="Times"/>
              <a:cs typeface="Times"/>
            </a:endParaRPr>
          </a:p>
          <a:p>
            <a:r>
              <a:rPr lang="en-US" sz="1200" dirty="0">
                <a:latin typeface="Times"/>
                <a:cs typeface="Times"/>
              </a:rPr>
              <a:t>C. Representative image of the heating bag used during the emergency period. Dinner foods were heated with a heating bag </a:t>
            </a:r>
            <a:endParaRPr lang="en-US" sz="1200" dirty="0" smtClean="0">
              <a:latin typeface="Times"/>
              <a:cs typeface="Times"/>
            </a:endParaRPr>
          </a:p>
          <a:p>
            <a:r>
              <a:rPr lang="en-US" sz="1200" dirty="0">
                <a:latin typeface="Times"/>
                <a:cs typeface="Times"/>
              </a:rPr>
              <a:t> </a:t>
            </a:r>
            <a:r>
              <a:rPr lang="en-US" sz="1200" dirty="0" smtClean="0">
                <a:latin typeface="Times"/>
                <a:cs typeface="Times"/>
              </a:rPr>
              <a:t>    to </a:t>
            </a:r>
            <a:r>
              <a:rPr lang="en-US" sz="1200" dirty="0">
                <a:latin typeface="Times"/>
                <a:cs typeface="Times"/>
              </a:rPr>
              <a:t>provide a hot meal. </a:t>
            </a:r>
            <a:endParaRPr lang="ja-JP" altLang="en-US" sz="1200" dirty="0">
              <a:latin typeface="Times"/>
              <a:cs typeface="Times"/>
            </a:endParaRPr>
          </a:p>
          <a:p>
            <a:r>
              <a:rPr lang="en-US" sz="1200" dirty="0">
                <a:latin typeface="Times"/>
                <a:cs typeface="Times"/>
              </a:rPr>
              <a:t>D. Representative image of boxed lunches with fresh food. This lunch system was available after September 2011</a:t>
            </a:r>
            <a:r>
              <a:rPr lang="en-US" sz="1200" dirty="0" smtClean="0">
                <a:latin typeface="Times"/>
                <a:cs typeface="Times"/>
              </a:rPr>
              <a:t>.</a:t>
            </a:r>
            <a:endParaRPr lang="ja-JP" altLang="en-US" sz="1200" dirty="0"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421689423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4475A-9A00-4546-A101-AEDF80008D61}" type="slidenum">
              <a:rPr lang="en-US" smtClean="0"/>
              <a:t>5</a:t>
            </a:fld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85110" y="164616"/>
            <a:ext cx="55452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"/>
                <a:cs typeface="Times"/>
              </a:rPr>
              <a:t>Supplemental Table 1. </a:t>
            </a:r>
            <a:endParaRPr lang="en-US" sz="1200" b="1" dirty="0" smtClean="0">
              <a:latin typeface="Times"/>
              <a:cs typeface="Times"/>
            </a:endParaRPr>
          </a:p>
          <a:p>
            <a:r>
              <a:rPr lang="en-US" sz="1200" b="1" dirty="0" smtClean="0">
                <a:latin typeface="Times"/>
                <a:cs typeface="Times"/>
              </a:rPr>
              <a:t>Estimation </a:t>
            </a:r>
            <a:r>
              <a:rPr lang="en-US" sz="1200" b="1" dirty="0">
                <a:latin typeface="Times"/>
                <a:cs typeface="Times"/>
              </a:rPr>
              <a:t>between </a:t>
            </a:r>
            <a:r>
              <a:rPr lang="en-US" sz="1200" b="1" dirty="0" err="1">
                <a:latin typeface="Times"/>
                <a:cs typeface="Times"/>
              </a:rPr>
              <a:t>HbDif</a:t>
            </a:r>
            <a:r>
              <a:rPr lang="en-US" sz="1200" b="1" dirty="0">
                <a:latin typeface="Times"/>
                <a:cs typeface="Times"/>
              </a:rPr>
              <a:t> and </a:t>
            </a:r>
            <a:r>
              <a:rPr lang="en-US" sz="1200" b="1" dirty="0" smtClean="0">
                <a:latin typeface="Times"/>
                <a:cs typeface="Times"/>
              </a:rPr>
              <a:t>related variables </a:t>
            </a:r>
            <a:r>
              <a:rPr lang="en-US" sz="1200" b="1" dirty="0">
                <a:latin typeface="Times"/>
                <a:cs typeface="Times"/>
              </a:rPr>
              <a:t>using </a:t>
            </a:r>
            <a:r>
              <a:rPr lang="en-US" sz="1200" b="1" dirty="0" smtClean="0">
                <a:latin typeface="Times"/>
                <a:cs typeface="Times"/>
              </a:rPr>
              <a:t>criterion</a:t>
            </a:r>
            <a:r>
              <a:rPr lang="en-US" sz="1200" b="1" dirty="0">
                <a:latin typeface="Times"/>
                <a:cs typeface="Times"/>
              </a:rPr>
              <a:t>-based procedures </a:t>
            </a:r>
            <a:endParaRPr lang="en-US" sz="1200" b="1" dirty="0" smtClean="0">
              <a:latin typeface="Times"/>
              <a:cs typeface="Times"/>
            </a:endParaRPr>
          </a:p>
          <a:p>
            <a:r>
              <a:rPr lang="en-US" sz="1200" b="1" dirty="0" smtClean="0">
                <a:latin typeface="Times"/>
                <a:cs typeface="Times"/>
              </a:rPr>
              <a:t>with </a:t>
            </a:r>
            <a:r>
              <a:rPr lang="en-US" sz="1200" b="1" dirty="0">
                <a:latin typeface="Times"/>
                <a:cs typeface="Times"/>
              </a:rPr>
              <a:t>AIC for variable selection in generalized linear model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787016"/>
              </p:ext>
            </p:extLst>
          </p:nvPr>
        </p:nvGraphicFramePr>
        <p:xfrm>
          <a:off x="940065" y="1511567"/>
          <a:ext cx="6985419" cy="1747520"/>
        </p:xfrm>
        <a:graphic>
          <a:graphicData uri="http://schemas.openxmlformats.org/drawingml/2006/table">
            <a:tbl>
              <a:tblPr/>
              <a:tblGrid>
                <a:gridCol w="1383421"/>
                <a:gridCol w="1725007"/>
                <a:gridCol w="1366340"/>
                <a:gridCol w="111841"/>
                <a:gridCol w="1220341"/>
                <a:gridCol w="1178469"/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Variable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rameter estimat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tandard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ro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-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 (&gt; |t| )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tercep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0.05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7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is-I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3.00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2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4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06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.4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86E-1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mokeNDif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5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3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hr-HR" sz="12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.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.51E-0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HbDif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~ EE (exposed effect) +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ge2011 + </a:t>
                      </a:r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ringDif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+ </a:t>
                      </a:r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mokeNDif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 gridSpan="6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ge2011 and DrinkDif were excluded during the stepwise variable selection. 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7324937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29</TotalTime>
  <Words>784</Words>
  <Application>Microsoft Macintosh PowerPoint</Application>
  <PresentationFormat>On-screen Show (4:3)</PresentationFormat>
  <Paragraphs>146</Paragraphs>
  <Slides>5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ジュネーブ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香崎 正宙</dc:creator>
  <cp:lastModifiedBy>香崎 正宙</cp:lastModifiedBy>
  <cp:revision>416</cp:revision>
  <cp:lastPrinted>2016-10-27T08:52:26Z</cp:lastPrinted>
  <dcterms:created xsi:type="dcterms:W3CDTF">2015-06-29T04:10:56Z</dcterms:created>
  <dcterms:modified xsi:type="dcterms:W3CDTF">2020-01-18T05:12:15Z</dcterms:modified>
</cp:coreProperties>
</file>